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43" r:id="rId2"/>
  </p:sldIdLst>
  <p:sldSz cx="12192000" cy="68580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5E9634BF-1C96-4565-855A-39A1853EEDD7}">
          <p14:sldIdLst>
            <p14:sldId id="34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FFFF"/>
    <a:srgbClr val="FFCCFF"/>
    <a:srgbClr val="CC00CC"/>
    <a:srgbClr val="FF99FF"/>
    <a:srgbClr val="6699FF"/>
    <a:srgbClr val="FF9933"/>
    <a:srgbClr val="99CCFF"/>
    <a:srgbClr val="CFDBDF"/>
    <a:srgbClr val="DDCC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12" autoAdjust="0"/>
    <p:restoredTop sz="94660"/>
  </p:normalViewPr>
  <p:slideViewPr>
    <p:cSldViewPr snapToGrid="0">
      <p:cViewPr>
        <p:scale>
          <a:sx n="100" d="100"/>
          <a:sy n="100" d="100"/>
        </p:scale>
        <p:origin x="534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C27AB5-7719-4076-835A-39F85C2E9489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988" y="1233488"/>
            <a:ext cx="591978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C6C972-CF21-4EBD-87ED-804A7CA688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592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813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287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0784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3964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251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397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713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662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674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49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327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99AA56-0F25-4A80-8992-898940AB51A6}" type="datetimeFigureOut">
              <a:rPr kumimoji="1" lang="ja-JP" altLang="en-US" smtClean="0"/>
              <a:t>2022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A56A1-9A89-47C1-99D2-7369561BD1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8273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BF0D8C1A-E9D3-4DF6-A358-F75478BCA43E}"/>
              </a:ext>
            </a:extLst>
          </p:cNvPr>
          <p:cNvGrpSpPr/>
          <p:nvPr/>
        </p:nvGrpSpPr>
        <p:grpSpPr>
          <a:xfrm>
            <a:off x="0" y="499656"/>
            <a:ext cx="12360744" cy="6022879"/>
            <a:chOff x="0" y="623482"/>
            <a:chExt cx="12360744" cy="6022879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63112" y="2987827"/>
              <a:ext cx="347908" cy="336950"/>
            </a:xfrm>
            <a:prstGeom prst="rect">
              <a:avLst/>
            </a:prstGeom>
          </p:spPr>
        </p:pic>
        <p:sp>
          <p:nvSpPr>
            <p:cNvPr id="18" name="フリーフォーム 17"/>
            <p:cNvSpPr/>
            <p:nvPr/>
          </p:nvSpPr>
          <p:spPr>
            <a:xfrm>
              <a:off x="0" y="1389285"/>
              <a:ext cx="1530788" cy="1039877"/>
            </a:xfrm>
            <a:custGeom>
              <a:avLst/>
              <a:gdLst>
                <a:gd name="connsiteX0" fmla="*/ 359505 w 8470233"/>
                <a:gd name="connsiteY0" fmla="*/ 3255264 h 4975977"/>
                <a:gd name="connsiteX1" fmla="*/ 423513 w 8470233"/>
                <a:gd name="connsiteY1" fmla="*/ 3273552 h 4975977"/>
                <a:gd name="connsiteX2" fmla="*/ 688689 w 8470233"/>
                <a:gd name="connsiteY2" fmla="*/ 3291840 h 4975977"/>
                <a:gd name="connsiteX3" fmla="*/ 752697 w 8470233"/>
                <a:gd name="connsiteY3" fmla="*/ 3300984 h 4975977"/>
                <a:gd name="connsiteX4" fmla="*/ 789273 w 8470233"/>
                <a:gd name="connsiteY4" fmla="*/ 3310128 h 4975977"/>
                <a:gd name="connsiteX5" fmla="*/ 1036161 w 8470233"/>
                <a:gd name="connsiteY5" fmla="*/ 3319272 h 4975977"/>
                <a:gd name="connsiteX6" fmla="*/ 1429353 w 8470233"/>
                <a:gd name="connsiteY6" fmla="*/ 3300984 h 4975977"/>
                <a:gd name="connsiteX7" fmla="*/ 1603089 w 8470233"/>
                <a:gd name="connsiteY7" fmla="*/ 3282696 h 4975977"/>
                <a:gd name="connsiteX8" fmla="*/ 1657953 w 8470233"/>
                <a:gd name="connsiteY8" fmla="*/ 3273552 h 4975977"/>
                <a:gd name="connsiteX9" fmla="*/ 1694529 w 8470233"/>
                <a:gd name="connsiteY9" fmla="*/ 3264408 h 4975977"/>
                <a:gd name="connsiteX10" fmla="*/ 1804257 w 8470233"/>
                <a:gd name="connsiteY10" fmla="*/ 3255264 h 4975977"/>
                <a:gd name="connsiteX11" fmla="*/ 1877409 w 8470233"/>
                <a:gd name="connsiteY11" fmla="*/ 3236976 h 4975977"/>
                <a:gd name="connsiteX12" fmla="*/ 1950561 w 8470233"/>
                <a:gd name="connsiteY12" fmla="*/ 3218688 h 4975977"/>
                <a:gd name="connsiteX13" fmla="*/ 2005425 w 8470233"/>
                <a:gd name="connsiteY13" fmla="*/ 3209544 h 4975977"/>
                <a:gd name="connsiteX14" fmla="*/ 2032857 w 8470233"/>
                <a:gd name="connsiteY14" fmla="*/ 3200400 h 4975977"/>
                <a:gd name="connsiteX15" fmla="*/ 2078577 w 8470233"/>
                <a:gd name="connsiteY15" fmla="*/ 3191256 h 4975977"/>
                <a:gd name="connsiteX16" fmla="*/ 2133441 w 8470233"/>
                <a:gd name="connsiteY16" fmla="*/ 3172968 h 4975977"/>
                <a:gd name="connsiteX17" fmla="*/ 2179161 w 8470233"/>
                <a:gd name="connsiteY17" fmla="*/ 3163824 h 4975977"/>
                <a:gd name="connsiteX18" fmla="*/ 2270601 w 8470233"/>
                <a:gd name="connsiteY18" fmla="*/ 3127248 h 4975977"/>
                <a:gd name="connsiteX19" fmla="*/ 2298033 w 8470233"/>
                <a:gd name="connsiteY19" fmla="*/ 3118104 h 4975977"/>
                <a:gd name="connsiteX20" fmla="*/ 2325465 w 8470233"/>
                <a:gd name="connsiteY20" fmla="*/ 3099816 h 4975977"/>
                <a:gd name="connsiteX21" fmla="*/ 2398617 w 8470233"/>
                <a:gd name="connsiteY21" fmla="*/ 3081528 h 4975977"/>
                <a:gd name="connsiteX22" fmla="*/ 2462625 w 8470233"/>
                <a:gd name="connsiteY22" fmla="*/ 3035808 h 4975977"/>
                <a:gd name="connsiteX23" fmla="*/ 2499201 w 8470233"/>
                <a:gd name="connsiteY23" fmla="*/ 3026664 h 4975977"/>
                <a:gd name="connsiteX24" fmla="*/ 2572353 w 8470233"/>
                <a:gd name="connsiteY24" fmla="*/ 2971800 h 4975977"/>
                <a:gd name="connsiteX25" fmla="*/ 2627217 w 8470233"/>
                <a:gd name="connsiteY25" fmla="*/ 2935224 h 4975977"/>
                <a:gd name="connsiteX26" fmla="*/ 2654649 w 8470233"/>
                <a:gd name="connsiteY26" fmla="*/ 2916936 h 4975977"/>
                <a:gd name="connsiteX27" fmla="*/ 2682081 w 8470233"/>
                <a:gd name="connsiteY27" fmla="*/ 2889504 h 4975977"/>
                <a:gd name="connsiteX28" fmla="*/ 2736945 w 8470233"/>
                <a:gd name="connsiteY28" fmla="*/ 2852928 h 4975977"/>
                <a:gd name="connsiteX29" fmla="*/ 2837529 w 8470233"/>
                <a:gd name="connsiteY29" fmla="*/ 2770632 h 4975977"/>
                <a:gd name="connsiteX30" fmla="*/ 2901537 w 8470233"/>
                <a:gd name="connsiteY30" fmla="*/ 2706624 h 4975977"/>
                <a:gd name="connsiteX31" fmla="*/ 2956401 w 8470233"/>
                <a:gd name="connsiteY31" fmla="*/ 2660904 h 4975977"/>
                <a:gd name="connsiteX32" fmla="*/ 2992977 w 8470233"/>
                <a:gd name="connsiteY32" fmla="*/ 2633472 h 4975977"/>
                <a:gd name="connsiteX33" fmla="*/ 3020409 w 8470233"/>
                <a:gd name="connsiteY33" fmla="*/ 2596896 h 4975977"/>
                <a:gd name="connsiteX34" fmla="*/ 3056985 w 8470233"/>
                <a:gd name="connsiteY34" fmla="*/ 2569464 h 4975977"/>
                <a:gd name="connsiteX35" fmla="*/ 3111849 w 8470233"/>
                <a:gd name="connsiteY35" fmla="*/ 2514600 h 4975977"/>
                <a:gd name="connsiteX36" fmla="*/ 3130137 w 8470233"/>
                <a:gd name="connsiteY36" fmla="*/ 2478024 h 4975977"/>
                <a:gd name="connsiteX37" fmla="*/ 3157569 w 8470233"/>
                <a:gd name="connsiteY37" fmla="*/ 2450592 h 4975977"/>
                <a:gd name="connsiteX38" fmla="*/ 3212433 w 8470233"/>
                <a:gd name="connsiteY38" fmla="*/ 2377440 h 4975977"/>
                <a:gd name="connsiteX39" fmla="*/ 3230721 w 8470233"/>
                <a:gd name="connsiteY39" fmla="*/ 2340864 h 4975977"/>
                <a:gd name="connsiteX40" fmla="*/ 3258153 w 8470233"/>
                <a:gd name="connsiteY40" fmla="*/ 2304288 h 4975977"/>
                <a:gd name="connsiteX41" fmla="*/ 3303873 w 8470233"/>
                <a:gd name="connsiteY41" fmla="*/ 2231136 h 4975977"/>
                <a:gd name="connsiteX42" fmla="*/ 3349593 w 8470233"/>
                <a:gd name="connsiteY42" fmla="*/ 2148840 h 4975977"/>
                <a:gd name="connsiteX43" fmla="*/ 3395313 w 8470233"/>
                <a:gd name="connsiteY43" fmla="*/ 2029968 h 4975977"/>
                <a:gd name="connsiteX44" fmla="*/ 3413601 w 8470233"/>
                <a:gd name="connsiteY44" fmla="*/ 1993392 h 4975977"/>
                <a:gd name="connsiteX45" fmla="*/ 3441033 w 8470233"/>
                <a:gd name="connsiteY45" fmla="*/ 1920240 h 4975977"/>
                <a:gd name="connsiteX46" fmla="*/ 3459321 w 8470233"/>
                <a:gd name="connsiteY46" fmla="*/ 1892808 h 4975977"/>
                <a:gd name="connsiteX47" fmla="*/ 3477609 w 8470233"/>
                <a:gd name="connsiteY47" fmla="*/ 1837944 h 4975977"/>
                <a:gd name="connsiteX48" fmla="*/ 3495897 w 8470233"/>
                <a:gd name="connsiteY48" fmla="*/ 1810512 h 4975977"/>
                <a:gd name="connsiteX49" fmla="*/ 3532473 w 8470233"/>
                <a:gd name="connsiteY49" fmla="*/ 1719072 h 4975977"/>
                <a:gd name="connsiteX50" fmla="*/ 3541617 w 8470233"/>
                <a:gd name="connsiteY50" fmla="*/ 1682496 h 4975977"/>
                <a:gd name="connsiteX51" fmla="*/ 3587337 w 8470233"/>
                <a:gd name="connsiteY51" fmla="*/ 1600200 h 4975977"/>
                <a:gd name="connsiteX52" fmla="*/ 3596481 w 8470233"/>
                <a:gd name="connsiteY52" fmla="*/ 1563624 h 4975977"/>
                <a:gd name="connsiteX53" fmla="*/ 3633057 w 8470233"/>
                <a:gd name="connsiteY53" fmla="*/ 1463040 h 4975977"/>
                <a:gd name="connsiteX54" fmla="*/ 3642201 w 8470233"/>
                <a:gd name="connsiteY54" fmla="*/ 1426464 h 4975977"/>
                <a:gd name="connsiteX55" fmla="*/ 3678777 w 8470233"/>
                <a:gd name="connsiteY55" fmla="*/ 1344168 h 4975977"/>
                <a:gd name="connsiteX56" fmla="*/ 3697065 w 8470233"/>
                <a:gd name="connsiteY56" fmla="*/ 1289304 h 4975977"/>
                <a:gd name="connsiteX57" fmla="*/ 3706209 w 8470233"/>
                <a:gd name="connsiteY57" fmla="*/ 1261872 h 4975977"/>
                <a:gd name="connsiteX58" fmla="*/ 3724497 w 8470233"/>
                <a:gd name="connsiteY58" fmla="*/ 1225296 h 4975977"/>
                <a:gd name="connsiteX59" fmla="*/ 3751929 w 8470233"/>
                <a:gd name="connsiteY59" fmla="*/ 1152144 h 4975977"/>
                <a:gd name="connsiteX60" fmla="*/ 3761073 w 8470233"/>
                <a:gd name="connsiteY60" fmla="*/ 1115568 h 4975977"/>
                <a:gd name="connsiteX61" fmla="*/ 3779361 w 8470233"/>
                <a:gd name="connsiteY61" fmla="*/ 1033272 h 4975977"/>
                <a:gd name="connsiteX62" fmla="*/ 3815937 w 8470233"/>
                <a:gd name="connsiteY62" fmla="*/ 932688 h 4975977"/>
                <a:gd name="connsiteX63" fmla="*/ 3834225 w 8470233"/>
                <a:gd name="connsiteY63" fmla="*/ 877824 h 4975977"/>
                <a:gd name="connsiteX64" fmla="*/ 3852513 w 8470233"/>
                <a:gd name="connsiteY64" fmla="*/ 832104 h 4975977"/>
                <a:gd name="connsiteX65" fmla="*/ 3861657 w 8470233"/>
                <a:gd name="connsiteY65" fmla="*/ 804672 h 4975977"/>
                <a:gd name="connsiteX66" fmla="*/ 3898233 w 8470233"/>
                <a:gd name="connsiteY66" fmla="*/ 713232 h 4975977"/>
                <a:gd name="connsiteX67" fmla="*/ 3907377 w 8470233"/>
                <a:gd name="connsiteY67" fmla="*/ 676656 h 4975977"/>
                <a:gd name="connsiteX68" fmla="*/ 3925665 w 8470233"/>
                <a:gd name="connsiteY68" fmla="*/ 621792 h 4975977"/>
                <a:gd name="connsiteX69" fmla="*/ 3934809 w 8470233"/>
                <a:gd name="connsiteY69" fmla="*/ 576072 h 4975977"/>
                <a:gd name="connsiteX70" fmla="*/ 3971385 w 8470233"/>
                <a:gd name="connsiteY70" fmla="*/ 493776 h 4975977"/>
                <a:gd name="connsiteX71" fmla="*/ 3989673 w 8470233"/>
                <a:gd name="connsiteY71" fmla="*/ 466344 h 4975977"/>
                <a:gd name="connsiteX72" fmla="*/ 4007961 w 8470233"/>
                <a:gd name="connsiteY72" fmla="*/ 384048 h 4975977"/>
                <a:gd name="connsiteX73" fmla="*/ 4026249 w 8470233"/>
                <a:gd name="connsiteY73" fmla="*/ 356616 h 4975977"/>
                <a:gd name="connsiteX74" fmla="*/ 4044537 w 8470233"/>
                <a:gd name="connsiteY74" fmla="*/ 301752 h 4975977"/>
                <a:gd name="connsiteX75" fmla="*/ 4053681 w 8470233"/>
                <a:gd name="connsiteY75" fmla="*/ 256032 h 4975977"/>
                <a:gd name="connsiteX76" fmla="*/ 4071969 w 8470233"/>
                <a:gd name="connsiteY76" fmla="*/ 201168 h 4975977"/>
                <a:gd name="connsiteX77" fmla="*/ 4090257 w 8470233"/>
                <a:gd name="connsiteY77" fmla="*/ 137160 h 4975977"/>
                <a:gd name="connsiteX78" fmla="*/ 4126833 w 8470233"/>
                <a:gd name="connsiteY78" fmla="*/ 64008 h 4975977"/>
                <a:gd name="connsiteX79" fmla="*/ 4154265 w 8470233"/>
                <a:gd name="connsiteY79" fmla="*/ 0 h 4975977"/>
                <a:gd name="connsiteX80" fmla="*/ 4163409 w 8470233"/>
                <a:gd name="connsiteY80" fmla="*/ 36576 h 4975977"/>
                <a:gd name="connsiteX81" fmla="*/ 4145121 w 8470233"/>
                <a:gd name="connsiteY81" fmla="*/ 228600 h 4975977"/>
                <a:gd name="connsiteX82" fmla="*/ 4126833 w 8470233"/>
                <a:gd name="connsiteY82" fmla="*/ 301752 h 4975977"/>
                <a:gd name="connsiteX83" fmla="*/ 4099401 w 8470233"/>
                <a:gd name="connsiteY83" fmla="*/ 411480 h 4975977"/>
                <a:gd name="connsiteX84" fmla="*/ 4081113 w 8470233"/>
                <a:gd name="connsiteY84" fmla="*/ 475488 h 4975977"/>
                <a:gd name="connsiteX85" fmla="*/ 4062825 w 8470233"/>
                <a:gd name="connsiteY85" fmla="*/ 502920 h 4975977"/>
                <a:gd name="connsiteX86" fmla="*/ 4044537 w 8470233"/>
                <a:gd name="connsiteY86" fmla="*/ 576072 h 4975977"/>
                <a:gd name="connsiteX87" fmla="*/ 4026249 w 8470233"/>
                <a:gd name="connsiteY87" fmla="*/ 640080 h 4975977"/>
                <a:gd name="connsiteX88" fmla="*/ 4017105 w 8470233"/>
                <a:gd name="connsiteY88" fmla="*/ 694944 h 4975977"/>
                <a:gd name="connsiteX89" fmla="*/ 3998817 w 8470233"/>
                <a:gd name="connsiteY89" fmla="*/ 749808 h 4975977"/>
                <a:gd name="connsiteX90" fmla="*/ 3989673 w 8470233"/>
                <a:gd name="connsiteY90" fmla="*/ 777240 h 4975977"/>
                <a:gd name="connsiteX91" fmla="*/ 3971385 w 8470233"/>
                <a:gd name="connsiteY91" fmla="*/ 850392 h 4975977"/>
                <a:gd name="connsiteX92" fmla="*/ 3962241 w 8470233"/>
                <a:gd name="connsiteY92" fmla="*/ 932688 h 4975977"/>
                <a:gd name="connsiteX93" fmla="*/ 3953097 w 8470233"/>
                <a:gd name="connsiteY93" fmla="*/ 1005840 h 4975977"/>
                <a:gd name="connsiteX94" fmla="*/ 3943953 w 8470233"/>
                <a:gd name="connsiteY94" fmla="*/ 1143000 h 4975977"/>
                <a:gd name="connsiteX95" fmla="*/ 3953097 w 8470233"/>
                <a:gd name="connsiteY95" fmla="*/ 1289304 h 4975977"/>
                <a:gd name="connsiteX96" fmla="*/ 3971385 w 8470233"/>
                <a:gd name="connsiteY96" fmla="*/ 1408176 h 4975977"/>
                <a:gd name="connsiteX97" fmla="*/ 3980529 w 8470233"/>
                <a:gd name="connsiteY97" fmla="*/ 2221992 h 4975977"/>
                <a:gd name="connsiteX98" fmla="*/ 3998817 w 8470233"/>
                <a:gd name="connsiteY98" fmla="*/ 2322576 h 4975977"/>
                <a:gd name="connsiteX99" fmla="*/ 4007961 w 8470233"/>
                <a:gd name="connsiteY99" fmla="*/ 2395728 h 4975977"/>
                <a:gd name="connsiteX100" fmla="*/ 4017105 w 8470233"/>
                <a:gd name="connsiteY100" fmla="*/ 2432304 h 4975977"/>
                <a:gd name="connsiteX101" fmla="*/ 4026249 w 8470233"/>
                <a:gd name="connsiteY101" fmla="*/ 2487168 h 4975977"/>
                <a:gd name="connsiteX102" fmla="*/ 4035393 w 8470233"/>
                <a:gd name="connsiteY102" fmla="*/ 2532888 h 4975977"/>
                <a:gd name="connsiteX103" fmla="*/ 4062825 w 8470233"/>
                <a:gd name="connsiteY103" fmla="*/ 2660904 h 4975977"/>
                <a:gd name="connsiteX104" fmla="*/ 4071969 w 8470233"/>
                <a:gd name="connsiteY104" fmla="*/ 2697480 h 4975977"/>
                <a:gd name="connsiteX105" fmla="*/ 4081113 w 8470233"/>
                <a:gd name="connsiteY105" fmla="*/ 2734056 h 4975977"/>
                <a:gd name="connsiteX106" fmla="*/ 4108545 w 8470233"/>
                <a:gd name="connsiteY106" fmla="*/ 2816352 h 4975977"/>
                <a:gd name="connsiteX107" fmla="*/ 4117689 w 8470233"/>
                <a:gd name="connsiteY107" fmla="*/ 2862072 h 4975977"/>
                <a:gd name="connsiteX108" fmla="*/ 4135977 w 8470233"/>
                <a:gd name="connsiteY108" fmla="*/ 2898648 h 4975977"/>
                <a:gd name="connsiteX109" fmla="*/ 4145121 w 8470233"/>
                <a:gd name="connsiteY109" fmla="*/ 2926080 h 4975977"/>
                <a:gd name="connsiteX110" fmla="*/ 4163409 w 8470233"/>
                <a:gd name="connsiteY110" fmla="*/ 2962656 h 4975977"/>
                <a:gd name="connsiteX111" fmla="*/ 4209129 w 8470233"/>
                <a:gd name="connsiteY111" fmla="*/ 3054096 h 4975977"/>
                <a:gd name="connsiteX112" fmla="*/ 4227417 w 8470233"/>
                <a:gd name="connsiteY112" fmla="*/ 3108960 h 4975977"/>
                <a:gd name="connsiteX113" fmla="*/ 4318857 w 8470233"/>
                <a:gd name="connsiteY113" fmla="*/ 3218688 h 4975977"/>
                <a:gd name="connsiteX114" fmla="*/ 4346289 w 8470233"/>
                <a:gd name="connsiteY114" fmla="*/ 3246120 h 4975977"/>
                <a:gd name="connsiteX115" fmla="*/ 4446873 w 8470233"/>
                <a:gd name="connsiteY115" fmla="*/ 3300984 h 4975977"/>
                <a:gd name="connsiteX116" fmla="*/ 4483449 w 8470233"/>
                <a:gd name="connsiteY116" fmla="*/ 3328416 h 4975977"/>
                <a:gd name="connsiteX117" fmla="*/ 4547457 w 8470233"/>
                <a:gd name="connsiteY117" fmla="*/ 3355848 h 4975977"/>
                <a:gd name="connsiteX118" fmla="*/ 4584033 w 8470233"/>
                <a:gd name="connsiteY118" fmla="*/ 3374136 h 4975977"/>
                <a:gd name="connsiteX119" fmla="*/ 4648041 w 8470233"/>
                <a:gd name="connsiteY119" fmla="*/ 3392424 h 4975977"/>
                <a:gd name="connsiteX120" fmla="*/ 4675473 w 8470233"/>
                <a:gd name="connsiteY120" fmla="*/ 3401568 h 4975977"/>
                <a:gd name="connsiteX121" fmla="*/ 4721193 w 8470233"/>
                <a:gd name="connsiteY121" fmla="*/ 3410712 h 4975977"/>
                <a:gd name="connsiteX122" fmla="*/ 4766913 w 8470233"/>
                <a:gd name="connsiteY122" fmla="*/ 3429000 h 4975977"/>
                <a:gd name="connsiteX123" fmla="*/ 4995513 w 8470233"/>
                <a:gd name="connsiteY123" fmla="*/ 3511296 h 4975977"/>
                <a:gd name="connsiteX124" fmla="*/ 5077809 w 8470233"/>
                <a:gd name="connsiteY124" fmla="*/ 3547872 h 4975977"/>
                <a:gd name="connsiteX125" fmla="*/ 5114385 w 8470233"/>
                <a:gd name="connsiteY125" fmla="*/ 3557016 h 4975977"/>
                <a:gd name="connsiteX126" fmla="*/ 5160105 w 8470233"/>
                <a:gd name="connsiteY126" fmla="*/ 3575304 h 4975977"/>
                <a:gd name="connsiteX127" fmla="*/ 5242401 w 8470233"/>
                <a:gd name="connsiteY127" fmla="*/ 3611880 h 4975977"/>
                <a:gd name="connsiteX128" fmla="*/ 5297265 w 8470233"/>
                <a:gd name="connsiteY128" fmla="*/ 3621024 h 4975977"/>
                <a:gd name="connsiteX129" fmla="*/ 5370417 w 8470233"/>
                <a:gd name="connsiteY129" fmla="*/ 3657600 h 4975977"/>
                <a:gd name="connsiteX130" fmla="*/ 5443569 w 8470233"/>
                <a:gd name="connsiteY130" fmla="*/ 3685032 h 4975977"/>
                <a:gd name="connsiteX131" fmla="*/ 5471001 w 8470233"/>
                <a:gd name="connsiteY131" fmla="*/ 3703320 h 4975977"/>
                <a:gd name="connsiteX132" fmla="*/ 5525865 w 8470233"/>
                <a:gd name="connsiteY132" fmla="*/ 3721608 h 4975977"/>
                <a:gd name="connsiteX133" fmla="*/ 5599017 w 8470233"/>
                <a:gd name="connsiteY133" fmla="*/ 3758184 h 4975977"/>
                <a:gd name="connsiteX134" fmla="*/ 5717889 w 8470233"/>
                <a:gd name="connsiteY134" fmla="*/ 3803904 h 4975977"/>
                <a:gd name="connsiteX135" fmla="*/ 5763609 w 8470233"/>
                <a:gd name="connsiteY135" fmla="*/ 3822192 h 4975977"/>
                <a:gd name="connsiteX136" fmla="*/ 5809329 w 8470233"/>
                <a:gd name="connsiteY136" fmla="*/ 3849624 h 4975977"/>
                <a:gd name="connsiteX137" fmla="*/ 5873337 w 8470233"/>
                <a:gd name="connsiteY137" fmla="*/ 3867912 h 4975977"/>
                <a:gd name="connsiteX138" fmla="*/ 5992209 w 8470233"/>
                <a:gd name="connsiteY138" fmla="*/ 3931920 h 4975977"/>
                <a:gd name="connsiteX139" fmla="*/ 6065361 w 8470233"/>
                <a:gd name="connsiteY139" fmla="*/ 3959352 h 4975977"/>
                <a:gd name="connsiteX140" fmla="*/ 6129369 w 8470233"/>
                <a:gd name="connsiteY140" fmla="*/ 3986784 h 4975977"/>
                <a:gd name="connsiteX141" fmla="*/ 6193377 w 8470233"/>
                <a:gd name="connsiteY141" fmla="*/ 4005072 h 4975977"/>
                <a:gd name="connsiteX142" fmla="*/ 6348825 w 8470233"/>
                <a:gd name="connsiteY142" fmla="*/ 4069080 h 4975977"/>
                <a:gd name="connsiteX143" fmla="*/ 6403689 w 8470233"/>
                <a:gd name="connsiteY143" fmla="*/ 4078224 h 4975977"/>
                <a:gd name="connsiteX144" fmla="*/ 6476841 w 8470233"/>
                <a:gd name="connsiteY144" fmla="*/ 4096512 h 4975977"/>
                <a:gd name="connsiteX145" fmla="*/ 6504273 w 8470233"/>
                <a:gd name="connsiteY145" fmla="*/ 4105656 h 4975977"/>
                <a:gd name="connsiteX146" fmla="*/ 6559137 w 8470233"/>
                <a:gd name="connsiteY146" fmla="*/ 4114800 h 4975977"/>
                <a:gd name="connsiteX147" fmla="*/ 6641433 w 8470233"/>
                <a:gd name="connsiteY147" fmla="*/ 4142232 h 4975977"/>
                <a:gd name="connsiteX148" fmla="*/ 6714585 w 8470233"/>
                <a:gd name="connsiteY148" fmla="*/ 4151376 h 4975977"/>
                <a:gd name="connsiteX149" fmla="*/ 6787737 w 8470233"/>
                <a:gd name="connsiteY149" fmla="*/ 4169664 h 4975977"/>
                <a:gd name="connsiteX150" fmla="*/ 6824313 w 8470233"/>
                <a:gd name="connsiteY150" fmla="*/ 4178808 h 4975977"/>
                <a:gd name="connsiteX151" fmla="*/ 6915753 w 8470233"/>
                <a:gd name="connsiteY151" fmla="*/ 4187952 h 4975977"/>
                <a:gd name="connsiteX152" fmla="*/ 7025481 w 8470233"/>
                <a:gd name="connsiteY152" fmla="*/ 4215384 h 4975977"/>
                <a:gd name="connsiteX153" fmla="*/ 7089489 w 8470233"/>
                <a:gd name="connsiteY153" fmla="*/ 4233672 h 4975977"/>
                <a:gd name="connsiteX154" fmla="*/ 7208361 w 8470233"/>
                <a:gd name="connsiteY154" fmla="*/ 4251960 h 4975977"/>
                <a:gd name="connsiteX155" fmla="*/ 7263225 w 8470233"/>
                <a:gd name="connsiteY155" fmla="*/ 4270248 h 4975977"/>
                <a:gd name="connsiteX156" fmla="*/ 7473537 w 8470233"/>
                <a:gd name="connsiteY156" fmla="*/ 4306824 h 4975977"/>
                <a:gd name="connsiteX157" fmla="*/ 7628985 w 8470233"/>
                <a:gd name="connsiteY157" fmla="*/ 4334256 h 4975977"/>
                <a:gd name="connsiteX158" fmla="*/ 7656417 w 8470233"/>
                <a:gd name="connsiteY158" fmla="*/ 4352544 h 4975977"/>
                <a:gd name="connsiteX159" fmla="*/ 7711281 w 8470233"/>
                <a:gd name="connsiteY159" fmla="*/ 4370832 h 4975977"/>
                <a:gd name="connsiteX160" fmla="*/ 7757001 w 8470233"/>
                <a:gd name="connsiteY160" fmla="*/ 4398264 h 4975977"/>
                <a:gd name="connsiteX161" fmla="*/ 7821009 w 8470233"/>
                <a:gd name="connsiteY161" fmla="*/ 4407408 h 4975977"/>
                <a:gd name="connsiteX162" fmla="*/ 7912449 w 8470233"/>
                <a:gd name="connsiteY162" fmla="*/ 4425696 h 4975977"/>
                <a:gd name="connsiteX163" fmla="*/ 7985601 w 8470233"/>
                <a:gd name="connsiteY163" fmla="*/ 4462272 h 4975977"/>
                <a:gd name="connsiteX164" fmla="*/ 8049609 w 8470233"/>
                <a:gd name="connsiteY164" fmla="*/ 4489704 h 4975977"/>
                <a:gd name="connsiteX165" fmla="*/ 8168481 w 8470233"/>
                <a:gd name="connsiteY165" fmla="*/ 4526280 h 4975977"/>
                <a:gd name="connsiteX166" fmla="*/ 8241633 w 8470233"/>
                <a:gd name="connsiteY166" fmla="*/ 4535424 h 4975977"/>
                <a:gd name="connsiteX167" fmla="*/ 8287353 w 8470233"/>
                <a:gd name="connsiteY167" fmla="*/ 4544568 h 4975977"/>
                <a:gd name="connsiteX168" fmla="*/ 8351361 w 8470233"/>
                <a:gd name="connsiteY168" fmla="*/ 4553712 h 4975977"/>
                <a:gd name="connsiteX169" fmla="*/ 8387937 w 8470233"/>
                <a:gd name="connsiteY169" fmla="*/ 4562856 h 4975977"/>
                <a:gd name="connsiteX170" fmla="*/ 8470233 w 8470233"/>
                <a:gd name="connsiteY170" fmla="*/ 4581144 h 4975977"/>
                <a:gd name="connsiteX171" fmla="*/ 8013033 w 8470233"/>
                <a:gd name="connsiteY171" fmla="*/ 4599432 h 4975977"/>
                <a:gd name="connsiteX172" fmla="*/ 7967313 w 8470233"/>
                <a:gd name="connsiteY172" fmla="*/ 4608576 h 4975977"/>
                <a:gd name="connsiteX173" fmla="*/ 7903305 w 8470233"/>
                <a:gd name="connsiteY173" fmla="*/ 4617720 h 4975977"/>
                <a:gd name="connsiteX174" fmla="*/ 7857585 w 8470233"/>
                <a:gd name="connsiteY174" fmla="*/ 4626864 h 4975977"/>
                <a:gd name="connsiteX175" fmla="*/ 7766145 w 8470233"/>
                <a:gd name="connsiteY175" fmla="*/ 4636008 h 4975977"/>
                <a:gd name="connsiteX176" fmla="*/ 7692993 w 8470233"/>
                <a:gd name="connsiteY176" fmla="*/ 4654296 h 4975977"/>
                <a:gd name="connsiteX177" fmla="*/ 7601553 w 8470233"/>
                <a:gd name="connsiteY177" fmla="*/ 4672584 h 4975977"/>
                <a:gd name="connsiteX178" fmla="*/ 7574121 w 8470233"/>
                <a:gd name="connsiteY178" fmla="*/ 4690872 h 4975977"/>
                <a:gd name="connsiteX179" fmla="*/ 7500969 w 8470233"/>
                <a:gd name="connsiteY179" fmla="*/ 4709160 h 4975977"/>
                <a:gd name="connsiteX180" fmla="*/ 7464393 w 8470233"/>
                <a:gd name="connsiteY180" fmla="*/ 4727448 h 4975977"/>
                <a:gd name="connsiteX181" fmla="*/ 7400385 w 8470233"/>
                <a:gd name="connsiteY181" fmla="*/ 4745736 h 4975977"/>
                <a:gd name="connsiteX182" fmla="*/ 7318089 w 8470233"/>
                <a:gd name="connsiteY182" fmla="*/ 4754880 h 4975977"/>
                <a:gd name="connsiteX183" fmla="*/ 7290657 w 8470233"/>
                <a:gd name="connsiteY183" fmla="*/ 4764024 h 4975977"/>
                <a:gd name="connsiteX184" fmla="*/ 7254081 w 8470233"/>
                <a:gd name="connsiteY184" fmla="*/ 4773168 h 4975977"/>
                <a:gd name="connsiteX185" fmla="*/ 7107777 w 8470233"/>
                <a:gd name="connsiteY185" fmla="*/ 4800600 h 4975977"/>
                <a:gd name="connsiteX186" fmla="*/ 7043769 w 8470233"/>
                <a:gd name="connsiteY186" fmla="*/ 4809744 h 4975977"/>
                <a:gd name="connsiteX187" fmla="*/ 7007193 w 8470233"/>
                <a:gd name="connsiteY187" fmla="*/ 4818888 h 4975977"/>
                <a:gd name="connsiteX188" fmla="*/ 6979761 w 8470233"/>
                <a:gd name="connsiteY188" fmla="*/ 4828032 h 4975977"/>
                <a:gd name="connsiteX189" fmla="*/ 6897465 w 8470233"/>
                <a:gd name="connsiteY189" fmla="*/ 4837176 h 4975977"/>
                <a:gd name="connsiteX190" fmla="*/ 6851745 w 8470233"/>
                <a:gd name="connsiteY190" fmla="*/ 4846320 h 4975977"/>
                <a:gd name="connsiteX191" fmla="*/ 6787737 w 8470233"/>
                <a:gd name="connsiteY191" fmla="*/ 4855464 h 4975977"/>
                <a:gd name="connsiteX192" fmla="*/ 6604857 w 8470233"/>
                <a:gd name="connsiteY192" fmla="*/ 4901184 h 4975977"/>
                <a:gd name="connsiteX193" fmla="*/ 6577425 w 8470233"/>
                <a:gd name="connsiteY193" fmla="*/ 4910328 h 4975977"/>
                <a:gd name="connsiteX194" fmla="*/ 6504273 w 8470233"/>
                <a:gd name="connsiteY194" fmla="*/ 4919472 h 4975977"/>
                <a:gd name="connsiteX195" fmla="*/ 6440265 w 8470233"/>
                <a:gd name="connsiteY195" fmla="*/ 4937760 h 4975977"/>
                <a:gd name="connsiteX196" fmla="*/ 6321393 w 8470233"/>
                <a:gd name="connsiteY196" fmla="*/ 4956048 h 4975977"/>
                <a:gd name="connsiteX197" fmla="*/ 6010497 w 8470233"/>
                <a:gd name="connsiteY197" fmla="*/ 4956048 h 4975977"/>
                <a:gd name="connsiteX198" fmla="*/ 5800185 w 8470233"/>
                <a:gd name="connsiteY198" fmla="*/ 4946904 h 4975977"/>
                <a:gd name="connsiteX199" fmla="*/ 5626449 w 8470233"/>
                <a:gd name="connsiteY199" fmla="*/ 4928616 h 4975977"/>
                <a:gd name="connsiteX200" fmla="*/ 5507577 w 8470233"/>
                <a:gd name="connsiteY200" fmla="*/ 4910328 h 4975977"/>
                <a:gd name="connsiteX201" fmla="*/ 5388705 w 8470233"/>
                <a:gd name="connsiteY201" fmla="*/ 4901184 h 4975977"/>
                <a:gd name="connsiteX202" fmla="*/ 5306409 w 8470233"/>
                <a:gd name="connsiteY202" fmla="*/ 4882896 h 4975977"/>
                <a:gd name="connsiteX203" fmla="*/ 5233257 w 8470233"/>
                <a:gd name="connsiteY203" fmla="*/ 4864608 h 4975977"/>
                <a:gd name="connsiteX204" fmla="*/ 5196681 w 8470233"/>
                <a:gd name="connsiteY204" fmla="*/ 4846320 h 4975977"/>
                <a:gd name="connsiteX205" fmla="*/ 5086953 w 8470233"/>
                <a:gd name="connsiteY205" fmla="*/ 4837176 h 4975977"/>
                <a:gd name="connsiteX206" fmla="*/ 5004657 w 8470233"/>
                <a:gd name="connsiteY206" fmla="*/ 4818888 h 4975977"/>
                <a:gd name="connsiteX207" fmla="*/ 4940649 w 8470233"/>
                <a:gd name="connsiteY207" fmla="*/ 4809744 h 4975977"/>
                <a:gd name="connsiteX208" fmla="*/ 4885785 w 8470233"/>
                <a:gd name="connsiteY208" fmla="*/ 4800600 h 4975977"/>
                <a:gd name="connsiteX209" fmla="*/ 4757769 w 8470233"/>
                <a:gd name="connsiteY209" fmla="*/ 4791456 h 4975977"/>
                <a:gd name="connsiteX210" fmla="*/ 4638897 w 8470233"/>
                <a:gd name="connsiteY210" fmla="*/ 4773168 h 4975977"/>
                <a:gd name="connsiteX211" fmla="*/ 4529169 w 8470233"/>
                <a:gd name="connsiteY211" fmla="*/ 4764024 h 4975977"/>
                <a:gd name="connsiteX212" fmla="*/ 4392009 w 8470233"/>
                <a:gd name="connsiteY212" fmla="*/ 4745736 h 4975977"/>
                <a:gd name="connsiteX213" fmla="*/ 4245705 w 8470233"/>
                <a:gd name="connsiteY213" fmla="*/ 4727448 h 4975977"/>
                <a:gd name="connsiteX214" fmla="*/ 4181697 w 8470233"/>
                <a:gd name="connsiteY214" fmla="*/ 4718304 h 4975977"/>
                <a:gd name="connsiteX215" fmla="*/ 4145121 w 8470233"/>
                <a:gd name="connsiteY215" fmla="*/ 4709160 h 4975977"/>
                <a:gd name="connsiteX216" fmla="*/ 4117689 w 8470233"/>
                <a:gd name="connsiteY216" fmla="*/ 4700016 h 4975977"/>
                <a:gd name="connsiteX217" fmla="*/ 3989673 w 8470233"/>
                <a:gd name="connsiteY217" fmla="*/ 4690872 h 4975977"/>
                <a:gd name="connsiteX218" fmla="*/ 3879945 w 8470233"/>
                <a:gd name="connsiteY218" fmla="*/ 4681728 h 4975977"/>
                <a:gd name="connsiteX219" fmla="*/ 3559905 w 8470233"/>
                <a:gd name="connsiteY219" fmla="*/ 4654296 h 4975977"/>
                <a:gd name="connsiteX220" fmla="*/ 3340449 w 8470233"/>
                <a:gd name="connsiteY220" fmla="*/ 4636008 h 4975977"/>
                <a:gd name="connsiteX221" fmla="*/ 3258153 w 8470233"/>
                <a:gd name="connsiteY221" fmla="*/ 4626864 h 4975977"/>
                <a:gd name="connsiteX222" fmla="*/ 3139281 w 8470233"/>
                <a:gd name="connsiteY222" fmla="*/ 4608576 h 4975977"/>
                <a:gd name="connsiteX223" fmla="*/ 3102705 w 8470233"/>
                <a:gd name="connsiteY223" fmla="*/ 4599432 h 4975977"/>
                <a:gd name="connsiteX224" fmla="*/ 3038697 w 8470233"/>
                <a:gd name="connsiteY224" fmla="*/ 4590288 h 4975977"/>
                <a:gd name="connsiteX225" fmla="*/ 2974689 w 8470233"/>
                <a:gd name="connsiteY225" fmla="*/ 4572000 h 4975977"/>
                <a:gd name="connsiteX226" fmla="*/ 2874105 w 8470233"/>
                <a:gd name="connsiteY226" fmla="*/ 4562856 h 4975977"/>
                <a:gd name="connsiteX227" fmla="*/ 2810097 w 8470233"/>
                <a:gd name="connsiteY227" fmla="*/ 4544568 h 4975977"/>
                <a:gd name="connsiteX228" fmla="*/ 2746089 w 8470233"/>
                <a:gd name="connsiteY228" fmla="*/ 4526280 h 4975977"/>
                <a:gd name="connsiteX229" fmla="*/ 2700369 w 8470233"/>
                <a:gd name="connsiteY229" fmla="*/ 4507992 h 4975977"/>
                <a:gd name="connsiteX230" fmla="*/ 2672937 w 8470233"/>
                <a:gd name="connsiteY230" fmla="*/ 4498848 h 4975977"/>
                <a:gd name="connsiteX231" fmla="*/ 2645505 w 8470233"/>
                <a:gd name="connsiteY231" fmla="*/ 4480560 h 4975977"/>
                <a:gd name="connsiteX232" fmla="*/ 2608929 w 8470233"/>
                <a:gd name="connsiteY232" fmla="*/ 4471416 h 4975977"/>
                <a:gd name="connsiteX233" fmla="*/ 2508345 w 8470233"/>
                <a:gd name="connsiteY233" fmla="*/ 4443984 h 4975977"/>
                <a:gd name="connsiteX234" fmla="*/ 2453481 w 8470233"/>
                <a:gd name="connsiteY234" fmla="*/ 4416552 h 4975977"/>
                <a:gd name="connsiteX235" fmla="*/ 2316321 w 8470233"/>
                <a:gd name="connsiteY235" fmla="*/ 4343400 h 4975977"/>
                <a:gd name="connsiteX236" fmla="*/ 2288889 w 8470233"/>
                <a:gd name="connsiteY236" fmla="*/ 4334256 h 4975977"/>
                <a:gd name="connsiteX237" fmla="*/ 2261457 w 8470233"/>
                <a:gd name="connsiteY237" fmla="*/ 4315968 h 4975977"/>
                <a:gd name="connsiteX238" fmla="*/ 2224881 w 8470233"/>
                <a:gd name="connsiteY238" fmla="*/ 4297680 h 4975977"/>
                <a:gd name="connsiteX239" fmla="*/ 2197449 w 8470233"/>
                <a:gd name="connsiteY239" fmla="*/ 4279392 h 4975977"/>
                <a:gd name="connsiteX240" fmla="*/ 2170017 w 8470233"/>
                <a:gd name="connsiteY240" fmla="*/ 4270248 h 4975977"/>
                <a:gd name="connsiteX241" fmla="*/ 2115153 w 8470233"/>
                <a:gd name="connsiteY241" fmla="*/ 4233672 h 4975977"/>
                <a:gd name="connsiteX242" fmla="*/ 2051145 w 8470233"/>
                <a:gd name="connsiteY242" fmla="*/ 4206240 h 4975977"/>
                <a:gd name="connsiteX243" fmla="*/ 2014569 w 8470233"/>
                <a:gd name="connsiteY243" fmla="*/ 4187952 h 4975977"/>
                <a:gd name="connsiteX244" fmla="*/ 1987137 w 8470233"/>
                <a:gd name="connsiteY244" fmla="*/ 4178808 h 4975977"/>
                <a:gd name="connsiteX245" fmla="*/ 1932273 w 8470233"/>
                <a:gd name="connsiteY245" fmla="*/ 4151376 h 4975977"/>
                <a:gd name="connsiteX246" fmla="*/ 1849977 w 8470233"/>
                <a:gd name="connsiteY246" fmla="*/ 4114800 h 4975977"/>
                <a:gd name="connsiteX247" fmla="*/ 1795113 w 8470233"/>
                <a:gd name="connsiteY247" fmla="*/ 4096512 h 4975977"/>
                <a:gd name="connsiteX248" fmla="*/ 1749393 w 8470233"/>
                <a:gd name="connsiteY248" fmla="*/ 4078224 h 4975977"/>
                <a:gd name="connsiteX249" fmla="*/ 1685385 w 8470233"/>
                <a:gd name="connsiteY249" fmla="*/ 4069080 h 4975977"/>
                <a:gd name="connsiteX250" fmla="*/ 1575657 w 8470233"/>
                <a:gd name="connsiteY250" fmla="*/ 4032504 h 4975977"/>
                <a:gd name="connsiteX251" fmla="*/ 1539081 w 8470233"/>
                <a:gd name="connsiteY251" fmla="*/ 4023360 h 4975977"/>
                <a:gd name="connsiteX252" fmla="*/ 1484217 w 8470233"/>
                <a:gd name="connsiteY252" fmla="*/ 3986784 h 4975977"/>
                <a:gd name="connsiteX253" fmla="*/ 1456785 w 8470233"/>
                <a:gd name="connsiteY253" fmla="*/ 3977640 h 4975977"/>
                <a:gd name="connsiteX254" fmla="*/ 1383633 w 8470233"/>
                <a:gd name="connsiteY254" fmla="*/ 3950208 h 4975977"/>
                <a:gd name="connsiteX255" fmla="*/ 1328769 w 8470233"/>
                <a:gd name="connsiteY255" fmla="*/ 3913632 h 4975977"/>
                <a:gd name="connsiteX256" fmla="*/ 1292193 w 8470233"/>
                <a:gd name="connsiteY256" fmla="*/ 3895344 h 4975977"/>
                <a:gd name="connsiteX257" fmla="*/ 1191609 w 8470233"/>
                <a:gd name="connsiteY257" fmla="*/ 3831336 h 4975977"/>
                <a:gd name="connsiteX258" fmla="*/ 1118457 w 8470233"/>
                <a:gd name="connsiteY258" fmla="*/ 3803904 h 4975977"/>
                <a:gd name="connsiteX259" fmla="*/ 1072737 w 8470233"/>
                <a:gd name="connsiteY259" fmla="*/ 3785616 h 4975977"/>
                <a:gd name="connsiteX260" fmla="*/ 1017873 w 8470233"/>
                <a:gd name="connsiteY260" fmla="*/ 3749040 h 4975977"/>
                <a:gd name="connsiteX261" fmla="*/ 990441 w 8470233"/>
                <a:gd name="connsiteY261" fmla="*/ 3739896 h 4975977"/>
                <a:gd name="connsiteX262" fmla="*/ 953865 w 8470233"/>
                <a:gd name="connsiteY262" fmla="*/ 3721608 h 4975977"/>
                <a:gd name="connsiteX263" fmla="*/ 889857 w 8470233"/>
                <a:gd name="connsiteY263" fmla="*/ 3685032 h 4975977"/>
                <a:gd name="connsiteX264" fmla="*/ 853281 w 8470233"/>
                <a:gd name="connsiteY264" fmla="*/ 3675888 h 4975977"/>
                <a:gd name="connsiteX265" fmla="*/ 770985 w 8470233"/>
                <a:gd name="connsiteY265" fmla="*/ 3639312 h 4975977"/>
                <a:gd name="connsiteX266" fmla="*/ 716121 w 8470233"/>
                <a:gd name="connsiteY266" fmla="*/ 3621024 h 4975977"/>
                <a:gd name="connsiteX267" fmla="*/ 679545 w 8470233"/>
                <a:gd name="connsiteY267" fmla="*/ 3602736 h 4975977"/>
                <a:gd name="connsiteX268" fmla="*/ 642969 w 8470233"/>
                <a:gd name="connsiteY268" fmla="*/ 3575304 h 4975977"/>
                <a:gd name="connsiteX269" fmla="*/ 597249 w 8470233"/>
                <a:gd name="connsiteY269" fmla="*/ 3566160 h 4975977"/>
                <a:gd name="connsiteX270" fmla="*/ 560673 w 8470233"/>
                <a:gd name="connsiteY270" fmla="*/ 3557016 h 4975977"/>
                <a:gd name="connsiteX271" fmla="*/ 524097 w 8470233"/>
                <a:gd name="connsiteY271" fmla="*/ 3538728 h 4975977"/>
                <a:gd name="connsiteX272" fmla="*/ 441801 w 8470233"/>
                <a:gd name="connsiteY272" fmla="*/ 3502152 h 4975977"/>
                <a:gd name="connsiteX273" fmla="*/ 414369 w 8470233"/>
                <a:gd name="connsiteY273" fmla="*/ 3483864 h 4975977"/>
                <a:gd name="connsiteX274" fmla="*/ 386937 w 8470233"/>
                <a:gd name="connsiteY274" fmla="*/ 3474720 h 4975977"/>
                <a:gd name="connsiteX275" fmla="*/ 313785 w 8470233"/>
                <a:gd name="connsiteY275" fmla="*/ 3438144 h 4975977"/>
                <a:gd name="connsiteX276" fmla="*/ 277209 w 8470233"/>
                <a:gd name="connsiteY276" fmla="*/ 3419856 h 4975977"/>
                <a:gd name="connsiteX277" fmla="*/ 204057 w 8470233"/>
                <a:gd name="connsiteY277" fmla="*/ 3364992 h 4975977"/>
                <a:gd name="connsiteX278" fmla="*/ 185769 w 8470233"/>
                <a:gd name="connsiteY278" fmla="*/ 3337560 h 4975977"/>
                <a:gd name="connsiteX279" fmla="*/ 121761 w 8470233"/>
                <a:gd name="connsiteY279" fmla="*/ 3310128 h 4975977"/>
                <a:gd name="connsiteX280" fmla="*/ 94329 w 8470233"/>
                <a:gd name="connsiteY280" fmla="*/ 3291840 h 4975977"/>
                <a:gd name="connsiteX281" fmla="*/ 66897 w 8470233"/>
                <a:gd name="connsiteY281" fmla="*/ 3282696 h 4975977"/>
                <a:gd name="connsiteX282" fmla="*/ 39465 w 8470233"/>
                <a:gd name="connsiteY282" fmla="*/ 3264408 h 4975977"/>
                <a:gd name="connsiteX283" fmla="*/ 2889 w 8470233"/>
                <a:gd name="connsiteY283" fmla="*/ 3246120 h 4975977"/>
                <a:gd name="connsiteX284" fmla="*/ 194913 w 8470233"/>
                <a:gd name="connsiteY284" fmla="*/ 3264408 h 4975977"/>
                <a:gd name="connsiteX285" fmla="*/ 277209 w 8470233"/>
                <a:gd name="connsiteY285" fmla="*/ 3282696 h 4975977"/>
                <a:gd name="connsiteX286" fmla="*/ 359505 w 8470233"/>
                <a:gd name="connsiteY286" fmla="*/ 3255264 h 49759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</a:cxnLst>
              <a:rect l="l" t="t" r="r" b="b"/>
              <a:pathLst>
                <a:path w="8470233" h="4975977">
                  <a:moveTo>
                    <a:pt x="359505" y="3255264"/>
                  </a:moveTo>
                  <a:cubicBezTo>
                    <a:pt x="383889" y="3253740"/>
                    <a:pt x="401703" y="3269463"/>
                    <a:pt x="423513" y="3273552"/>
                  </a:cubicBezTo>
                  <a:cubicBezTo>
                    <a:pt x="487050" y="3285465"/>
                    <a:pt x="653875" y="3290099"/>
                    <a:pt x="688689" y="3291840"/>
                  </a:cubicBezTo>
                  <a:cubicBezTo>
                    <a:pt x="710025" y="3294888"/>
                    <a:pt x="731492" y="3297129"/>
                    <a:pt x="752697" y="3300984"/>
                  </a:cubicBezTo>
                  <a:cubicBezTo>
                    <a:pt x="765062" y="3303232"/>
                    <a:pt x="776732" y="3309319"/>
                    <a:pt x="789273" y="3310128"/>
                  </a:cubicBezTo>
                  <a:cubicBezTo>
                    <a:pt x="871455" y="3315430"/>
                    <a:pt x="953865" y="3316224"/>
                    <a:pt x="1036161" y="3319272"/>
                  </a:cubicBezTo>
                  <a:cubicBezTo>
                    <a:pt x="1288458" y="3311133"/>
                    <a:pt x="1251756" y="3317129"/>
                    <a:pt x="1429353" y="3300984"/>
                  </a:cubicBezTo>
                  <a:cubicBezTo>
                    <a:pt x="1457237" y="3298449"/>
                    <a:pt x="1572361" y="3286793"/>
                    <a:pt x="1603089" y="3282696"/>
                  </a:cubicBezTo>
                  <a:cubicBezTo>
                    <a:pt x="1621467" y="3280246"/>
                    <a:pt x="1639773" y="3277188"/>
                    <a:pt x="1657953" y="3273552"/>
                  </a:cubicBezTo>
                  <a:cubicBezTo>
                    <a:pt x="1670276" y="3271087"/>
                    <a:pt x="1682059" y="3265967"/>
                    <a:pt x="1694529" y="3264408"/>
                  </a:cubicBezTo>
                  <a:cubicBezTo>
                    <a:pt x="1730948" y="3259856"/>
                    <a:pt x="1767681" y="3258312"/>
                    <a:pt x="1804257" y="3255264"/>
                  </a:cubicBezTo>
                  <a:cubicBezTo>
                    <a:pt x="1866963" y="3234362"/>
                    <a:pt x="1789135" y="3259045"/>
                    <a:pt x="1877409" y="3236976"/>
                  </a:cubicBezTo>
                  <a:cubicBezTo>
                    <a:pt x="1962010" y="3215826"/>
                    <a:pt x="1826982" y="3241157"/>
                    <a:pt x="1950561" y="3218688"/>
                  </a:cubicBezTo>
                  <a:cubicBezTo>
                    <a:pt x="1968802" y="3215371"/>
                    <a:pt x="1987326" y="3213566"/>
                    <a:pt x="2005425" y="3209544"/>
                  </a:cubicBezTo>
                  <a:cubicBezTo>
                    <a:pt x="2014834" y="3207453"/>
                    <a:pt x="2023506" y="3202738"/>
                    <a:pt x="2032857" y="3200400"/>
                  </a:cubicBezTo>
                  <a:cubicBezTo>
                    <a:pt x="2047935" y="3196631"/>
                    <a:pt x="2063583" y="3195345"/>
                    <a:pt x="2078577" y="3191256"/>
                  </a:cubicBezTo>
                  <a:cubicBezTo>
                    <a:pt x="2097175" y="3186184"/>
                    <a:pt x="2114538" y="3176749"/>
                    <a:pt x="2133441" y="3172968"/>
                  </a:cubicBezTo>
                  <a:cubicBezTo>
                    <a:pt x="2148681" y="3169920"/>
                    <a:pt x="2164167" y="3167913"/>
                    <a:pt x="2179161" y="3163824"/>
                  </a:cubicBezTo>
                  <a:cubicBezTo>
                    <a:pt x="2255476" y="3143011"/>
                    <a:pt x="2210759" y="3152895"/>
                    <a:pt x="2270601" y="3127248"/>
                  </a:cubicBezTo>
                  <a:cubicBezTo>
                    <a:pt x="2279460" y="3123451"/>
                    <a:pt x="2289412" y="3122415"/>
                    <a:pt x="2298033" y="3118104"/>
                  </a:cubicBezTo>
                  <a:cubicBezTo>
                    <a:pt x="2307863" y="3113189"/>
                    <a:pt x="2315635" y="3104731"/>
                    <a:pt x="2325465" y="3099816"/>
                  </a:cubicBezTo>
                  <a:cubicBezTo>
                    <a:pt x="2344210" y="3090443"/>
                    <a:pt x="2381227" y="3085006"/>
                    <a:pt x="2398617" y="3081528"/>
                  </a:cubicBezTo>
                  <a:cubicBezTo>
                    <a:pt x="2402780" y="3078405"/>
                    <a:pt x="2452225" y="3040265"/>
                    <a:pt x="2462625" y="3035808"/>
                  </a:cubicBezTo>
                  <a:cubicBezTo>
                    <a:pt x="2474176" y="3030858"/>
                    <a:pt x="2487009" y="3029712"/>
                    <a:pt x="2499201" y="3026664"/>
                  </a:cubicBezTo>
                  <a:cubicBezTo>
                    <a:pt x="2523585" y="3008376"/>
                    <a:pt x="2546992" y="2988707"/>
                    <a:pt x="2572353" y="2971800"/>
                  </a:cubicBezTo>
                  <a:lnTo>
                    <a:pt x="2627217" y="2935224"/>
                  </a:lnTo>
                  <a:cubicBezTo>
                    <a:pt x="2636361" y="2929128"/>
                    <a:pt x="2646878" y="2924707"/>
                    <a:pt x="2654649" y="2916936"/>
                  </a:cubicBezTo>
                  <a:cubicBezTo>
                    <a:pt x="2663793" y="2907792"/>
                    <a:pt x="2671873" y="2897443"/>
                    <a:pt x="2682081" y="2889504"/>
                  </a:cubicBezTo>
                  <a:cubicBezTo>
                    <a:pt x="2699431" y="2876010"/>
                    <a:pt x="2721403" y="2868470"/>
                    <a:pt x="2736945" y="2852928"/>
                  </a:cubicBezTo>
                  <a:cubicBezTo>
                    <a:pt x="2816913" y="2772960"/>
                    <a:pt x="2777382" y="2790681"/>
                    <a:pt x="2837529" y="2770632"/>
                  </a:cubicBezTo>
                  <a:cubicBezTo>
                    <a:pt x="2858865" y="2749296"/>
                    <a:pt x="2876431" y="2723361"/>
                    <a:pt x="2901537" y="2706624"/>
                  </a:cubicBezTo>
                  <a:cubicBezTo>
                    <a:pt x="2962166" y="2666204"/>
                    <a:pt x="2894796" y="2713708"/>
                    <a:pt x="2956401" y="2660904"/>
                  </a:cubicBezTo>
                  <a:cubicBezTo>
                    <a:pt x="2967972" y="2650986"/>
                    <a:pt x="2982201" y="2644248"/>
                    <a:pt x="2992977" y="2633472"/>
                  </a:cubicBezTo>
                  <a:cubicBezTo>
                    <a:pt x="3003753" y="2622696"/>
                    <a:pt x="3009633" y="2607672"/>
                    <a:pt x="3020409" y="2596896"/>
                  </a:cubicBezTo>
                  <a:cubicBezTo>
                    <a:pt x="3031185" y="2586120"/>
                    <a:pt x="3046209" y="2580240"/>
                    <a:pt x="3056985" y="2569464"/>
                  </a:cubicBezTo>
                  <a:cubicBezTo>
                    <a:pt x="3137210" y="2489239"/>
                    <a:pt x="2992313" y="2604252"/>
                    <a:pt x="3111849" y="2514600"/>
                  </a:cubicBezTo>
                  <a:cubicBezTo>
                    <a:pt x="3117945" y="2502408"/>
                    <a:pt x="3122214" y="2489116"/>
                    <a:pt x="3130137" y="2478024"/>
                  </a:cubicBezTo>
                  <a:cubicBezTo>
                    <a:pt x="3137653" y="2467501"/>
                    <a:pt x="3149054" y="2460324"/>
                    <a:pt x="3157569" y="2450592"/>
                  </a:cubicBezTo>
                  <a:cubicBezTo>
                    <a:pt x="3172054" y="2434037"/>
                    <a:pt x="3199624" y="2399856"/>
                    <a:pt x="3212433" y="2377440"/>
                  </a:cubicBezTo>
                  <a:cubicBezTo>
                    <a:pt x="3219196" y="2365605"/>
                    <a:pt x="3223497" y="2352423"/>
                    <a:pt x="3230721" y="2340864"/>
                  </a:cubicBezTo>
                  <a:cubicBezTo>
                    <a:pt x="3238798" y="2327941"/>
                    <a:pt x="3249295" y="2316689"/>
                    <a:pt x="3258153" y="2304288"/>
                  </a:cubicBezTo>
                  <a:cubicBezTo>
                    <a:pt x="3270242" y="2287363"/>
                    <a:pt x="3296755" y="2245373"/>
                    <a:pt x="3303873" y="2231136"/>
                  </a:cubicBezTo>
                  <a:cubicBezTo>
                    <a:pt x="3345782" y="2147318"/>
                    <a:pt x="3295636" y="2220782"/>
                    <a:pt x="3349593" y="2148840"/>
                  </a:cubicBezTo>
                  <a:cubicBezTo>
                    <a:pt x="3370374" y="2086498"/>
                    <a:pt x="3366125" y="2094182"/>
                    <a:pt x="3395313" y="2029968"/>
                  </a:cubicBezTo>
                  <a:cubicBezTo>
                    <a:pt x="3400954" y="2017559"/>
                    <a:pt x="3408231" y="2005921"/>
                    <a:pt x="3413601" y="1993392"/>
                  </a:cubicBezTo>
                  <a:cubicBezTo>
                    <a:pt x="3437343" y="1937994"/>
                    <a:pt x="3403145" y="1996016"/>
                    <a:pt x="3441033" y="1920240"/>
                  </a:cubicBezTo>
                  <a:cubicBezTo>
                    <a:pt x="3445948" y="1910410"/>
                    <a:pt x="3454858" y="1902851"/>
                    <a:pt x="3459321" y="1892808"/>
                  </a:cubicBezTo>
                  <a:cubicBezTo>
                    <a:pt x="3467150" y="1875192"/>
                    <a:pt x="3466916" y="1853984"/>
                    <a:pt x="3477609" y="1837944"/>
                  </a:cubicBezTo>
                  <a:cubicBezTo>
                    <a:pt x="3483705" y="1828800"/>
                    <a:pt x="3490982" y="1820342"/>
                    <a:pt x="3495897" y="1810512"/>
                  </a:cubicBezTo>
                  <a:cubicBezTo>
                    <a:pt x="3506953" y="1788401"/>
                    <a:pt x="3524365" y="1747450"/>
                    <a:pt x="3532473" y="1719072"/>
                  </a:cubicBezTo>
                  <a:cubicBezTo>
                    <a:pt x="3535925" y="1706988"/>
                    <a:pt x="3536513" y="1693980"/>
                    <a:pt x="3541617" y="1682496"/>
                  </a:cubicBezTo>
                  <a:cubicBezTo>
                    <a:pt x="3569553" y="1619641"/>
                    <a:pt x="3566093" y="1656850"/>
                    <a:pt x="3587337" y="1600200"/>
                  </a:cubicBezTo>
                  <a:cubicBezTo>
                    <a:pt x="3591750" y="1588433"/>
                    <a:pt x="3592870" y="1575661"/>
                    <a:pt x="3596481" y="1563624"/>
                  </a:cubicBezTo>
                  <a:cubicBezTo>
                    <a:pt x="3641311" y="1414192"/>
                    <a:pt x="3589430" y="1593922"/>
                    <a:pt x="3633057" y="1463040"/>
                  </a:cubicBezTo>
                  <a:cubicBezTo>
                    <a:pt x="3637031" y="1451118"/>
                    <a:pt x="3638227" y="1438386"/>
                    <a:pt x="3642201" y="1426464"/>
                  </a:cubicBezTo>
                  <a:cubicBezTo>
                    <a:pt x="3673062" y="1333881"/>
                    <a:pt x="3646911" y="1423832"/>
                    <a:pt x="3678777" y="1344168"/>
                  </a:cubicBezTo>
                  <a:cubicBezTo>
                    <a:pt x="3685936" y="1326270"/>
                    <a:pt x="3690969" y="1307592"/>
                    <a:pt x="3697065" y="1289304"/>
                  </a:cubicBezTo>
                  <a:cubicBezTo>
                    <a:pt x="3700113" y="1280160"/>
                    <a:pt x="3701898" y="1270493"/>
                    <a:pt x="3706209" y="1261872"/>
                  </a:cubicBezTo>
                  <a:lnTo>
                    <a:pt x="3724497" y="1225296"/>
                  </a:lnTo>
                  <a:cubicBezTo>
                    <a:pt x="3747688" y="1109339"/>
                    <a:pt x="3716611" y="1234553"/>
                    <a:pt x="3751929" y="1152144"/>
                  </a:cubicBezTo>
                  <a:cubicBezTo>
                    <a:pt x="3756879" y="1140593"/>
                    <a:pt x="3758347" y="1127836"/>
                    <a:pt x="3761073" y="1115568"/>
                  </a:cubicBezTo>
                  <a:cubicBezTo>
                    <a:pt x="3768531" y="1082007"/>
                    <a:pt x="3769804" y="1065130"/>
                    <a:pt x="3779361" y="1033272"/>
                  </a:cubicBezTo>
                  <a:cubicBezTo>
                    <a:pt x="3802232" y="957036"/>
                    <a:pt x="3791007" y="1001245"/>
                    <a:pt x="3815937" y="932688"/>
                  </a:cubicBezTo>
                  <a:cubicBezTo>
                    <a:pt x="3822525" y="914571"/>
                    <a:pt x="3827066" y="895722"/>
                    <a:pt x="3834225" y="877824"/>
                  </a:cubicBezTo>
                  <a:cubicBezTo>
                    <a:pt x="3840321" y="862584"/>
                    <a:pt x="3846750" y="847473"/>
                    <a:pt x="3852513" y="832104"/>
                  </a:cubicBezTo>
                  <a:cubicBezTo>
                    <a:pt x="3855897" y="823079"/>
                    <a:pt x="3858197" y="813668"/>
                    <a:pt x="3861657" y="804672"/>
                  </a:cubicBezTo>
                  <a:cubicBezTo>
                    <a:pt x="3873442" y="774032"/>
                    <a:pt x="3890271" y="745080"/>
                    <a:pt x="3898233" y="713232"/>
                  </a:cubicBezTo>
                  <a:cubicBezTo>
                    <a:pt x="3901281" y="701040"/>
                    <a:pt x="3903766" y="688693"/>
                    <a:pt x="3907377" y="676656"/>
                  </a:cubicBezTo>
                  <a:cubicBezTo>
                    <a:pt x="3912916" y="658192"/>
                    <a:pt x="3921884" y="640695"/>
                    <a:pt x="3925665" y="621792"/>
                  </a:cubicBezTo>
                  <a:cubicBezTo>
                    <a:pt x="3928713" y="606552"/>
                    <a:pt x="3930343" y="590958"/>
                    <a:pt x="3934809" y="576072"/>
                  </a:cubicBezTo>
                  <a:cubicBezTo>
                    <a:pt x="3940997" y="555445"/>
                    <a:pt x="3960009" y="513684"/>
                    <a:pt x="3971385" y="493776"/>
                  </a:cubicBezTo>
                  <a:cubicBezTo>
                    <a:pt x="3976837" y="484234"/>
                    <a:pt x="3983577" y="475488"/>
                    <a:pt x="3989673" y="466344"/>
                  </a:cubicBezTo>
                  <a:cubicBezTo>
                    <a:pt x="3991300" y="458207"/>
                    <a:pt x="4003118" y="395347"/>
                    <a:pt x="4007961" y="384048"/>
                  </a:cubicBezTo>
                  <a:cubicBezTo>
                    <a:pt x="4012290" y="373947"/>
                    <a:pt x="4021786" y="366659"/>
                    <a:pt x="4026249" y="356616"/>
                  </a:cubicBezTo>
                  <a:cubicBezTo>
                    <a:pt x="4034078" y="339000"/>
                    <a:pt x="4039465" y="320350"/>
                    <a:pt x="4044537" y="301752"/>
                  </a:cubicBezTo>
                  <a:cubicBezTo>
                    <a:pt x="4048626" y="286758"/>
                    <a:pt x="4049592" y="271026"/>
                    <a:pt x="4053681" y="256032"/>
                  </a:cubicBezTo>
                  <a:cubicBezTo>
                    <a:pt x="4058753" y="237434"/>
                    <a:pt x="4067294" y="219870"/>
                    <a:pt x="4071969" y="201168"/>
                  </a:cubicBezTo>
                  <a:cubicBezTo>
                    <a:pt x="4075849" y="185648"/>
                    <a:pt x="4082969" y="153193"/>
                    <a:pt x="4090257" y="137160"/>
                  </a:cubicBezTo>
                  <a:cubicBezTo>
                    <a:pt x="4101538" y="112341"/>
                    <a:pt x="4118212" y="89871"/>
                    <a:pt x="4126833" y="64008"/>
                  </a:cubicBezTo>
                  <a:cubicBezTo>
                    <a:pt x="4140288" y="23644"/>
                    <a:pt x="4131666" y="45197"/>
                    <a:pt x="4154265" y="0"/>
                  </a:cubicBezTo>
                  <a:cubicBezTo>
                    <a:pt x="4157313" y="12192"/>
                    <a:pt x="4163409" y="24009"/>
                    <a:pt x="4163409" y="36576"/>
                  </a:cubicBezTo>
                  <a:cubicBezTo>
                    <a:pt x="4163409" y="115315"/>
                    <a:pt x="4160631" y="161390"/>
                    <a:pt x="4145121" y="228600"/>
                  </a:cubicBezTo>
                  <a:cubicBezTo>
                    <a:pt x="4139469" y="253091"/>
                    <a:pt x="4129951" y="276812"/>
                    <a:pt x="4126833" y="301752"/>
                  </a:cubicBezTo>
                  <a:cubicBezTo>
                    <a:pt x="4109401" y="441211"/>
                    <a:pt x="4132338" y="323647"/>
                    <a:pt x="4099401" y="411480"/>
                  </a:cubicBezTo>
                  <a:cubicBezTo>
                    <a:pt x="4090612" y="434918"/>
                    <a:pt x="4092166" y="453382"/>
                    <a:pt x="4081113" y="475488"/>
                  </a:cubicBezTo>
                  <a:cubicBezTo>
                    <a:pt x="4076198" y="485318"/>
                    <a:pt x="4068921" y="493776"/>
                    <a:pt x="4062825" y="502920"/>
                  </a:cubicBezTo>
                  <a:cubicBezTo>
                    <a:pt x="4056729" y="527304"/>
                    <a:pt x="4052485" y="552227"/>
                    <a:pt x="4044537" y="576072"/>
                  </a:cubicBezTo>
                  <a:cubicBezTo>
                    <a:pt x="4035822" y="602217"/>
                    <a:pt x="4031990" y="611376"/>
                    <a:pt x="4026249" y="640080"/>
                  </a:cubicBezTo>
                  <a:cubicBezTo>
                    <a:pt x="4022613" y="658260"/>
                    <a:pt x="4021602" y="676957"/>
                    <a:pt x="4017105" y="694944"/>
                  </a:cubicBezTo>
                  <a:cubicBezTo>
                    <a:pt x="4012430" y="713646"/>
                    <a:pt x="4004913" y="731520"/>
                    <a:pt x="3998817" y="749808"/>
                  </a:cubicBezTo>
                  <a:cubicBezTo>
                    <a:pt x="3995769" y="758952"/>
                    <a:pt x="3991563" y="767789"/>
                    <a:pt x="3989673" y="777240"/>
                  </a:cubicBezTo>
                  <a:cubicBezTo>
                    <a:pt x="3978639" y="832411"/>
                    <a:pt x="3985444" y="808216"/>
                    <a:pt x="3971385" y="850392"/>
                  </a:cubicBezTo>
                  <a:cubicBezTo>
                    <a:pt x="3968337" y="877824"/>
                    <a:pt x="3965466" y="905276"/>
                    <a:pt x="3962241" y="932688"/>
                  </a:cubicBezTo>
                  <a:cubicBezTo>
                    <a:pt x="3959370" y="957093"/>
                    <a:pt x="3955226" y="981359"/>
                    <a:pt x="3953097" y="1005840"/>
                  </a:cubicBezTo>
                  <a:cubicBezTo>
                    <a:pt x="3949128" y="1051489"/>
                    <a:pt x="3947001" y="1097280"/>
                    <a:pt x="3943953" y="1143000"/>
                  </a:cubicBezTo>
                  <a:cubicBezTo>
                    <a:pt x="3947001" y="1191768"/>
                    <a:pt x="3949349" y="1240585"/>
                    <a:pt x="3953097" y="1289304"/>
                  </a:cubicBezTo>
                  <a:cubicBezTo>
                    <a:pt x="3960169" y="1381242"/>
                    <a:pt x="3953508" y="1354545"/>
                    <a:pt x="3971385" y="1408176"/>
                  </a:cubicBezTo>
                  <a:cubicBezTo>
                    <a:pt x="3974433" y="1679448"/>
                    <a:pt x="3974819" y="1950763"/>
                    <a:pt x="3980529" y="2221992"/>
                  </a:cubicBezTo>
                  <a:cubicBezTo>
                    <a:pt x="3980944" y="2241709"/>
                    <a:pt x="3995496" y="2300990"/>
                    <a:pt x="3998817" y="2322576"/>
                  </a:cubicBezTo>
                  <a:cubicBezTo>
                    <a:pt x="4002554" y="2346864"/>
                    <a:pt x="4003921" y="2371489"/>
                    <a:pt x="4007961" y="2395728"/>
                  </a:cubicBezTo>
                  <a:cubicBezTo>
                    <a:pt x="4010027" y="2408124"/>
                    <a:pt x="4014640" y="2419981"/>
                    <a:pt x="4017105" y="2432304"/>
                  </a:cubicBezTo>
                  <a:cubicBezTo>
                    <a:pt x="4020741" y="2450484"/>
                    <a:pt x="4022932" y="2468927"/>
                    <a:pt x="4026249" y="2487168"/>
                  </a:cubicBezTo>
                  <a:cubicBezTo>
                    <a:pt x="4029029" y="2502459"/>
                    <a:pt x="4032613" y="2517597"/>
                    <a:pt x="4035393" y="2532888"/>
                  </a:cubicBezTo>
                  <a:cubicBezTo>
                    <a:pt x="4053094" y="2630246"/>
                    <a:pt x="4034041" y="2545768"/>
                    <a:pt x="4062825" y="2660904"/>
                  </a:cubicBezTo>
                  <a:lnTo>
                    <a:pt x="4071969" y="2697480"/>
                  </a:lnTo>
                  <a:cubicBezTo>
                    <a:pt x="4075017" y="2709672"/>
                    <a:pt x="4079047" y="2721660"/>
                    <a:pt x="4081113" y="2734056"/>
                  </a:cubicBezTo>
                  <a:cubicBezTo>
                    <a:pt x="4092064" y="2799760"/>
                    <a:pt x="4079973" y="2773494"/>
                    <a:pt x="4108545" y="2816352"/>
                  </a:cubicBezTo>
                  <a:cubicBezTo>
                    <a:pt x="4111593" y="2831592"/>
                    <a:pt x="4112774" y="2847328"/>
                    <a:pt x="4117689" y="2862072"/>
                  </a:cubicBezTo>
                  <a:cubicBezTo>
                    <a:pt x="4122000" y="2875004"/>
                    <a:pt x="4130607" y="2886119"/>
                    <a:pt x="4135977" y="2898648"/>
                  </a:cubicBezTo>
                  <a:cubicBezTo>
                    <a:pt x="4139774" y="2907507"/>
                    <a:pt x="4141324" y="2917221"/>
                    <a:pt x="4145121" y="2926080"/>
                  </a:cubicBezTo>
                  <a:cubicBezTo>
                    <a:pt x="4150491" y="2938609"/>
                    <a:pt x="4159098" y="2949724"/>
                    <a:pt x="4163409" y="2962656"/>
                  </a:cubicBezTo>
                  <a:cubicBezTo>
                    <a:pt x="4193342" y="3052456"/>
                    <a:pt x="4156857" y="3019248"/>
                    <a:pt x="4209129" y="3054096"/>
                  </a:cubicBezTo>
                  <a:cubicBezTo>
                    <a:pt x="4215225" y="3072384"/>
                    <a:pt x="4216724" y="3092920"/>
                    <a:pt x="4227417" y="3108960"/>
                  </a:cubicBezTo>
                  <a:cubicBezTo>
                    <a:pt x="4278339" y="3185343"/>
                    <a:pt x="4248451" y="3148282"/>
                    <a:pt x="4318857" y="3218688"/>
                  </a:cubicBezTo>
                  <a:cubicBezTo>
                    <a:pt x="4328001" y="3227832"/>
                    <a:pt x="4334723" y="3240337"/>
                    <a:pt x="4346289" y="3246120"/>
                  </a:cubicBezTo>
                  <a:cubicBezTo>
                    <a:pt x="4384811" y="3265381"/>
                    <a:pt x="4407146" y="3275703"/>
                    <a:pt x="4446873" y="3300984"/>
                  </a:cubicBezTo>
                  <a:cubicBezTo>
                    <a:pt x="4459730" y="3309166"/>
                    <a:pt x="4470526" y="3320339"/>
                    <a:pt x="4483449" y="3328416"/>
                  </a:cubicBezTo>
                  <a:cubicBezTo>
                    <a:pt x="4527561" y="3355986"/>
                    <a:pt x="4507861" y="3338878"/>
                    <a:pt x="4547457" y="3355848"/>
                  </a:cubicBezTo>
                  <a:cubicBezTo>
                    <a:pt x="4559986" y="3361218"/>
                    <a:pt x="4571504" y="3368766"/>
                    <a:pt x="4584033" y="3374136"/>
                  </a:cubicBezTo>
                  <a:cubicBezTo>
                    <a:pt x="4605957" y="3383532"/>
                    <a:pt x="4624840" y="3385795"/>
                    <a:pt x="4648041" y="3392424"/>
                  </a:cubicBezTo>
                  <a:cubicBezTo>
                    <a:pt x="4657309" y="3395072"/>
                    <a:pt x="4666122" y="3399230"/>
                    <a:pt x="4675473" y="3401568"/>
                  </a:cubicBezTo>
                  <a:cubicBezTo>
                    <a:pt x="4690551" y="3405337"/>
                    <a:pt x="4706307" y="3406246"/>
                    <a:pt x="4721193" y="3410712"/>
                  </a:cubicBezTo>
                  <a:cubicBezTo>
                    <a:pt x="4736915" y="3415429"/>
                    <a:pt x="4751455" y="3423479"/>
                    <a:pt x="4766913" y="3429000"/>
                  </a:cubicBezTo>
                  <a:cubicBezTo>
                    <a:pt x="4836348" y="3453798"/>
                    <a:pt x="4934301" y="3480690"/>
                    <a:pt x="4995513" y="3511296"/>
                  </a:cubicBezTo>
                  <a:cubicBezTo>
                    <a:pt x="5027379" y="3527229"/>
                    <a:pt x="5042783" y="3536197"/>
                    <a:pt x="5077809" y="3547872"/>
                  </a:cubicBezTo>
                  <a:cubicBezTo>
                    <a:pt x="5089731" y="3551846"/>
                    <a:pt x="5102463" y="3553042"/>
                    <a:pt x="5114385" y="3557016"/>
                  </a:cubicBezTo>
                  <a:cubicBezTo>
                    <a:pt x="5129957" y="3562207"/>
                    <a:pt x="5145106" y="3568638"/>
                    <a:pt x="5160105" y="3575304"/>
                  </a:cubicBezTo>
                  <a:cubicBezTo>
                    <a:pt x="5192014" y="3589486"/>
                    <a:pt x="5207323" y="3602313"/>
                    <a:pt x="5242401" y="3611880"/>
                  </a:cubicBezTo>
                  <a:cubicBezTo>
                    <a:pt x="5260288" y="3616758"/>
                    <a:pt x="5278977" y="3617976"/>
                    <a:pt x="5297265" y="3621024"/>
                  </a:cubicBezTo>
                  <a:cubicBezTo>
                    <a:pt x="5321649" y="3633216"/>
                    <a:pt x="5344554" y="3648979"/>
                    <a:pt x="5370417" y="3657600"/>
                  </a:cubicBezTo>
                  <a:cubicBezTo>
                    <a:pt x="5394159" y="3665514"/>
                    <a:pt x="5421701" y="3674098"/>
                    <a:pt x="5443569" y="3685032"/>
                  </a:cubicBezTo>
                  <a:cubicBezTo>
                    <a:pt x="5453399" y="3689947"/>
                    <a:pt x="5460958" y="3698857"/>
                    <a:pt x="5471001" y="3703320"/>
                  </a:cubicBezTo>
                  <a:cubicBezTo>
                    <a:pt x="5488617" y="3711149"/>
                    <a:pt x="5508146" y="3714014"/>
                    <a:pt x="5525865" y="3721608"/>
                  </a:cubicBezTo>
                  <a:cubicBezTo>
                    <a:pt x="5550923" y="3732347"/>
                    <a:pt x="5573572" y="3748397"/>
                    <a:pt x="5599017" y="3758184"/>
                  </a:cubicBezTo>
                  <a:lnTo>
                    <a:pt x="5717889" y="3803904"/>
                  </a:lnTo>
                  <a:cubicBezTo>
                    <a:pt x="5733187" y="3809853"/>
                    <a:pt x="5749534" y="3813747"/>
                    <a:pt x="5763609" y="3822192"/>
                  </a:cubicBezTo>
                  <a:cubicBezTo>
                    <a:pt x="5778849" y="3831336"/>
                    <a:pt x="5792923" y="3842788"/>
                    <a:pt x="5809329" y="3849624"/>
                  </a:cubicBezTo>
                  <a:cubicBezTo>
                    <a:pt x="5829812" y="3858159"/>
                    <a:pt x="5852626" y="3859946"/>
                    <a:pt x="5873337" y="3867912"/>
                  </a:cubicBezTo>
                  <a:cubicBezTo>
                    <a:pt x="5928978" y="3889312"/>
                    <a:pt x="5935931" y="3905657"/>
                    <a:pt x="5992209" y="3931920"/>
                  </a:cubicBezTo>
                  <a:cubicBezTo>
                    <a:pt x="6015808" y="3942933"/>
                    <a:pt x="6041181" y="3949680"/>
                    <a:pt x="6065361" y="3959352"/>
                  </a:cubicBezTo>
                  <a:cubicBezTo>
                    <a:pt x="6086914" y="3967973"/>
                    <a:pt x="6107508" y="3978977"/>
                    <a:pt x="6129369" y="3986784"/>
                  </a:cubicBezTo>
                  <a:cubicBezTo>
                    <a:pt x="6150266" y="3994247"/>
                    <a:pt x="6172600" y="3997281"/>
                    <a:pt x="6193377" y="4005072"/>
                  </a:cubicBezTo>
                  <a:cubicBezTo>
                    <a:pt x="6265263" y="4032029"/>
                    <a:pt x="6277240" y="4048627"/>
                    <a:pt x="6348825" y="4069080"/>
                  </a:cubicBezTo>
                  <a:cubicBezTo>
                    <a:pt x="6366652" y="4074173"/>
                    <a:pt x="6385560" y="4074339"/>
                    <a:pt x="6403689" y="4078224"/>
                  </a:cubicBezTo>
                  <a:cubicBezTo>
                    <a:pt x="6428266" y="4083490"/>
                    <a:pt x="6452592" y="4089899"/>
                    <a:pt x="6476841" y="4096512"/>
                  </a:cubicBezTo>
                  <a:cubicBezTo>
                    <a:pt x="6486140" y="4099048"/>
                    <a:pt x="6494864" y="4103565"/>
                    <a:pt x="6504273" y="4105656"/>
                  </a:cubicBezTo>
                  <a:cubicBezTo>
                    <a:pt x="6522372" y="4109678"/>
                    <a:pt x="6540849" y="4111752"/>
                    <a:pt x="6559137" y="4114800"/>
                  </a:cubicBezTo>
                  <a:cubicBezTo>
                    <a:pt x="6592036" y="4127960"/>
                    <a:pt x="6607683" y="4136607"/>
                    <a:pt x="6641433" y="4142232"/>
                  </a:cubicBezTo>
                  <a:cubicBezTo>
                    <a:pt x="6665672" y="4146272"/>
                    <a:pt x="6690432" y="4146847"/>
                    <a:pt x="6714585" y="4151376"/>
                  </a:cubicBezTo>
                  <a:cubicBezTo>
                    <a:pt x="6739289" y="4156008"/>
                    <a:pt x="6763353" y="4163568"/>
                    <a:pt x="6787737" y="4169664"/>
                  </a:cubicBezTo>
                  <a:cubicBezTo>
                    <a:pt x="6799929" y="4172712"/>
                    <a:pt x="6811808" y="4177558"/>
                    <a:pt x="6824313" y="4178808"/>
                  </a:cubicBezTo>
                  <a:lnTo>
                    <a:pt x="6915753" y="4187952"/>
                  </a:lnTo>
                  <a:cubicBezTo>
                    <a:pt x="7007410" y="4218504"/>
                    <a:pt x="6933132" y="4196914"/>
                    <a:pt x="7025481" y="4215384"/>
                  </a:cubicBezTo>
                  <a:cubicBezTo>
                    <a:pt x="7111001" y="4232488"/>
                    <a:pt x="7019768" y="4216242"/>
                    <a:pt x="7089489" y="4233672"/>
                  </a:cubicBezTo>
                  <a:cubicBezTo>
                    <a:pt x="7131379" y="4244144"/>
                    <a:pt x="7163943" y="4246408"/>
                    <a:pt x="7208361" y="4251960"/>
                  </a:cubicBezTo>
                  <a:cubicBezTo>
                    <a:pt x="7226649" y="4258056"/>
                    <a:pt x="7244407" y="4266066"/>
                    <a:pt x="7263225" y="4270248"/>
                  </a:cubicBezTo>
                  <a:cubicBezTo>
                    <a:pt x="7287937" y="4275740"/>
                    <a:pt x="7445494" y="4298812"/>
                    <a:pt x="7473537" y="4306824"/>
                  </a:cubicBezTo>
                  <a:cubicBezTo>
                    <a:pt x="7566998" y="4333527"/>
                    <a:pt x="7515465" y="4322904"/>
                    <a:pt x="7628985" y="4334256"/>
                  </a:cubicBezTo>
                  <a:cubicBezTo>
                    <a:pt x="7638129" y="4340352"/>
                    <a:pt x="7646374" y="4348081"/>
                    <a:pt x="7656417" y="4352544"/>
                  </a:cubicBezTo>
                  <a:cubicBezTo>
                    <a:pt x="7674033" y="4360373"/>
                    <a:pt x="7694751" y="4360914"/>
                    <a:pt x="7711281" y="4370832"/>
                  </a:cubicBezTo>
                  <a:cubicBezTo>
                    <a:pt x="7726521" y="4379976"/>
                    <a:pt x="7740140" y="4392644"/>
                    <a:pt x="7757001" y="4398264"/>
                  </a:cubicBezTo>
                  <a:cubicBezTo>
                    <a:pt x="7777448" y="4405080"/>
                    <a:pt x="7799707" y="4404131"/>
                    <a:pt x="7821009" y="4407408"/>
                  </a:cubicBezTo>
                  <a:cubicBezTo>
                    <a:pt x="7833942" y="4409398"/>
                    <a:pt x="7894711" y="4418305"/>
                    <a:pt x="7912449" y="4425696"/>
                  </a:cubicBezTo>
                  <a:cubicBezTo>
                    <a:pt x="7937614" y="4436181"/>
                    <a:pt x="7959738" y="4453651"/>
                    <a:pt x="7985601" y="4462272"/>
                  </a:cubicBezTo>
                  <a:cubicBezTo>
                    <a:pt x="8097873" y="4499696"/>
                    <a:pt x="7902719" y="4433208"/>
                    <a:pt x="8049609" y="4489704"/>
                  </a:cubicBezTo>
                  <a:cubicBezTo>
                    <a:pt x="8064801" y="4495547"/>
                    <a:pt x="8138198" y="4521233"/>
                    <a:pt x="8168481" y="4526280"/>
                  </a:cubicBezTo>
                  <a:cubicBezTo>
                    <a:pt x="8192720" y="4530320"/>
                    <a:pt x="8217345" y="4531687"/>
                    <a:pt x="8241633" y="4535424"/>
                  </a:cubicBezTo>
                  <a:cubicBezTo>
                    <a:pt x="8256994" y="4537787"/>
                    <a:pt x="8272023" y="4542013"/>
                    <a:pt x="8287353" y="4544568"/>
                  </a:cubicBezTo>
                  <a:cubicBezTo>
                    <a:pt x="8308612" y="4548111"/>
                    <a:pt x="8330156" y="4549857"/>
                    <a:pt x="8351361" y="4553712"/>
                  </a:cubicBezTo>
                  <a:cubicBezTo>
                    <a:pt x="8363726" y="4555960"/>
                    <a:pt x="8375614" y="4560391"/>
                    <a:pt x="8387937" y="4562856"/>
                  </a:cubicBezTo>
                  <a:cubicBezTo>
                    <a:pt x="8468401" y="4578949"/>
                    <a:pt x="8416846" y="4563348"/>
                    <a:pt x="8470233" y="4581144"/>
                  </a:cubicBezTo>
                  <a:cubicBezTo>
                    <a:pt x="8369215" y="4584030"/>
                    <a:pt x="8142978" y="4586437"/>
                    <a:pt x="8013033" y="4599432"/>
                  </a:cubicBezTo>
                  <a:cubicBezTo>
                    <a:pt x="7997568" y="4600978"/>
                    <a:pt x="7982643" y="4606021"/>
                    <a:pt x="7967313" y="4608576"/>
                  </a:cubicBezTo>
                  <a:cubicBezTo>
                    <a:pt x="7946054" y="4612119"/>
                    <a:pt x="7924564" y="4614177"/>
                    <a:pt x="7903305" y="4617720"/>
                  </a:cubicBezTo>
                  <a:cubicBezTo>
                    <a:pt x="7887975" y="4620275"/>
                    <a:pt x="7872990" y="4624810"/>
                    <a:pt x="7857585" y="4626864"/>
                  </a:cubicBezTo>
                  <a:cubicBezTo>
                    <a:pt x="7827222" y="4630912"/>
                    <a:pt x="7796625" y="4632960"/>
                    <a:pt x="7766145" y="4636008"/>
                  </a:cubicBezTo>
                  <a:cubicBezTo>
                    <a:pt x="7741761" y="4642104"/>
                    <a:pt x="7717529" y="4648844"/>
                    <a:pt x="7692993" y="4654296"/>
                  </a:cubicBezTo>
                  <a:cubicBezTo>
                    <a:pt x="7662650" y="4661039"/>
                    <a:pt x="7631262" y="4663443"/>
                    <a:pt x="7601553" y="4672584"/>
                  </a:cubicBezTo>
                  <a:cubicBezTo>
                    <a:pt x="7591049" y="4675816"/>
                    <a:pt x="7584449" y="4687116"/>
                    <a:pt x="7574121" y="4690872"/>
                  </a:cubicBezTo>
                  <a:cubicBezTo>
                    <a:pt x="7550500" y="4699462"/>
                    <a:pt x="7523450" y="4697920"/>
                    <a:pt x="7500969" y="4709160"/>
                  </a:cubicBezTo>
                  <a:cubicBezTo>
                    <a:pt x="7488777" y="4715256"/>
                    <a:pt x="7476922" y="4722078"/>
                    <a:pt x="7464393" y="4727448"/>
                  </a:cubicBezTo>
                  <a:cubicBezTo>
                    <a:pt x="7451010" y="4733184"/>
                    <a:pt x="7412449" y="4743880"/>
                    <a:pt x="7400385" y="4745736"/>
                  </a:cubicBezTo>
                  <a:cubicBezTo>
                    <a:pt x="7373105" y="4749933"/>
                    <a:pt x="7345521" y="4751832"/>
                    <a:pt x="7318089" y="4754880"/>
                  </a:cubicBezTo>
                  <a:cubicBezTo>
                    <a:pt x="7308945" y="4757928"/>
                    <a:pt x="7299925" y="4761376"/>
                    <a:pt x="7290657" y="4764024"/>
                  </a:cubicBezTo>
                  <a:cubicBezTo>
                    <a:pt x="7278573" y="4767476"/>
                    <a:pt x="7266369" y="4770535"/>
                    <a:pt x="7254081" y="4773168"/>
                  </a:cubicBezTo>
                  <a:cubicBezTo>
                    <a:pt x="7200786" y="4784588"/>
                    <a:pt x="7159706" y="4792611"/>
                    <a:pt x="7107777" y="4800600"/>
                  </a:cubicBezTo>
                  <a:cubicBezTo>
                    <a:pt x="7086475" y="4803877"/>
                    <a:pt x="7064974" y="4805889"/>
                    <a:pt x="7043769" y="4809744"/>
                  </a:cubicBezTo>
                  <a:cubicBezTo>
                    <a:pt x="7031404" y="4811992"/>
                    <a:pt x="7019277" y="4815436"/>
                    <a:pt x="7007193" y="4818888"/>
                  </a:cubicBezTo>
                  <a:cubicBezTo>
                    <a:pt x="6997925" y="4821536"/>
                    <a:pt x="6989268" y="4826447"/>
                    <a:pt x="6979761" y="4828032"/>
                  </a:cubicBezTo>
                  <a:cubicBezTo>
                    <a:pt x="6952536" y="4832570"/>
                    <a:pt x="6924788" y="4833273"/>
                    <a:pt x="6897465" y="4837176"/>
                  </a:cubicBezTo>
                  <a:cubicBezTo>
                    <a:pt x="6882079" y="4839374"/>
                    <a:pt x="6867075" y="4843765"/>
                    <a:pt x="6851745" y="4846320"/>
                  </a:cubicBezTo>
                  <a:cubicBezTo>
                    <a:pt x="6830486" y="4849863"/>
                    <a:pt x="6809073" y="4852416"/>
                    <a:pt x="6787737" y="4855464"/>
                  </a:cubicBezTo>
                  <a:cubicBezTo>
                    <a:pt x="6643252" y="4903626"/>
                    <a:pt x="6769081" y="4865993"/>
                    <a:pt x="6604857" y="4901184"/>
                  </a:cubicBezTo>
                  <a:cubicBezTo>
                    <a:pt x="6595432" y="4903204"/>
                    <a:pt x="6586908" y="4908604"/>
                    <a:pt x="6577425" y="4910328"/>
                  </a:cubicBezTo>
                  <a:cubicBezTo>
                    <a:pt x="6553248" y="4914724"/>
                    <a:pt x="6528512" y="4915432"/>
                    <a:pt x="6504273" y="4919472"/>
                  </a:cubicBezTo>
                  <a:cubicBezTo>
                    <a:pt x="6452961" y="4928024"/>
                    <a:pt x="6483749" y="4926889"/>
                    <a:pt x="6440265" y="4937760"/>
                  </a:cubicBezTo>
                  <a:cubicBezTo>
                    <a:pt x="6398375" y="4948232"/>
                    <a:pt x="6365811" y="4950496"/>
                    <a:pt x="6321393" y="4956048"/>
                  </a:cubicBezTo>
                  <a:cubicBezTo>
                    <a:pt x="6204661" y="4994959"/>
                    <a:pt x="6299813" y="4966763"/>
                    <a:pt x="6010497" y="4956048"/>
                  </a:cubicBezTo>
                  <a:lnTo>
                    <a:pt x="5800185" y="4946904"/>
                  </a:lnTo>
                  <a:cubicBezTo>
                    <a:pt x="5725311" y="4940097"/>
                    <a:pt x="5696378" y="4938606"/>
                    <a:pt x="5626449" y="4928616"/>
                  </a:cubicBezTo>
                  <a:cubicBezTo>
                    <a:pt x="5578885" y="4921821"/>
                    <a:pt x="5556739" y="4915244"/>
                    <a:pt x="5507577" y="4910328"/>
                  </a:cubicBezTo>
                  <a:cubicBezTo>
                    <a:pt x="5468033" y="4906374"/>
                    <a:pt x="5428329" y="4904232"/>
                    <a:pt x="5388705" y="4901184"/>
                  </a:cubicBezTo>
                  <a:cubicBezTo>
                    <a:pt x="5274848" y="4882208"/>
                    <a:pt x="5377156" y="4902191"/>
                    <a:pt x="5306409" y="4882896"/>
                  </a:cubicBezTo>
                  <a:cubicBezTo>
                    <a:pt x="5282160" y="4876283"/>
                    <a:pt x="5255738" y="4875848"/>
                    <a:pt x="5233257" y="4864608"/>
                  </a:cubicBezTo>
                  <a:cubicBezTo>
                    <a:pt x="5221065" y="4858512"/>
                    <a:pt x="5210079" y="4848832"/>
                    <a:pt x="5196681" y="4846320"/>
                  </a:cubicBezTo>
                  <a:cubicBezTo>
                    <a:pt x="5160607" y="4839556"/>
                    <a:pt x="5123529" y="4840224"/>
                    <a:pt x="5086953" y="4837176"/>
                  </a:cubicBezTo>
                  <a:cubicBezTo>
                    <a:pt x="5054073" y="4828956"/>
                    <a:pt x="5039483" y="4824692"/>
                    <a:pt x="5004657" y="4818888"/>
                  </a:cubicBezTo>
                  <a:cubicBezTo>
                    <a:pt x="4983398" y="4815345"/>
                    <a:pt x="4961951" y="4813021"/>
                    <a:pt x="4940649" y="4809744"/>
                  </a:cubicBezTo>
                  <a:cubicBezTo>
                    <a:pt x="4922324" y="4806925"/>
                    <a:pt x="4904233" y="4802445"/>
                    <a:pt x="4885785" y="4800600"/>
                  </a:cubicBezTo>
                  <a:cubicBezTo>
                    <a:pt x="4843217" y="4796343"/>
                    <a:pt x="4800357" y="4795512"/>
                    <a:pt x="4757769" y="4791456"/>
                  </a:cubicBezTo>
                  <a:cubicBezTo>
                    <a:pt x="4612772" y="4777647"/>
                    <a:pt x="4768901" y="4787613"/>
                    <a:pt x="4638897" y="4773168"/>
                  </a:cubicBezTo>
                  <a:cubicBezTo>
                    <a:pt x="4602419" y="4769115"/>
                    <a:pt x="4565706" y="4767504"/>
                    <a:pt x="4529169" y="4764024"/>
                  </a:cubicBezTo>
                  <a:cubicBezTo>
                    <a:pt x="4377275" y="4749558"/>
                    <a:pt x="4508471" y="4761617"/>
                    <a:pt x="4392009" y="4745736"/>
                  </a:cubicBezTo>
                  <a:cubicBezTo>
                    <a:pt x="4343312" y="4739096"/>
                    <a:pt x="4294359" y="4734399"/>
                    <a:pt x="4245705" y="4727448"/>
                  </a:cubicBezTo>
                  <a:cubicBezTo>
                    <a:pt x="4224369" y="4724400"/>
                    <a:pt x="4202902" y="4722159"/>
                    <a:pt x="4181697" y="4718304"/>
                  </a:cubicBezTo>
                  <a:cubicBezTo>
                    <a:pt x="4169332" y="4716056"/>
                    <a:pt x="4157205" y="4712612"/>
                    <a:pt x="4145121" y="4709160"/>
                  </a:cubicBezTo>
                  <a:cubicBezTo>
                    <a:pt x="4135853" y="4706512"/>
                    <a:pt x="4127262" y="4701142"/>
                    <a:pt x="4117689" y="4700016"/>
                  </a:cubicBezTo>
                  <a:cubicBezTo>
                    <a:pt x="4075201" y="4695017"/>
                    <a:pt x="4032328" y="4694153"/>
                    <a:pt x="3989673" y="4690872"/>
                  </a:cubicBezTo>
                  <a:lnTo>
                    <a:pt x="3879945" y="4681728"/>
                  </a:lnTo>
                  <a:cubicBezTo>
                    <a:pt x="3732501" y="4644867"/>
                    <a:pt x="3999138" y="4709200"/>
                    <a:pt x="3559905" y="4654296"/>
                  </a:cubicBezTo>
                  <a:cubicBezTo>
                    <a:pt x="3404857" y="4634915"/>
                    <a:pt x="3577713" y="4654989"/>
                    <a:pt x="3340449" y="4636008"/>
                  </a:cubicBezTo>
                  <a:cubicBezTo>
                    <a:pt x="3312936" y="4633807"/>
                    <a:pt x="3285585" y="4629912"/>
                    <a:pt x="3258153" y="4626864"/>
                  </a:cubicBezTo>
                  <a:cubicBezTo>
                    <a:pt x="3175619" y="4606230"/>
                    <a:pt x="3276195" y="4629640"/>
                    <a:pt x="3139281" y="4608576"/>
                  </a:cubicBezTo>
                  <a:cubicBezTo>
                    <a:pt x="3126860" y="4606665"/>
                    <a:pt x="3115070" y="4601680"/>
                    <a:pt x="3102705" y="4599432"/>
                  </a:cubicBezTo>
                  <a:cubicBezTo>
                    <a:pt x="3081500" y="4595577"/>
                    <a:pt x="3060033" y="4593336"/>
                    <a:pt x="3038697" y="4590288"/>
                  </a:cubicBezTo>
                  <a:cubicBezTo>
                    <a:pt x="3019890" y="4584019"/>
                    <a:pt x="2993825" y="4574551"/>
                    <a:pt x="2974689" y="4572000"/>
                  </a:cubicBezTo>
                  <a:cubicBezTo>
                    <a:pt x="2941318" y="4567551"/>
                    <a:pt x="2907633" y="4565904"/>
                    <a:pt x="2874105" y="4562856"/>
                  </a:cubicBezTo>
                  <a:cubicBezTo>
                    <a:pt x="2793970" y="4542822"/>
                    <a:pt x="2875688" y="4564245"/>
                    <a:pt x="2810097" y="4544568"/>
                  </a:cubicBezTo>
                  <a:cubicBezTo>
                    <a:pt x="2788843" y="4538192"/>
                    <a:pt x="2767140" y="4533297"/>
                    <a:pt x="2746089" y="4526280"/>
                  </a:cubicBezTo>
                  <a:cubicBezTo>
                    <a:pt x="2730517" y="4521089"/>
                    <a:pt x="2715738" y="4513755"/>
                    <a:pt x="2700369" y="4507992"/>
                  </a:cubicBezTo>
                  <a:cubicBezTo>
                    <a:pt x="2691344" y="4504608"/>
                    <a:pt x="2681558" y="4503159"/>
                    <a:pt x="2672937" y="4498848"/>
                  </a:cubicBezTo>
                  <a:cubicBezTo>
                    <a:pt x="2663107" y="4493933"/>
                    <a:pt x="2655606" y="4484889"/>
                    <a:pt x="2645505" y="4480560"/>
                  </a:cubicBezTo>
                  <a:cubicBezTo>
                    <a:pt x="2633954" y="4475610"/>
                    <a:pt x="2620851" y="4475390"/>
                    <a:pt x="2608929" y="4471416"/>
                  </a:cubicBezTo>
                  <a:cubicBezTo>
                    <a:pt x="2520821" y="4442047"/>
                    <a:pt x="2607834" y="4460566"/>
                    <a:pt x="2508345" y="4443984"/>
                  </a:cubicBezTo>
                  <a:cubicBezTo>
                    <a:pt x="2429729" y="4391573"/>
                    <a:pt x="2529197" y="4454410"/>
                    <a:pt x="2453481" y="4416552"/>
                  </a:cubicBezTo>
                  <a:cubicBezTo>
                    <a:pt x="2389555" y="4384589"/>
                    <a:pt x="2402537" y="4372139"/>
                    <a:pt x="2316321" y="4343400"/>
                  </a:cubicBezTo>
                  <a:cubicBezTo>
                    <a:pt x="2307177" y="4340352"/>
                    <a:pt x="2297510" y="4338567"/>
                    <a:pt x="2288889" y="4334256"/>
                  </a:cubicBezTo>
                  <a:cubicBezTo>
                    <a:pt x="2279059" y="4329341"/>
                    <a:pt x="2270999" y="4321420"/>
                    <a:pt x="2261457" y="4315968"/>
                  </a:cubicBezTo>
                  <a:cubicBezTo>
                    <a:pt x="2249622" y="4309205"/>
                    <a:pt x="2236716" y="4304443"/>
                    <a:pt x="2224881" y="4297680"/>
                  </a:cubicBezTo>
                  <a:cubicBezTo>
                    <a:pt x="2215339" y="4292228"/>
                    <a:pt x="2207279" y="4284307"/>
                    <a:pt x="2197449" y="4279392"/>
                  </a:cubicBezTo>
                  <a:cubicBezTo>
                    <a:pt x="2188828" y="4275081"/>
                    <a:pt x="2178443" y="4274929"/>
                    <a:pt x="2170017" y="4270248"/>
                  </a:cubicBezTo>
                  <a:cubicBezTo>
                    <a:pt x="2150804" y="4259574"/>
                    <a:pt x="2134505" y="4244092"/>
                    <a:pt x="2115153" y="4233672"/>
                  </a:cubicBezTo>
                  <a:cubicBezTo>
                    <a:pt x="2094715" y="4222667"/>
                    <a:pt x="2072277" y="4215846"/>
                    <a:pt x="2051145" y="4206240"/>
                  </a:cubicBezTo>
                  <a:cubicBezTo>
                    <a:pt x="2038736" y="4200599"/>
                    <a:pt x="2027098" y="4193322"/>
                    <a:pt x="2014569" y="4187952"/>
                  </a:cubicBezTo>
                  <a:cubicBezTo>
                    <a:pt x="2005710" y="4184155"/>
                    <a:pt x="1995758" y="4183119"/>
                    <a:pt x="1987137" y="4178808"/>
                  </a:cubicBezTo>
                  <a:cubicBezTo>
                    <a:pt x="1916233" y="4143356"/>
                    <a:pt x="2001224" y="4174360"/>
                    <a:pt x="1932273" y="4151376"/>
                  </a:cubicBezTo>
                  <a:cubicBezTo>
                    <a:pt x="1874199" y="4107821"/>
                    <a:pt x="1919885" y="4133866"/>
                    <a:pt x="1849977" y="4114800"/>
                  </a:cubicBezTo>
                  <a:cubicBezTo>
                    <a:pt x="1831379" y="4109728"/>
                    <a:pt x="1813230" y="4103100"/>
                    <a:pt x="1795113" y="4096512"/>
                  </a:cubicBezTo>
                  <a:cubicBezTo>
                    <a:pt x="1779687" y="4090903"/>
                    <a:pt x="1765317" y="4082205"/>
                    <a:pt x="1749393" y="4078224"/>
                  </a:cubicBezTo>
                  <a:cubicBezTo>
                    <a:pt x="1728484" y="4072997"/>
                    <a:pt x="1706590" y="4072935"/>
                    <a:pt x="1685385" y="4069080"/>
                  </a:cubicBezTo>
                  <a:cubicBezTo>
                    <a:pt x="1640103" y="4060847"/>
                    <a:pt x="1626262" y="4049372"/>
                    <a:pt x="1575657" y="4032504"/>
                  </a:cubicBezTo>
                  <a:cubicBezTo>
                    <a:pt x="1563735" y="4028530"/>
                    <a:pt x="1551273" y="4026408"/>
                    <a:pt x="1539081" y="4023360"/>
                  </a:cubicBezTo>
                  <a:cubicBezTo>
                    <a:pt x="1520793" y="4011168"/>
                    <a:pt x="1503430" y="3997458"/>
                    <a:pt x="1484217" y="3986784"/>
                  </a:cubicBezTo>
                  <a:cubicBezTo>
                    <a:pt x="1475791" y="3982103"/>
                    <a:pt x="1465644" y="3981437"/>
                    <a:pt x="1456785" y="3977640"/>
                  </a:cubicBezTo>
                  <a:cubicBezTo>
                    <a:pt x="1389842" y="3948950"/>
                    <a:pt x="1451067" y="3967066"/>
                    <a:pt x="1383633" y="3950208"/>
                  </a:cubicBezTo>
                  <a:cubicBezTo>
                    <a:pt x="1365345" y="3938016"/>
                    <a:pt x="1347616" y="3924940"/>
                    <a:pt x="1328769" y="3913632"/>
                  </a:cubicBezTo>
                  <a:cubicBezTo>
                    <a:pt x="1317080" y="3906619"/>
                    <a:pt x="1303882" y="3902357"/>
                    <a:pt x="1292193" y="3895344"/>
                  </a:cubicBezTo>
                  <a:cubicBezTo>
                    <a:pt x="1258115" y="3874897"/>
                    <a:pt x="1230163" y="3840975"/>
                    <a:pt x="1191609" y="3831336"/>
                  </a:cubicBezTo>
                  <a:cubicBezTo>
                    <a:pt x="1129213" y="3815737"/>
                    <a:pt x="1179935" y="3831228"/>
                    <a:pt x="1118457" y="3803904"/>
                  </a:cubicBezTo>
                  <a:cubicBezTo>
                    <a:pt x="1103458" y="3797238"/>
                    <a:pt x="1087147" y="3793476"/>
                    <a:pt x="1072737" y="3785616"/>
                  </a:cubicBezTo>
                  <a:cubicBezTo>
                    <a:pt x="1053441" y="3775091"/>
                    <a:pt x="1037086" y="3759714"/>
                    <a:pt x="1017873" y="3749040"/>
                  </a:cubicBezTo>
                  <a:cubicBezTo>
                    <a:pt x="1009447" y="3744359"/>
                    <a:pt x="999300" y="3743693"/>
                    <a:pt x="990441" y="3739896"/>
                  </a:cubicBezTo>
                  <a:cubicBezTo>
                    <a:pt x="977912" y="3734526"/>
                    <a:pt x="965700" y="3728371"/>
                    <a:pt x="953865" y="3721608"/>
                  </a:cubicBezTo>
                  <a:cubicBezTo>
                    <a:pt x="920100" y="3702314"/>
                    <a:pt x="930049" y="3700104"/>
                    <a:pt x="889857" y="3685032"/>
                  </a:cubicBezTo>
                  <a:cubicBezTo>
                    <a:pt x="878090" y="3680619"/>
                    <a:pt x="865011" y="3680399"/>
                    <a:pt x="853281" y="3675888"/>
                  </a:cubicBezTo>
                  <a:cubicBezTo>
                    <a:pt x="825263" y="3665112"/>
                    <a:pt x="798857" y="3650461"/>
                    <a:pt x="770985" y="3639312"/>
                  </a:cubicBezTo>
                  <a:cubicBezTo>
                    <a:pt x="753087" y="3632153"/>
                    <a:pt x="733363" y="3629645"/>
                    <a:pt x="716121" y="3621024"/>
                  </a:cubicBezTo>
                  <a:cubicBezTo>
                    <a:pt x="703929" y="3614928"/>
                    <a:pt x="691104" y="3609960"/>
                    <a:pt x="679545" y="3602736"/>
                  </a:cubicBezTo>
                  <a:cubicBezTo>
                    <a:pt x="666622" y="3594659"/>
                    <a:pt x="656895" y="3581494"/>
                    <a:pt x="642969" y="3575304"/>
                  </a:cubicBezTo>
                  <a:cubicBezTo>
                    <a:pt x="628767" y="3568992"/>
                    <a:pt x="612421" y="3569531"/>
                    <a:pt x="597249" y="3566160"/>
                  </a:cubicBezTo>
                  <a:cubicBezTo>
                    <a:pt x="584981" y="3563434"/>
                    <a:pt x="572440" y="3561429"/>
                    <a:pt x="560673" y="3557016"/>
                  </a:cubicBezTo>
                  <a:cubicBezTo>
                    <a:pt x="547910" y="3552230"/>
                    <a:pt x="536626" y="3544098"/>
                    <a:pt x="524097" y="3538728"/>
                  </a:cubicBezTo>
                  <a:cubicBezTo>
                    <a:pt x="455239" y="3509217"/>
                    <a:pt x="552016" y="3563383"/>
                    <a:pt x="441801" y="3502152"/>
                  </a:cubicBezTo>
                  <a:cubicBezTo>
                    <a:pt x="432194" y="3496815"/>
                    <a:pt x="424199" y="3488779"/>
                    <a:pt x="414369" y="3483864"/>
                  </a:cubicBezTo>
                  <a:cubicBezTo>
                    <a:pt x="405748" y="3479553"/>
                    <a:pt x="395712" y="3478708"/>
                    <a:pt x="386937" y="3474720"/>
                  </a:cubicBezTo>
                  <a:cubicBezTo>
                    <a:pt x="362118" y="3463439"/>
                    <a:pt x="338169" y="3450336"/>
                    <a:pt x="313785" y="3438144"/>
                  </a:cubicBezTo>
                  <a:cubicBezTo>
                    <a:pt x="301593" y="3432048"/>
                    <a:pt x="286848" y="3429495"/>
                    <a:pt x="277209" y="3419856"/>
                  </a:cubicBezTo>
                  <a:cubicBezTo>
                    <a:pt x="237210" y="3379857"/>
                    <a:pt x="260866" y="3399077"/>
                    <a:pt x="204057" y="3364992"/>
                  </a:cubicBezTo>
                  <a:cubicBezTo>
                    <a:pt x="197961" y="3355848"/>
                    <a:pt x="194212" y="3344595"/>
                    <a:pt x="185769" y="3337560"/>
                  </a:cubicBezTo>
                  <a:cubicBezTo>
                    <a:pt x="157228" y="3313776"/>
                    <a:pt x="150347" y="3324421"/>
                    <a:pt x="121761" y="3310128"/>
                  </a:cubicBezTo>
                  <a:cubicBezTo>
                    <a:pt x="111931" y="3305213"/>
                    <a:pt x="104159" y="3296755"/>
                    <a:pt x="94329" y="3291840"/>
                  </a:cubicBezTo>
                  <a:cubicBezTo>
                    <a:pt x="85708" y="3287529"/>
                    <a:pt x="75518" y="3287007"/>
                    <a:pt x="66897" y="3282696"/>
                  </a:cubicBezTo>
                  <a:cubicBezTo>
                    <a:pt x="57067" y="3277781"/>
                    <a:pt x="49007" y="3269860"/>
                    <a:pt x="39465" y="3264408"/>
                  </a:cubicBezTo>
                  <a:cubicBezTo>
                    <a:pt x="27630" y="3257645"/>
                    <a:pt x="-10742" y="3246120"/>
                    <a:pt x="2889" y="3246120"/>
                  </a:cubicBezTo>
                  <a:cubicBezTo>
                    <a:pt x="67187" y="3246120"/>
                    <a:pt x="194913" y="3264408"/>
                    <a:pt x="194913" y="3264408"/>
                  </a:cubicBezTo>
                  <a:cubicBezTo>
                    <a:pt x="227384" y="3275232"/>
                    <a:pt x="236977" y="3280014"/>
                    <a:pt x="277209" y="3282696"/>
                  </a:cubicBezTo>
                  <a:cubicBezTo>
                    <a:pt x="304580" y="3284521"/>
                    <a:pt x="335121" y="3256788"/>
                    <a:pt x="359505" y="3255264"/>
                  </a:cubicBezTo>
                  <a:close/>
                </a:path>
              </a:pathLst>
            </a:custGeom>
            <a:solidFill>
              <a:srgbClr val="FFFF99"/>
            </a:solidFill>
            <a:ln w="3175"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右矢印 21"/>
            <p:cNvSpPr/>
            <p:nvPr/>
          </p:nvSpPr>
          <p:spPr>
            <a:xfrm>
              <a:off x="1422750" y="1978300"/>
              <a:ext cx="786384" cy="25721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109310" y="923565"/>
              <a:ext cx="1148070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broblasts</a:t>
              </a:r>
            </a:p>
            <a:p>
              <a:pPr algn="ctr"/>
              <a:r>
                <a:rPr lang="en-US" altLang="ja-JP" sz="11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trisomy 21)</a:t>
              </a:r>
              <a:endParaRPr kumimoji="1" lang="ja-JP" altLang="en-US" sz="11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2423726" y="923565"/>
              <a:ext cx="949299" cy="469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iPS</a:t>
              </a:r>
              <a:r>
                <a:rPr kumimoji="1" lang="en-US" altLang="ja-JP" sz="14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cells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trisomy 21)</a:t>
              </a:r>
              <a:endParaRPr kumimoji="1" lang="ja-JP" altLang="en-US" sz="105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5" name="右矢印 24"/>
            <p:cNvSpPr/>
            <p:nvPr/>
          </p:nvSpPr>
          <p:spPr>
            <a:xfrm>
              <a:off x="3435295" y="1978300"/>
              <a:ext cx="786384" cy="25721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稲妻 25"/>
            <p:cNvSpPr/>
            <p:nvPr/>
          </p:nvSpPr>
          <p:spPr>
            <a:xfrm rot="20504130" flipV="1">
              <a:off x="1306361" y="2322904"/>
              <a:ext cx="658368" cy="626219"/>
            </a:xfrm>
            <a:prstGeom prst="lightningBol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稲妻 26"/>
            <p:cNvSpPr/>
            <p:nvPr/>
          </p:nvSpPr>
          <p:spPr>
            <a:xfrm rot="20504130" flipV="1">
              <a:off x="3349011" y="2322906"/>
              <a:ext cx="658368" cy="626219"/>
            </a:xfrm>
            <a:prstGeom prst="lightningBol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楕円 28"/>
            <p:cNvSpPr/>
            <p:nvPr/>
          </p:nvSpPr>
          <p:spPr>
            <a:xfrm>
              <a:off x="1141285" y="2995041"/>
              <a:ext cx="306830" cy="302931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449634" y="3026097"/>
              <a:ext cx="4267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Klf4</a:t>
              </a:r>
            </a:p>
          </p:txBody>
        </p:sp>
        <p:sp>
          <p:nvSpPr>
            <p:cNvPr id="42" name="右矢印 41"/>
            <p:cNvSpPr/>
            <p:nvPr/>
          </p:nvSpPr>
          <p:spPr>
            <a:xfrm>
              <a:off x="5900196" y="1978300"/>
              <a:ext cx="786384" cy="25721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296314" y="3320391"/>
              <a:ext cx="5084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EC</a:t>
              </a:r>
              <a:endParaRPr kumimoji="1"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601539" y="1524146"/>
              <a:ext cx="13469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uromycin</a:t>
              </a:r>
              <a:endPara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election</a:t>
              </a:r>
            </a:p>
          </p:txBody>
        </p:sp>
        <p:sp>
          <p:nvSpPr>
            <p:cNvPr id="55" name="右矢印 54"/>
            <p:cNvSpPr/>
            <p:nvPr/>
          </p:nvSpPr>
          <p:spPr>
            <a:xfrm>
              <a:off x="8163590" y="1978300"/>
              <a:ext cx="786384" cy="25721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角丸四角形 70"/>
            <p:cNvSpPr/>
            <p:nvPr/>
          </p:nvSpPr>
          <p:spPr>
            <a:xfrm>
              <a:off x="2605223" y="5605672"/>
              <a:ext cx="3146735" cy="687812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角丸四角形 58"/>
            <p:cNvSpPr/>
            <p:nvPr/>
          </p:nvSpPr>
          <p:spPr>
            <a:xfrm>
              <a:off x="2674853" y="5479513"/>
              <a:ext cx="595479" cy="24724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角丸四角形 59"/>
            <p:cNvSpPr/>
            <p:nvPr/>
          </p:nvSpPr>
          <p:spPr>
            <a:xfrm>
              <a:off x="5128139" y="5479513"/>
              <a:ext cx="595479" cy="24724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2664099" y="5464689"/>
              <a:ext cx="6238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Homology </a:t>
              </a:r>
            </a:p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Arm (left)</a:t>
              </a: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5100993" y="5464689"/>
              <a:ext cx="647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Homology </a:t>
              </a:r>
            </a:p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Arm (right)</a:t>
              </a:r>
            </a:p>
          </p:txBody>
        </p:sp>
        <p:sp>
          <p:nvSpPr>
            <p:cNvPr id="63" name="右矢印 62"/>
            <p:cNvSpPr/>
            <p:nvPr/>
          </p:nvSpPr>
          <p:spPr>
            <a:xfrm>
              <a:off x="3319518" y="5411085"/>
              <a:ext cx="278822" cy="403838"/>
            </a:xfrm>
            <a:prstGeom prst="rightArrow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3265551" y="5517756"/>
              <a:ext cx="378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loxP</a:t>
              </a:r>
              <a:endParaRPr lang="en-US" altLang="ja-JP" sz="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5" name="右矢印 64"/>
            <p:cNvSpPr/>
            <p:nvPr/>
          </p:nvSpPr>
          <p:spPr>
            <a:xfrm flipH="1">
              <a:off x="4810267" y="5411085"/>
              <a:ext cx="278822" cy="403838"/>
            </a:xfrm>
            <a:prstGeom prst="rightArrow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 rot="10800000">
              <a:off x="4787614" y="5519412"/>
              <a:ext cx="35794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loxP</a:t>
              </a:r>
              <a:endParaRPr lang="en-US" altLang="ja-JP" sz="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7" name="右矢印 66"/>
            <p:cNvSpPr/>
            <p:nvPr/>
          </p:nvSpPr>
          <p:spPr>
            <a:xfrm>
              <a:off x="3662737" y="5428901"/>
              <a:ext cx="1094861" cy="363067"/>
            </a:xfrm>
            <a:prstGeom prst="rightArrow">
              <a:avLst/>
            </a:prstGeom>
            <a:gradFill>
              <a:gsLst>
                <a:gs pos="96000">
                  <a:srgbClr val="FF0000"/>
                </a:gs>
                <a:gs pos="50000">
                  <a:srgbClr val="FF9999"/>
                </a:gs>
                <a:gs pos="4000">
                  <a:schemeClr val="bg1">
                    <a:lumMod val="95000"/>
                  </a:schemeClr>
                </a:gs>
              </a:gsLst>
              <a:path path="circle">
                <a:fillToRect l="50000" t="50000" r="50000" b="50000"/>
              </a:path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3619763" y="5511507"/>
              <a:ext cx="11374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AG-</a:t>
              </a:r>
              <a:r>
                <a:rPr lang="en-US" altLang="ja-JP" sz="6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uro</a:t>
              </a:r>
              <a:r>
                <a:rPr lang="en-US" altLang="ja-JP" sz="600" b="1" baseline="30000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r</a:t>
              </a:r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-ΔTK-poly(A)</a:t>
              </a:r>
            </a:p>
          </p:txBody>
        </p:sp>
        <p:sp>
          <p:nvSpPr>
            <p:cNvPr id="69" name="角丸四角形 68"/>
            <p:cNvSpPr/>
            <p:nvPr/>
          </p:nvSpPr>
          <p:spPr>
            <a:xfrm>
              <a:off x="3947782" y="6195533"/>
              <a:ext cx="488377" cy="186554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3883507" y="6194162"/>
              <a:ext cx="610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Ori , </a:t>
              </a:r>
              <a:r>
                <a:rPr lang="en-US" altLang="ja-JP" sz="6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Amp</a:t>
              </a:r>
              <a:r>
                <a:rPr lang="en-US" altLang="ja-JP" sz="600" b="1" baseline="30000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r</a:t>
              </a:r>
              <a:endParaRPr lang="en-US" altLang="ja-JP" sz="600" b="1" baseline="30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75" name="直線コネクタ 74"/>
            <p:cNvCxnSpPr/>
            <p:nvPr/>
          </p:nvCxnSpPr>
          <p:spPr>
            <a:xfrm>
              <a:off x="2800282" y="4494155"/>
              <a:ext cx="1711069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テキスト ボックス 76"/>
            <p:cNvSpPr txBox="1"/>
            <p:nvPr/>
          </p:nvSpPr>
          <p:spPr>
            <a:xfrm>
              <a:off x="2208458" y="4264698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hromosome21</a:t>
              </a: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4007325" y="4136538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HSF2BP intron3</a:t>
              </a:r>
            </a:p>
          </p:txBody>
        </p:sp>
        <p:sp>
          <p:nvSpPr>
            <p:cNvPr id="80" name="角丸四角形 79"/>
            <p:cNvSpPr/>
            <p:nvPr/>
          </p:nvSpPr>
          <p:spPr>
            <a:xfrm>
              <a:off x="3905117" y="4363335"/>
              <a:ext cx="45719" cy="258836"/>
            </a:xfrm>
            <a:prstGeom prst="roundRect">
              <a:avLst/>
            </a:prstGeom>
            <a:solidFill>
              <a:schemeClr val="accent4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3537066" y="4177252"/>
              <a:ext cx="6464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enta</a:t>
              </a:r>
              <a:r>
                <a:rPr lang="en-US" altLang="ja-JP" sz="8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D</a:t>
              </a:r>
            </a:p>
          </p:txBody>
        </p:sp>
        <p:cxnSp>
          <p:nvCxnSpPr>
            <p:cNvPr id="83" name="直線コネクタ 82"/>
            <p:cNvCxnSpPr/>
            <p:nvPr/>
          </p:nvCxnSpPr>
          <p:spPr>
            <a:xfrm>
              <a:off x="2332947" y="4497203"/>
              <a:ext cx="33265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/>
            <p:cNvCxnSpPr/>
            <p:nvPr/>
          </p:nvCxnSpPr>
          <p:spPr>
            <a:xfrm>
              <a:off x="2696706" y="4497203"/>
              <a:ext cx="6736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/>
            <p:cNvCxnSpPr/>
            <p:nvPr/>
          </p:nvCxnSpPr>
          <p:spPr>
            <a:xfrm flipH="1">
              <a:off x="2614813" y="4545094"/>
              <a:ext cx="1533904" cy="925392"/>
            </a:xfrm>
            <a:prstGeom prst="line">
              <a:avLst/>
            </a:prstGeom>
            <a:ln w="6350">
              <a:solidFill>
                <a:schemeClr val="accent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/>
            <p:cNvCxnSpPr/>
            <p:nvPr/>
          </p:nvCxnSpPr>
          <p:spPr>
            <a:xfrm>
              <a:off x="4309088" y="4545094"/>
              <a:ext cx="1468392" cy="899878"/>
            </a:xfrm>
            <a:prstGeom prst="line">
              <a:avLst/>
            </a:prstGeom>
            <a:ln w="635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7" name="図 96" descr="画面の領域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71" t="8919" r="7879" b="4196"/>
            <a:stretch/>
          </p:blipFill>
          <p:spPr>
            <a:xfrm>
              <a:off x="4133276" y="4628172"/>
              <a:ext cx="202952" cy="275361"/>
            </a:xfrm>
            <a:prstGeom prst="rect">
              <a:avLst/>
            </a:prstGeom>
          </p:spPr>
        </p:pic>
        <p:sp>
          <p:nvSpPr>
            <p:cNvPr id="125" name="テキスト ボックス 124"/>
            <p:cNvSpPr txBox="1"/>
            <p:nvPr/>
          </p:nvSpPr>
          <p:spPr>
            <a:xfrm>
              <a:off x="7982421" y="1486822"/>
              <a:ext cx="1211531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Negative selection</a:t>
              </a:r>
              <a:r>
                <a:rPr lang="ja-JP" altLang="en-US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　</a:t>
              </a:r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FIAU)</a:t>
              </a:r>
            </a:p>
          </p:txBody>
        </p:sp>
        <p:sp>
          <p:nvSpPr>
            <p:cNvPr id="141" name="角丸四角形吹き出し 140"/>
            <p:cNvSpPr/>
            <p:nvPr/>
          </p:nvSpPr>
          <p:spPr>
            <a:xfrm>
              <a:off x="2106140" y="4058538"/>
              <a:ext cx="3802371" cy="2559612"/>
            </a:xfrm>
            <a:prstGeom prst="wedgeRoundRectCallout">
              <a:avLst>
                <a:gd name="adj1" fmla="val -11412"/>
                <a:gd name="adj2" fmla="val -68672"/>
                <a:gd name="adj3" fmla="val 16667"/>
              </a:avLst>
            </a:prstGeom>
            <a:noFill/>
            <a:ln w="28575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角丸四角形吹き出し 141"/>
            <p:cNvSpPr/>
            <p:nvPr/>
          </p:nvSpPr>
          <p:spPr>
            <a:xfrm>
              <a:off x="6811422" y="4054752"/>
              <a:ext cx="3802371" cy="2574648"/>
            </a:xfrm>
            <a:prstGeom prst="wedgeRoundRectCallout">
              <a:avLst>
                <a:gd name="adj1" fmla="val -10417"/>
                <a:gd name="adj2" fmla="val -67413"/>
                <a:gd name="adj3" fmla="val 16667"/>
              </a:avLst>
            </a:prstGeom>
            <a:noFill/>
            <a:ln w="28575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右矢印 142"/>
            <p:cNvSpPr/>
            <p:nvPr/>
          </p:nvSpPr>
          <p:spPr>
            <a:xfrm>
              <a:off x="10224762" y="1975073"/>
              <a:ext cx="786384" cy="257211"/>
            </a:xfrm>
            <a:prstGeom prst="rightArrow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グループ化 144"/>
            <p:cNvGrpSpPr/>
            <p:nvPr/>
          </p:nvGrpSpPr>
          <p:grpSpPr>
            <a:xfrm>
              <a:off x="11071799" y="1903499"/>
              <a:ext cx="852384" cy="520136"/>
              <a:chOff x="6945745" y="2299855"/>
              <a:chExt cx="2872510" cy="867275"/>
            </a:xfrm>
          </p:grpSpPr>
          <p:sp>
            <p:nvSpPr>
              <p:cNvPr id="146" name="楕円 145"/>
              <p:cNvSpPr/>
              <p:nvPr/>
            </p:nvSpPr>
            <p:spPr>
              <a:xfrm>
                <a:off x="6945745" y="2594476"/>
                <a:ext cx="2872510" cy="572654"/>
              </a:xfrm>
              <a:prstGeom prst="ellipse">
                <a:avLst/>
              </a:prstGeom>
              <a:solidFill>
                <a:srgbClr val="CCFFFF">
                  <a:alpha val="1000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7" name="直線コネクタ 146"/>
              <p:cNvCxnSpPr>
                <a:stCxn id="146" idx="2"/>
                <a:endCxn id="149" idx="2"/>
              </p:cNvCxnSpPr>
              <p:nvPr/>
            </p:nvCxnSpPr>
            <p:spPr>
              <a:xfrm flipV="1">
                <a:off x="6945745" y="2586182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線コネクタ 147"/>
              <p:cNvCxnSpPr/>
              <p:nvPr/>
            </p:nvCxnSpPr>
            <p:spPr>
              <a:xfrm flipV="1">
                <a:off x="9818255" y="2553383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楕円 148"/>
              <p:cNvSpPr/>
              <p:nvPr/>
            </p:nvSpPr>
            <p:spPr>
              <a:xfrm>
                <a:off x="6945745" y="2299855"/>
                <a:ext cx="2872510" cy="572654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9" name="テキスト ボックス 158"/>
            <p:cNvSpPr txBox="1"/>
            <p:nvPr/>
          </p:nvSpPr>
          <p:spPr>
            <a:xfrm>
              <a:off x="9940949" y="1524146"/>
              <a:ext cx="1302422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ingle cell cloning</a:t>
              </a:r>
            </a:p>
          </p:txBody>
        </p:sp>
        <p:grpSp>
          <p:nvGrpSpPr>
            <p:cNvPr id="162" name="グループ化 161"/>
            <p:cNvGrpSpPr/>
            <p:nvPr/>
          </p:nvGrpSpPr>
          <p:grpSpPr>
            <a:xfrm>
              <a:off x="11071799" y="2637208"/>
              <a:ext cx="852384" cy="520136"/>
              <a:chOff x="6945745" y="2299855"/>
              <a:chExt cx="2872510" cy="867275"/>
            </a:xfrm>
          </p:grpSpPr>
          <p:sp>
            <p:nvSpPr>
              <p:cNvPr id="163" name="楕円 162"/>
              <p:cNvSpPr/>
              <p:nvPr/>
            </p:nvSpPr>
            <p:spPr>
              <a:xfrm>
                <a:off x="6945745" y="2594476"/>
                <a:ext cx="2872510" cy="572654"/>
              </a:xfrm>
              <a:prstGeom prst="ellipse">
                <a:avLst/>
              </a:prstGeom>
              <a:solidFill>
                <a:srgbClr val="CCFFFF">
                  <a:alpha val="1000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4" name="直線コネクタ 163"/>
              <p:cNvCxnSpPr>
                <a:stCxn id="163" idx="2"/>
                <a:endCxn id="166" idx="2"/>
              </p:cNvCxnSpPr>
              <p:nvPr/>
            </p:nvCxnSpPr>
            <p:spPr>
              <a:xfrm flipV="1">
                <a:off x="6945745" y="2586182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線コネクタ 164"/>
              <p:cNvCxnSpPr/>
              <p:nvPr/>
            </p:nvCxnSpPr>
            <p:spPr>
              <a:xfrm flipV="1">
                <a:off x="9818255" y="2553383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楕円 165"/>
              <p:cNvSpPr/>
              <p:nvPr/>
            </p:nvSpPr>
            <p:spPr>
              <a:xfrm>
                <a:off x="6945745" y="2299855"/>
                <a:ext cx="2872510" cy="572654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0" name="グループ化 169"/>
            <p:cNvGrpSpPr/>
            <p:nvPr/>
          </p:nvGrpSpPr>
          <p:grpSpPr>
            <a:xfrm>
              <a:off x="11071799" y="1218844"/>
              <a:ext cx="852384" cy="520136"/>
              <a:chOff x="6945745" y="2299855"/>
              <a:chExt cx="2872510" cy="867275"/>
            </a:xfrm>
          </p:grpSpPr>
          <p:sp>
            <p:nvSpPr>
              <p:cNvPr id="171" name="楕円 170"/>
              <p:cNvSpPr/>
              <p:nvPr/>
            </p:nvSpPr>
            <p:spPr>
              <a:xfrm>
                <a:off x="6945745" y="2594476"/>
                <a:ext cx="2872510" cy="572654"/>
              </a:xfrm>
              <a:prstGeom prst="ellipse">
                <a:avLst/>
              </a:prstGeom>
              <a:solidFill>
                <a:srgbClr val="CCFFFF">
                  <a:alpha val="1000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2" name="直線コネクタ 171"/>
              <p:cNvCxnSpPr>
                <a:stCxn id="171" idx="2"/>
                <a:endCxn id="174" idx="2"/>
              </p:cNvCxnSpPr>
              <p:nvPr/>
            </p:nvCxnSpPr>
            <p:spPr>
              <a:xfrm flipV="1">
                <a:off x="6945745" y="2586182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線コネクタ 172"/>
              <p:cNvCxnSpPr/>
              <p:nvPr/>
            </p:nvCxnSpPr>
            <p:spPr>
              <a:xfrm flipV="1">
                <a:off x="9818255" y="2553383"/>
                <a:ext cx="0" cy="2946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楕円 173"/>
              <p:cNvSpPr/>
              <p:nvPr/>
            </p:nvSpPr>
            <p:spPr>
              <a:xfrm>
                <a:off x="6945745" y="2299855"/>
                <a:ext cx="2872510" cy="572654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5" name="テキスト ボックス 174"/>
            <p:cNvSpPr txBox="1"/>
            <p:nvPr/>
          </p:nvSpPr>
          <p:spPr>
            <a:xfrm>
              <a:off x="1761581" y="3268061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-</a:t>
              </a:r>
              <a:r>
                <a:rPr lang="en-US" altLang="ja-JP" sz="10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yc</a:t>
              </a:r>
              <a:endParaRPr lang="en-US" altLang="ja-JP" sz="10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0" name="二等辺三角形 179"/>
            <p:cNvSpPr/>
            <p:nvPr/>
          </p:nvSpPr>
          <p:spPr>
            <a:xfrm flipV="1">
              <a:off x="4183558" y="4310626"/>
              <a:ext cx="117737" cy="13569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11009513" y="623482"/>
              <a:ext cx="933268" cy="469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iPS</a:t>
              </a:r>
              <a:r>
                <a:rPr kumimoji="1" lang="en-US" altLang="ja-JP" sz="14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cells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</a:t>
              </a:r>
              <a:r>
                <a:rPr lang="en-US" altLang="ja-JP" sz="105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disomy</a:t>
              </a:r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21)</a:t>
              </a:r>
              <a:endParaRPr kumimoji="1" lang="ja-JP" altLang="en-US" sz="105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1065040" y="3037229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ox4</a:t>
              </a: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700970" y="3268061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Oct3/4</a:t>
              </a:r>
            </a:p>
          </p:txBody>
        </p:sp>
        <p:sp>
          <p:nvSpPr>
            <p:cNvPr id="130" name="稲妻 129"/>
            <p:cNvSpPr/>
            <p:nvPr/>
          </p:nvSpPr>
          <p:spPr>
            <a:xfrm rot="20504130" flipV="1">
              <a:off x="7967434" y="2315866"/>
              <a:ext cx="658368" cy="626219"/>
            </a:xfrm>
            <a:prstGeom prst="lightningBol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楕円 1"/>
            <p:cNvSpPr/>
            <p:nvPr/>
          </p:nvSpPr>
          <p:spPr>
            <a:xfrm>
              <a:off x="8015264" y="3027272"/>
              <a:ext cx="322933" cy="296866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円弧 2"/>
            <p:cNvSpPr/>
            <p:nvPr/>
          </p:nvSpPr>
          <p:spPr>
            <a:xfrm>
              <a:off x="8130826" y="3037680"/>
              <a:ext cx="211001" cy="264880"/>
            </a:xfrm>
            <a:prstGeom prst="arc">
              <a:avLst/>
            </a:prstGeom>
            <a:ln w="571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/>
            <p:cNvSpPr txBox="1"/>
            <p:nvPr/>
          </p:nvSpPr>
          <p:spPr>
            <a:xfrm>
              <a:off x="7695256" y="3332330"/>
              <a:ext cx="1430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re</a:t>
              </a:r>
              <a:r>
                <a:rPr kumimoji="1"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recombinase</a:t>
              </a:r>
              <a:endParaRPr kumimoji="1"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5" name="直線矢印コネクタ 4"/>
            <p:cNvCxnSpPr/>
            <p:nvPr/>
          </p:nvCxnSpPr>
          <p:spPr>
            <a:xfrm flipH="1">
              <a:off x="4440120" y="4578645"/>
              <a:ext cx="18175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矢印コネクタ 133"/>
            <p:cNvCxnSpPr/>
            <p:nvPr/>
          </p:nvCxnSpPr>
          <p:spPr>
            <a:xfrm flipH="1">
              <a:off x="3646731" y="4627238"/>
              <a:ext cx="181756" cy="0"/>
            </a:xfrm>
            <a:prstGeom prst="straightConnector1">
              <a:avLst/>
            </a:prstGeom>
            <a:ln>
              <a:solidFill>
                <a:srgbClr val="000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/>
            <p:cNvCxnSpPr/>
            <p:nvPr/>
          </p:nvCxnSpPr>
          <p:spPr>
            <a:xfrm flipV="1">
              <a:off x="7936961" y="4264316"/>
              <a:ext cx="1715247" cy="20658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/>
            <p:cNvSpPr txBox="1"/>
            <p:nvPr/>
          </p:nvSpPr>
          <p:spPr>
            <a:xfrm>
              <a:off x="7154347" y="4037153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ister chromatids</a:t>
              </a:r>
            </a:p>
          </p:txBody>
        </p:sp>
        <p:cxnSp>
          <p:nvCxnSpPr>
            <p:cNvPr id="160" name="直線コネクタ 159"/>
            <p:cNvCxnSpPr/>
            <p:nvPr/>
          </p:nvCxnSpPr>
          <p:spPr>
            <a:xfrm>
              <a:off x="7473804" y="4267363"/>
              <a:ext cx="329958" cy="17611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/>
            <p:cNvCxnSpPr/>
            <p:nvPr/>
          </p:nvCxnSpPr>
          <p:spPr>
            <a:xfrm>
              <a:off x="7837563" y="4290223"/>
              <a:ext cx="6736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二等辺三角形 7"/>
            <p:cNvSpPr/>
            <p:nvPr/>
          </p:nvSpPr>
          <p:spPr>
            <a:xfrm rot="5400000" flipH="1">
              <a:off x="9106364" y="4208521"/>
              <a:ext cx="152734" cy="95460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9240383" y="4229660"/>
              <a:ext cx="197856" cy="89236"/>
            </a:xfrm>
            <a:prstGeom prst="rect">
              <a:avLst/>
            </a:prstGeom>
            <a:gradFill>
              <a:gsLst>
                <a:gs pos="96000">
                  <a:srgbClr val="FF0000"/>
                </a:gs>
                <a:gs pos="50000">
                  <a:srgbClr val="FF9999"/>
                </a:gs>
                <a:gs pos="4000">
                  <a:schemeClr val="bg1">
                    <a:lumMod val="95000"/>
                  </a:schemeClr>
                </a:gs>
              </a:gsLst>
              <a:path path="circle">
                <a:fillToRect l="50000" t="50000" r="50000" b="50000"/>
              </a:path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5" name="二等辺三角形 194"/>
            <p:cNvSpPr/>
            <p:nvPr/>
          </p:nvSpPr>
          <p:spPr>
            <a:xfrm rot="16200000">
              <a:off x="9422921" y="4208522"/>
              <a:ext cx="152734" cy="95458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96" name="直線コネクタ 195"/>
            <p:cNvCxnSpPr/>
            <p:nvPr/>
          </p:nvCxnSpPr>
          <p:spPr>
            <a:xfrm>
              <a:off x="7936961" y="4382794"/>
              <a:ext cx="1719424" cy="2743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線コネクタ 199"/>
            <p:cNvCxnSpPr/>
            <p:nvPr/>
          </p:nvCxnSpPr>
          <p:spPr>
            <a:xfrm flipV="1">
              <a:off x="7477981" y="4392696"/>
              <a:ext cx="333920" cy="20578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直線コネクタ 200"/>
            <p:cNvCxnSpPr/>
            <p:nvPr/>
          </p:nvCxnSpPr>
          <p:spPr>
            <a:xfrm>
              <a:off x="7841740" y="4382794"/>
              <a:ext cx="6736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二等辺三角形 203"/>
            <p:cNvSpPr/>
            <p:nvPr/>
          </p:nvSpPr>
          <p:spPr>
            <a:xfrm rot="5400000" flipH="1">
              <a:off x="9108001" y="4354432"/>
              <a:ext cx="152734" cy="95460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5" name="正方形/長方形 204"/>
            <p:cNvSpPr/>
            <p:nvPr/>
          </p:nvSpPr>
          <p:spPr>
            <a:xfrm>
              <a:off x="9244560" y="4375571"/>
              <a:ext cx="197856" cy="89236"/>
            </a:xfrm>
            <a:prstGeom prst="rect">
              <a:avLst/>
            </a:prstGeom>
            <a:gradFill>
              <a:gsLst>
                <a:gs pos="96000">
                  <a:srgbClr val="FF0000"/>
                </a:gs>
                <a:gs pos="50000">
                  <a:srgbClr val="FF9999"/>
                </a:gs>
                <a:gs pos="4000">
                  <a:schemeClr val="bg1">
                    <a:lumMod val="95000"/>
                  </a:schemeClr>
                </a:gs>
              </a:gsLst>
              <a:path path="circle">
                <a:fillToRect l="50000" t="50000" r="50000" b="50000"/>
              </a:path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6" name="二等辺三角形 205"/>
            <p:cNvSpPr/>
            <p:nvPr/>
          </p:nvSpPr>
          <p:spPr>
            <a:xfrm rot="16200000">
              <a:off x="9427098" y="4369673"/>
              <a:ext cx="152734" cy="95458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07" name="直線コネクタ 206"/>
            <p:cNvCxnSpPr>
              <a:endCxn id="211" idx="0"/>
            </p:cNvCxnSpPr>
            <p:nvPr/>
          </p:nvCxnSpPr>
          <p:spPr>
            <a:xfrm flipV="1">
              <a:off x="7936961" y="5083639"/>
              <a:ext cx="1243066" cy="121924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線コネクタ 208"/>
            <p:cNvCxnSpPr/>
            <p:nvPr/>
          </p:nvCxnSpPr>
          <p:spPr>
            <a:xfrm>
              <a:off x="7479250" y="5167141"/>
              <a:ext cx="324512" cy="4572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直線コネクタ 209"/>
            <p:cNvCxnSpPr/>
            <p:nvPr/>
          </p:nvCxnSpPr>
          <p:spPr>
            <a:xfrm>
              <a:off x="7843009" y="5212861"/>
              <a:ext cx="6736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二等辺三角形 210"/>
            <p:cNvSpPr/>
            <p:nvPr/>
          </p:nvSpPr>
          <p:spPr>
            <a:xfrm rot="5400000" flipH="1">
              <a:off x="9055930" y="5035909"/>
              <a:ext cx="152734" cy="95460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14" name="直線コネクタ 213"/>
            <p:cNvCxnSpPr>
              <a:endCxn id="217" idx="0"/>
            </p:cNvCxnSpPr>
            <p:nvPr/>
          </p:nvCxnSpPr>
          <p:spPr>
            <a:xfrm>
              <a:off x="7936961" y="5318069"/>
              <a:ext cx="1242547" cy="17241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直線コネクタ 214"/>
            <p:cNvCxnSpPr/>
            <p:nvPr/>
          </p:nvCxnSpPr>
          <p:spPr>
            <a:xfrm flipV="1">
              <a:off x="7471111" y="5314903"/>
              <a:ext cx="340790" cy="3048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直線コネクタ 215"/>
            <p:cNvCxnSpPr/>
            <p:nvPr/>
          </p:nvCxnSpPr>
          <p:spPr>
            <a:xfrm>
              <a:off x="7847570" y="5314903"/>
              <a:ext cx="6736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二等辺三角形 216"/>
            <p:cNvSpPr/>
            <p:nvPr/>
          </p:nvSpPr>
          <p:spPr>
            <a:xfrm rot="5400000" flipH="1">
              <a:off x="9055411" y="5442751"/>
              <a:ext cx="152734" cy="95460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アーチ 13"/>
            <p:cNvSpPr/>
            <p:nvPr/>
          </p:nvSpPr>
          <p:spPr>
            <a:xfrm rot="16200000">
              <a:off x="9809922" y="4894638"/>
              <a:ext cx="509805" cy="761423"/>
            </a:xfrm>
            <a:prstGeom prst="blockArc">
              <a:avLst>
                <a:gd name="adj1" fmla="val 10800000"/>
                <a:gd name="adj2" fmla="val 21182406"/>
                <a:gd name="adj3" fmla="val 12811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221" name="アーチ 220"/>
            <p:cNvSpPr/>
            <p:nvPr/>
          </p:nvSpPr>
          <p:spPr>
            <a:xfrm rot="16200000">
              <a:off x="9672650" y="5040143"/>
              <a:ext cx="509805" cy="486875"/>
            </a:xfrm>
            <a:prstGeom prst="blockArc">
              <a:avLst>
                <a:gd name="adj1" fmla="val 10411770"/>
                <a:gd name="adj2" fmla="val 21418696"/>
                <a:gd name="adj3" fmla="val 20883"/>
              </a:avLst>
            </a:prstGeom>
            <a:gradFill>
              <a:gsLst>
                <a:gs pos="96000">
                  <a:srgbClr val="FF0000"/>
                </a:gs>
                <a:gs pos="50000">
                  <a:srgbClr val="FF9999"/>
                </a:gs>
                <a:gs pos="4000">
                  <a:schemeClr val="bg1">
                    <a:lumMod val="95000"/>
                  </a:schemeClr>
                </a:gs>
              </a:gsLst>
              <a:path path="circle">
                <a:fillToRect l="50000" t="50000" r="50000" b="50000"/>
              </a:path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222" name="二等辺三角形 221"/>
            <p:cNvSpPr/>
            <p:nvPr/>
          </p:nvSpPr>
          <p:spPr>
            <a:xfrm rot="16200000">
              <a:off x="9879442" y="5030910"/>
              <a:ext cx="152734" cy="95458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3" name="二等辺三角形 222"/>
            <p:cNvSpPr/>
            <p:nvPr/>
          </p:nvSpPr>
          <p:spPr>
            <a:xfrm rot="16200000">
              <a:off x="9913199" y="5450539"/>
              <a:ext cx="152734" cy="95458"/>
            </a:xfrm>
            <a:prstGeom prst="triangl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5" name="アーチ 224"/>
            <p:cNvSpPr/>
            <p:nvPr/>
          </p:nvSpPr>
          <p:spPr>
            <a:xfrm rot="5400000" flipH="1">
              <a:off x="8950232" y="5040143"/>
              <a:ext cx="509805" cy="486875"/>
            </a:xfrm>
            <a:prstGeom prst="blockArc">
              <a:avLst>
                <a:gd name="adj1" fmla="val 10486047"/>
                <a:gd name="adj2" fmla="val 331208"/>
                <a:gd name="adj3" fmla="val 20780"/>
              </a:avLst>
            </a:prstGeom>
            <a:gradFill>
              <a:gsLst>
                <a:gs pos="96000">
                  <a:srgbClr val="FF0000"/>
                </a:gs>
                <a:gs pos="50000">
                  <a:srgbClr val="FF9999"/>
                </a:gs>
                <a:gs pos="4000">
                  <a:schemeClr val="bg1">
                    <a:lumMod val="95000"/>
                  </a:schemeClr>
                </a:gs>
              </a:gsLst>
              <a:path path="circle">
                <a:fillToRect l="50000" t="50000" r="50000" b="50000"/>
              </a:path>
            </a:gra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cxnSp>
          <p:nvCxnSpPr>
            <p:cNvPr id="229" name="直線矢印コネクタ 228"/>
            <p:cNvCxnSpPr/>
            <p:nvPr/>
          </p:nvCxnSpPr>
          <p:spPr>
            <a:xfrm>
              <a:off x="8362137" y="4545094"/>
              <a:ext cx="0" cy="4571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曲線コネクタ 230"/>
            <p:cNvCxnSpPr/>
            <p:nvPr/>
          </p:nvCxnSpPr>
          <p:spPr>
            <a:xfrm>
              <a:off x="7957516" y="4632891"/>
              <a:ext cx="408023" cy="368735"/>
            </a:xfrm>
            <a:prstGeom prst="curvedConnector3">
              <a:avLst>
                <a:gd name="adj1" fmla="val 99489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テキスト ボックス 239"/>
            <p:cNvSpPr txBox="1"/>
            <p:nvPr/>
          </p:nvSpPr>
          <p:spPr>
            <a:xfrm>
              <a:off x="7661231" y="4509623"/>
              <a:ext cx="3610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re</a:t>
              </a:r>
              <a:endParaRPr lang="en-US" altLang="ja-JP" sz="8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5" name="テキスト ボックス 244"/>
            <p:cNvSpPr txBox="1"/>
            <p:nvPr/>
          </p:nvSpPr>
          <p:spPr>
            <a:xfrm>
              <a:off x="9656666" y="5163389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Nullicentric</a:t>
              </a:r>
              <a:endParaRPr lang="en-US" altLang="ja-JP" sz="8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6" name="テキスト ボックス 245"/>
            <p:cNvSpPr txBox="1"/>
            <p:nvPr/>
          </p:nvSpPr>
          <p:spPr>
            <a:xfrm>
              <a:off x="8196250" y="5182725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Dicentric</a:t>
              </a:r>
              <a:endParaRPr lang="en-US" altLang="ja-JP" sz="8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56" name="直線矢印コネクタ 255"/>
            <p:cNvCxnSpPr/>
            <p:nvPr/>
          </p:nvCxnSpPr>
          <p:spPr>
            <a:xfrm>
              <a:off x="8362137" y="5488800"/>
              <a:ext cx="0" cy="4571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線コネクタ 256"/>
            <p:cNvCxnSpPr>
              <a:endCxn id="260" idx="0"/>
            </p:cNvCxnSpPr>
            <p:nvPr/>
          </p:nvCxnSpPr>
          <p:spPr>
            <a:xfrm flipV="1">
              <a:off x="7867054" y="5936521"/>
              <a:ext cx="1243066" cy="121924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線コネクタ 257"/>
            <p:cNvCxnSpPr/>
            <p:nvPr/>
          </p:nvCxnSpPr>
          <p:spPr>
            <a:xfrm>
              <a:off x="7409343" y="6020023"/>
              <a:ext cx="324512" cy="45720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直線コネクタ 258"/>
            <p:cNvCxnSpPr/>
            <p:nvPr/>
          </p:nvCxnSpPr>
          <p:spPr>
            <a:xfrm>
              <a:off x="7773102" y="6065743"/>
              <a:ext cx="67363" cy="0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二等辺三角形 259"/>
            <p:cNvSpPr/>
            <p:nvPr/>
          </p:nvSpPr>
          <p:spPr>
            <a:xfrm rot="5400000" flipH="1">
              <a:off x="8986023" y="5888791"/>
              <a:ext cx="152734" cy="95460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61" name="直線コネクタ 260"/>
            <p:cNvCxnSpPr>
              <a:endCxn id="264" idx="0"/>
            </p:cNvCxnSpPr>
            <p:nvPr/>
          </p:nvCxnSpPr>
          <p:spPr>
            <a:xfrm>
              <a:off x="7887609" y="6174995"/>
              <a:ext cx="1221992" cy="168368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直線コネクタ 261"/>
            <p:cNvCxnSpPr/>
            <p:nvPr/>
          </p:nvCxnSpPr>
          <p:spPr>
            <a:xfrm flipV="1">
              <a:off x="7401204" y="6167785"/>
              <a:ext cx="340790" cy="30480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直線コネクタ 262"/>
            <p:cNvCxnSpPr/>
            <p:nvPr/>
          </p:nvCxnSpPr>
          <p:spPr>
            <a:xfrm>
              <a:off x="7764963" y="6167785"/>
              <a:ext cx="67363" cy="0"/>
            </a:xfrm>
            <a:prstGeom prst="line">
              <a:avLst/>
            </a:prstGeom>
            <a:ln w="7620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4" name="二等辺三角形 263"/>
            <p:cNvSpPr/>
            <p:nvPr/>
          </p:nvSpPr>
          <p:spPr>
            <a:xfrm rot="5400000" flipH="1">
              <a:off x="8985504" y="6295633"/>
              <a:ext cx="152734" cy="95460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5" name="アーチ 264"/>
            <p:cNvSpPr/>
            <p:nvPr/>
          </p:nvSpPr>
          <p:spPr>
            <a:xfrm rot="16200000">
              <a:off x="9740015" y="5747520"/>
              <a:ext cx="509805" cy="761423"/>
            </a:xfrm>
            <a:prstGeom prst="blockArc">
              <a:avLst>
                <a:gd name="adj1" fmla="val 10800000"/>
                <a:gd name="adj2" fmla="val 21182406"/>
                <a:gd name="adj3" fmla="val 12811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266" name="アーチ 265"/>
            <p:cNvSpPr/>
            <p:nvPr/>
          </p:nvSpPr>
          <p:spPr>
            <a:xfrm rot="16200000">
              <a:off x="9602743" y="5893025"/>
              <a:ext cx="509805" cy="486875"/>
            </a:xfrm>
            <a:prstGeom prst="blockArc">
              <a:avLst>
                <a:gd name="adj1" fmla="val 10411770"/>
                <a:gd name="adj2" fmla="val 21418696"/>
                <a:gd name="adj3" fmla="val 20883"/>
              </a:avLst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267" name="二等辺三角形 266"/>
            <p:cNvSpPr/>
            <p:nvPr/>
          </p:nvSpPr>
          <p:spPr>
            <a:xfrm rot="16200000">
              <a:off x="9809535" y="5883792"/>
              <a:ext cx="152734" cy="95458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8" name="二等辺三角形 267"/>
            <p:cNvSpPr/>
            <p:nvPr/>
          </p:nvSpPr>
          <p:spPr>
            <a:xfrm rot="16200000">
              <a:off x="9843292" y="6303421"/>
              <a:ext cx="152734" cy="95458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9" name="アーチ 268"/>
            <p:cNvSpPr/>
            <p:nvPr/>
          </p:nvSpPr>
          <p:spPr>
            <a:xfrm rot="5400000" flipH="1">
              <a:off x="8880325" y="5893025"/>
              <a:ext cx="509805" cy="486875"/>
            </a:xfrm>
            <a:prstGeom prst="blockArc">
              <a:avLst>
                <a:gd name="adj1" fmla="val 10486047"/>
                <a:gd name="adj2" fmla="val 331208"/>
                <a:gd name="adj3" fmla="val 20780"/>
              </a:avLst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endParaRPr>
            </a:p>
          </p:txBody>
        </p:sp>
        <p:sp>
          <p:nvSpPr>
            <p:cNvPr id="271" name="テキスト ボックス 270"/>
            <p:cNvSpPr txBox="1"/>
            <p:nvPr/>
          </p:nvSpPr>
          <p:spPr>
            <a:xfrm>
              <a:off x="9079871" y="4472656"/>
              <a:ext cx="5848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EC</a:t>
              </a:r>
            </a:p>
          </p:txBody>
        </p:sp>
        <p:sp>
          <p:nvSpPr>
            <p:cNvPr id="272" name="テキスト ボックス 271"/>
            <p:cNvSpPr txBox="1"/>
            <p:nvPr/>
          </p:nvSpPr>
          <p:spPr>
            <a:xfrm>
              <a:off x="8072710" y="4049254"/>
              <a:ext cx="1175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itosis</a:t>
              </a:r>
            </a:p>
          </p:txBody>
        </p:sp>
        <p:sp>
          <p:nvSpPr>
            <p:cNvPr id="273" name="テキスト ボックス 272"/>
            <p:cNvSpPr txBox="1"/>
            <p:nvPr/>
          </p:nvSpPr>
          <p:spPr>
            <a:xfrm>
              <a:off x="7189520" y="6430917"/>
              <a:ext cx="2954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abnormal chromosomes are naturally eliminated</a:t>
              </a:r>
            </a:p>
          </p:txBody>
        </p:sp>
        <p:sp>
          <p:nvSpPr>
            <p:cNvPr id="276" name="テキスト ボックス 275"/>
            <p:cNvSpPr txBox="1"/>
            <p:nvPr/>
          </p:nvSpPr>
          <p:spPr>
            <a:xfrm>
              <a:off x="3120029" y="5950775"/>
              <a:ext cx="21427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hromosome Elimination Cassette (CEC)</a:t>
              </a:r>
            </a:p>
          </p:txBody>
        </p:sp>
        <p:sp>
          <p:nvSpPr>
            <p:cNvPr id="41" name="右中かっこ 40"/>
            <p:cNvSpPr/>
            <p:nvPr/>
          </p:nvSpPr>
          <p:spPr>
            <a:xfrm rot="5400000">
              <a:off x="4095991" y="4952114"/>
              <a:ext cx="193420" cy="1792775"/>
            </a:xfrm>
            <a:prstGeom prst="rightBrace">
              <a:avLst>
                <a:gd name="adj1" fmla="val 8333"/>
                <a:gd name="adj2" fmla="val 50282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8" name="テキスト ボックス 277"/>
            <p:cNvSpPr txBox="1"/>
            <p:nvPr/>
          </p:nvSpPr>
          <p:spPr>
            <a:xfrm>
              <a:off x="10375629" y="3179875"/>
              <a:ext cx="1985115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ytogenetic analysis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NGS,G-band,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SH,STR, and MLPA)</a:t>
              </a:r>
            </a:p>
          </p:txBody>
        </p:sp>
        <p:sp>
          <p:nvSpPr>
            <p:cNvPr id="279" name="テキスト ボックス 278"/>
            <p:cNvSpPr txBox="1"/>
            <p:nvPr/>
          </p:nvSpPr>
          <p:spPr>
            <a:xfrm>
              <a:off x="1120385" y="1712899"/>
              <a:ext cx="13469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reprograming</a:t>
              </a:r>
            </a:p>
          </p:txBody>
        </p:sp>
        <p:sp>
          <p:nvSpPr>
            <p:cNvPr id="280" name="楕円 279"/>
            <p:cNvSpPr/>
            <p:nvPr/>
          </p:nvSpPr>
          <p:spPr>
            <a:xfrm>
              <a:off x="1853879" y="2995041"/>
              <a:ext cx="306830" cy="302931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1" name="楕円 280"/>
            <p:cNvSpPr/>
            <p:nvPr/>
          </p:nvSpPr>
          <p:spPr>
            <a:xfrm>
              <a:off x="1497582" y="2995041"/>
              <a:ext cx="306830" cy="302931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2" name="楕円 281"/>
            <p:cNvSpPr/>
            <p:nvPr/>
          </p:nvSpPr>
          <p:spPr>
            <a:xfrm>
              <a:off x="784988" y="2995041"/>
              <a:ext cx="306830" cy="302931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3" name="円弧 282"/>
            <p:cNvSpPr/>
            <p:nvPr/>
          </p:nvSpPr>
          <p:spPr>
            <a:xfrm>
              <a:off x="1950602" y="3006769"/>
              <a:ext cx="211001" cy="264880"/>
            </a:xfrm>
            <a:prstGeom prst="arc">
              <a:avLst/>
            </a:prstGeom>
            <a:ln w="57150"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円弧 283"/>
            <p:cNvSpPr/>
            <p:nvPr/>
          </p:nvSpPr>
          <p:spPr>
            <a:xfrm>
              <a:off x="1592794" y="3004183"/>
              <a:ext cx="211001" cy="264880"/>
            </a:xfrm>
            <a:prstGeom prst="arc">
              <a:avLst/>
            </a:prstGeom>
            <a:ln w="57150">
              <a:solidFill>
                <a:srgbClr val="FFCC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円弧 284"/>
            <p:cNvSpPr/>
            <p:nvPr/>
          </p:nvSpPr>
          <p:spPr>
            <a:xfrm>
              <a:off x="1237037" y="3002469"/>
              <a:ext cx="211001" cy="264880"/>
            </a:xfrm>
            <a:prstGeom prst="arc">
              <a:avLst/>
            </a:prstGeom>
            <a:ln w="57150">
              <a:solidFill>
                <a:schemeClr val="accent3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円弧 285"/>
            <p:cNvSpPr/>
            <p:nvPr/>
          </p:nvSpPr>
          <p:spPr>
            <a:xfrm>
              <a:off x="876688" y="3002469"/>
              <a:ext cx="211001" cy="264880"/>
            </a:xfrm>
            <a:prstGeom prst="arc">
              <a:avLst/>
            </a:prstGeom>
            <a:ln w="57150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正方形/長方形 152"/>
          <p:cNvSpPr/>
          <p:nvPr/>
        </p:nvSpPr>
        <p:spPr>
          <a:xfrm>
            <a:off x="-55540" y="28472"/>
            <a:ext cx="26776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11163" indent="-342900">
              <a:spcBef>
                <a:spcPts val="1600"/>
              </a:spcBef>
              <a:buClr>
                <a:schemeClr val="tx2"/>
              </a:buClr>
              <a:buSzPct val="95000"/>
            </a:pPr>
            <a:r>
              <a:rPr lang="en-US" altLang="ja-JP" b="1" dirty="0">
                <a:latin typeface="Arial" panose="020B0604020202020204" pitchFamily="34" charset="0"/>
                <a:ea typeface="HGｺﾞｼｯｸM" pitchFamily="49" charset="-128"/>
                <a:cs typeface="Arial" panose="020B0604020202020204" pitchFamily="34" charset="0"/>
              </a:rPr>
              <a:t>Supplementary Fig.S1</a:t>
            </a:r>
            <a:endParaRPr lang="ja-JP" altLang="en-US" b="1" dirty="0">
              <a:latin typeface="Arial" panose="020B0604020202020204" pitchFamily="34" charset="0"/>
              <a:ea typeface="HGｺﾞｼｯｸM" pitchFamily="49" charset="-128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812D5077-BC9E-4414-AEB2-EFEDCDEB8ACF}"/>
              </a:ext>
            </a:extLst>
          </p:cNvPr>
          <p:cNvGrpSpPr/>
          <p:nvPr/>
        </p:nvGrpSpPr>
        <p:grpSpPr>
          <a:xfrm>
            <a:off x="450340" y="1835966"/>
            <a:ext cx="356914" cy="407549"/>
            <a:chOff x="1803795" y="906901"/>
            <a:chExt cx="356914" cy="407549"/>
          </a:xfrm>
        </p:grpSpPr>
        <p:sp>
          <p:nvSpPr>
            <p:cNvPr id="10" name="楕円 9">
              <a:extLst>
                <a:ext uri="{FF2B5EF4-FFF2-40B4-BE49-F238E27FC236}">
                  <a16:creationId xmlns:a16="http://schemas.microsoft.com/office/drawing/2014/main" id="{007BE75C-D115-419F-8F45-25A512A80C98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66A08A3C-3518-40B8-83E9-D041B0EF5767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154" name="角丸四角形 426">
                <a:extLst>
                  <a:ext uri="{FF2B5EF4-FFF2-40B4-BE49-F238E27FC236}">
                    <a16:creationId xmlns:a16="http://schemas.microsoft.com/office/drawing/2014/main" id="{132234A5-94A4-401A-AA9A-9C6A551F4892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55" name="角丸四角形 427">
                <a:extLst>
                  <a:ext uri="{FF2B5EF4-FFF2-40B4-BE49-F238E27FC236}">
                    <a16:creationId xmlns:a16="http://schemas.microsoft.com/office/drawing/2014/main" id="{C91E14B8-DBF2-4588-BBAB-18964A1DD8D3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56" name="角丸四角形 428">
                <a:extLst>
                  <a:ext uri="{FF2B5EF4-FFF2-40B4-BE49-F238E27FC236}">
                    <a16:creationId xmlns:a16="http://schemas.microsoft.com/office/drawing/2014/main" id="{4C7D8453-A841-435C-A34E-6D58408FBA08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57" name="角丸四角形 429">
                <a:extLst>
                  <a:ext uri="{FF2B5EF4-FFF2-40B4-BE49-F238E27FC236}">
                    <a16:creationId xmlns:a16="http://schemas.microsoft.com/office/drawing/2014/main" id="{056C0184-D062-4BEB-A98A-E3EC9D7BC3FC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58" name="角丸四角形 430">
                <a:extLst>
                  <a:ext uri="{FF2B5EF4-FFF2-40B4-BE49-F238E27FC236}">
                    <a16:creationId xmlns:a16="http://schemas.microsoft.com/office/drawing/2014/main" id="{C6A28FF3-A044-4158-94E6-7F6A7092C61F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67" name="角丸四角形 431">
                <a:extLst>
                  <a:ext uri="{FF2B5EF4-FFF2-40B4-BE49-F238E27FC236}">
                    <a16:creationId xmlns:a16="http://schemas.microsoft.com/office/drawing/2014/main" id="{D0A61AA1-1D32-4214-BA0D-42EB2BF3B2EB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68" name="角丸四角形 432">
                <a:extLst>
                  <a:ext uri="{FF2B5EF4-FFF2-40B4-BE49-F238E27FC236}">
                    <a16:creationId xmlns:a16="http://schemas.microsoft.com/office/drawing/2014/main" id="{87398B13-E5FD-41A4-B001-E75CFA743DE3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69" name="角丸四角形 433">
                <a:extLst>
                  <a:ext uri="{FF2B5EF4-FFF2-40B4-BE49-F238E27FC236}">
                    <a16:creationId xmlns:a16="http://schemas.microsoft.com/office/drawing/2014/main" id="{22B0E3B8-7312-40A0-BDC0-E5B4F20AB8C2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76" name="角丸四角形 434">
                <a:extLst>
                  <a:ext uri="{FF2B5EF4-FFF2-40B4-BE49-F238E27FC236}">
                    <a16:creationId xmlns:a16="http://schemas.microsoft.com/office/drawing/2014/main" id="{B987CC05-0095-48AF-8F4A-3AF53CE5A5CD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12" name="楕円 11">
            <a:extLst>
              <a:ext uri="{FF2B5EF4-FFF2-40B4-BE49-F238E27FC236}">
                <a16:creationId xmlns:a16="http://schemas.microsoft.com/office/drawing/2014/main" id="{2EA1B175-FCA9-46E0-A383-A94E8171DCF7}"/>
              </a:ext>
            </a:extLst>
          </p:cNvPr>
          <p:cNvSpPr/>
          <p:nvPr/>
        </p:nvSpPr>
        <p:spPr>
          <a:xfrm>
            <a:off x="2574220" y="1807326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A57AD0ED-CA60-4E5D-B94D-BC391B9CC8AF}"/>
              </a:ext>
            </a:extLst>
          </p:cNvPr>
          <p:cNvGrpSpPr/>
          <p:nvPr/>
        </p:nvGrpSpPr>
        <p:grpSpPr>
          <a:xfrm>
            <a:off x="2704915" y="2015708"/>
            <a:ext cx="356914" cy="407549"/>
            <a:chOff x="1803795" y="906901"/>
            <a:chExt cx="356914" cy="407549"/>
          </a:xfrm>
        </p:grpSpPr>
        <p:sp>
          <p:nvSpPr>
            <p:cNvPr id="181" name="楕円 180">
              <a:extLst>
                <a:ext uri="{FF2B5EF4-FFF2-40B4-BE49-F238E27FC236}">
                  <a16:creationId xmlns:a16="http://schemas.microsoft.com/office/drawing/2014/main" id="{A0CB0D6C-269D-49DC-80FD-12C75E880659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id="{F855AB09-3AD3-430A-9F17-B3776EAC0018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188" name="角丸四角形 426">
                <a:extLst>
                  <a:ext uri="{FF2B5EF4-FFF2-40B4-BE49-F238E27FC236}">
                    <a16:creationId xmlns:a16="http://schemas.microsoft.com/office/drawing/2014/main" id="{C0EE7525-0FFA-4D1A-BD95-D33E297F33AA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89" name="角丸四角形 427">
                <a:extLst>
                  <a:ext uri="{FF2B5EF4-FFF2-40B4-BE49-F238E27FC236}">
                    <a16:creationId xmlns:a16="http://schemas.microsoft.com/office/drawing/2014/main" id="{F2ECF385-81B2-4E20-8B4A-B9EAB01A1450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0" name="角丸四角形 428">
                <a:extLst>
                  <a:ext uri="{FF2B5EF4-FFF2-40B4-BE49-F238E27FC236}">
                    <a16:creationId xmlns:a16="http://schemas.microsoft.com/office/drawing/2014/main" id="{CC16B0DF-E558-465C-A2C9-7518445A2716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1" name="角丸四角形 429">
                <a:extLst>
                  <a:ext uri="{FF2B5EF4-FFF2-40B4-BE49-F238E27FC236}">
                    <a16:creationId xmlns:a16="http://schemas.microsoft.com/office/drawing/2014/main" id="{FBF95113-BBDB-46B8-94FD-09F3AC1B0BC2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2" name="角丸四角形 430">
                <a:extLst>
                  <a:ext uri="{FF2B5EF4-FFF2-40B4-BE49-F238E27FC236}">
                    <a16:creationId xmlns:a16="http://schemas.microsoft.com/office/drawing/2014/main" id="{549A1015-31CF-4C7B-B6B2-930BF38D72B7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3" name="角丸四角形 431">
                <a:extLst>
                  <a:ext uri="{FF2B5EF4-FFF2-40B4-BE49-F238E27FC236}">
                    <a16:creationId xmlns:a16="http://schemas.microsoft.com/office/drawing/2014/main" id="{55F93523-9618-40DF-8232-D866AF8D0BA0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4" name="角丸四角形 432">
                <a:extLst>
                  <a:ext uri="{FF2B5EF4-FFF2-40B4-BE49-F238E27FC236}">
                    <a16:creationId xmlns:a16="http://schemas.microsoft.com/office/drawing/2014/main" id="{A754655D-7404-4DF3-ADC2-EFAF8C2E7D5D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7" name="角丸四角形 433">
                <a:extLst>
                  <a:ext uri="{FF2B5EF4-FFF2-40B4-BE49-F238E27FC236}">
                    <a16:creationId xmlns:a16="http://schemas.microsoft.com/office/drawing/2014/main" id="{F4237971-A66B-488E-AA0E-CA9C653BB75C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198" name="角丸四角形 434">
                <a:extLst>
                  <a:ext uri="{FF2B5EF4-FFF2-40B4-BE49-F238E27FC236}">
                    <a16:creationId xmlns:a16="http://schemas.microsoft.com/office/drawing/2014/main" id="{3A7A234C-0BB4-486B-9EFE-780E46BBDB04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D1E97E85-1ADB-4004-B12B-31504CF1FC2E}"/>
              </a:ext>
            </a:extLst>
          </p:cNvPr>
          <p:cNvGrpSpPr/>
          <p:nvPr/>
        </p:nvGrpSpPr>
        <p:grpSpPr>
          <a:xfrm>
            <a:off x="5127250" y="1331480"/>
            <a:ext cx="614309" cy="672851"/>
            <a:chOff x="5416463" y="626935"/>
            <a:chExt cx="614309" cy="672851"/>
          </a:xfrm>
        </p:grpSpPr>
        <p:sp>
          <p:nvSpPr>
            <p:cNvPr id="199" name="楕円 198">
              <a:extLst>
                <a:ext uri="{FF2B5EF4-FFF2-40B4-BE49-F238E27FC236}">
                  <a16:creationId xmlns:a16="http://schemas.microsoft.com/office/drawing/2014/main" id="{579F18AC-8D36-4658-8D0E-4AC9190830F2}"/>
                </a:ext>
              </a:extLst>
            </p:cNvPr>
            <p:cNvSpPr/>
            <p:nvPr/>
          </p:nvSpPr>
          <p:spPr>
            <a:xfrm>
              <a:off x="5416463" y="626935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rgbClr val="FFCCFF"/>
                </a:gs>
                <a:gs pos="35000">
                  <a:srgbClr val="FFFFFF"/>
                </a:gs>
                <a:gs pos="100000">
                  <a:srgbClr val="FFCC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0D4B3D28-15E4-4026-A389-F0D14843093F}"/>
                </a:ext>
              </a:extLst>
            </p:cNvPr>
            <p:cNvGrpSpPr/>
            <p:nvPr/>
          </p:nvGrpSpPr>
          <p:grpSpPr>
            <a:xfrm>
              <a:off x="5547158" y="835317"/>
              <a:ext cx="356914" cy="407549"/>
              <a:chOff x="1803795" y="906901"/>
              <a:chExt cx="356914" cy="407549"/>
            </a:xfrm>
          </p:grpSpPr>
          <p:sp>
            <p:nvSpPr>
              <p:cNvPr id="203" name="楕円 202">
                <a:extLst>
                  <a:ext uri="{FF2B5EF4-FFF2-40B4-BE49-F238E27FC236}">
                    <a16:creationId xmlns:a16="http://schemas.microsoft.com/office/drawing/2014/main" id="{5F5A2173-627B-481F-9BE9-4811051D7EC8}"/>
                  </a:ext>
                </a:extLst>
              </p:cNvPr>
              <p:cNvSpPr/>
              <p:nvPr/>
            </p:nvSpPr>
            <p:spPr>
              <a:xfrm>
                <a:off x="1803795" y="906901"/>
                <a:ext cx="356914" cy="407549"/>
              </a:xfrm>
              <a:prstGeom prst="ellipse">
                <a:avLst/>
              </a:prstGeom>
              <a:gradFill flip="none" rotWithShape="1">
                <a:gsLst>
                  <a:gs pos="14000">
                    <a:srgbClr val="CC00CC"/>
                  </a:gs>
                  <a:gs pos="0">
                    <a:srgbClr val="FFCCFF">
                      <a:lumMod val="0"/>
                      <a:lumOff val="100000"/>
                    </a:srgbClr>
                  </a:gs>
                  <a:gs pos="60000">
                    <a:srgbClr val="FFCCFF">
                      <a:shade val="100000"/>
                      <a:satMod val="115000"/>
                      <a:lumMod val="67000"/>
                      <a:lumOff val="33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08" name="グループ化 207">
                <a:extLst>
                  <a:ext uri="{FF2B5EF4-FFF2-40B4-BE49-F238E27FC236}">
                    <a16:creationId xmlns:a16="http://schemas.microsoft.com/office/drawing/2014/main" id="{E0B84722-1914-4588-9B31-E1D7D32EF16D}"/>
                  </a:ext>
                </a:extLst>
              </p:cNvPr>
              <p:cNvGrpSpPr/>
              <p:nvPr/>
            </p:nvGrpSpPr>
            <p:grpSpPr>
              <a:xfrm rot="5400000">
                <a:off x="1846818" y="1005191"/>
                <a:ext cx="259969" cy="239599"/>
                <a:chOff x="1074320" y="761314"/>
                <a:chExt cx="1140560" cy="388368"/>
              </a:xfrm>
            </p:grpSpPr>
            <p:sp>
              <p:nvSpPr>
                <p:cNvPr id="212" name="角丸四角形 426">
                  <a:extLst>
                    <a:ext uri="{FF2B5EF4-FFF2-40B4-BE49-F238E27FC236}">
                      <a16:creationId xmlns:a16="http://schemas.microsoft.com/office/drawing/2014/main" id="{6DE6BC0C-E529-41F1-BA68-2A339031BCB2}"/>
                    </a:ext>
                  </a:extLst>
                </p:cNvPr>
                <p:cNvSpPr/>
                <p:nvPr/>
              </p:nvSpPr>
              <p:spPr>
                <a:xfrm>
                  <a:off x="1074320" y="761314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13" name="角丸四角形 427">
                  <a:extLst>
                    <a:ext uri="{FF2B5EF4-FFF2-40B4-BE49-F238E27FC236}">
                      <a16:creationId xmlns:a16="http://schemas.microsoft.com/office/drawing/2014/main" id="{7CBAC070-A826-4640-8A31-95DB5B57114D}"/>
                    </a:ext>
                  </a:extLst>
                </p:cNvPr>
                <p:cNvSpPr/>
                <p:nvPr/>
              </p:nvSpPr>
              <p:spPr>
                <a:xfrm>
                  <a:off x="1350500" y="761314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18" name="角丸四角形 428">
                  <a:extLst>
                    <a:ext uri="{FF2B5EF4-FFF2-40B4-BE49-F238E27FC236}">
                      <a16:creationId xmlns:a16="http://schemas.microsoft.com/office/drawing/2014/main" id="{37D1B133-B72C-4C9C-B7C1-A814EA2AFECE}"/>
                    </a:ext>
                  </a:extLst>
                </p:cNvPr>
                <p:cNvSpPr/>
                <p:nvPr/>
              </p:nvSpPr>
              <p:spPr>
                <a:xfrm>
                  <a:off x="1496808" y="761314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19" name="角丸四角形 429">
                  <a:extLst>
                    <a:ext uri="{FF2B5EF4-FFF2-40B4-BE49-F238E27FC236}">
                      <a16:creationId xmlns:a16="http://schemas.microsoft.com/office/drawing/2014/main" id="{8182AAED-A2D9-4358-B8A6-3F5E2CEE80D7}"/>
                    </a:ext>
                  </a:extLst>
                </p:cNvPr>
                <p:cNvSpPr/>
                <p:nvPr/>
              </p:nvSpPr>
              <p:spPr>
                <a:xfrm>
                  <a:off x="1074320" y="899976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20" name="角丸四角形 430">
                  <a:extLst>
                    <a:ext uri="{FF2B5EF4-FFF2-40B4-BE49-F238E27FC236}">
                      <a16:creationId xmlns:a16="http://schemas.microsoft.com/office/drawing/2014/main" id="{0FBCD287-2629-4EE2-BF6A-4C4B05EC7187}"/>
                    </a:ext>
                  </a:extLst>
                </p:cNvPr>
                <p:cNvSpPr/>
                <p:nvPr/>
              </p:nvSpPr>
              <p:spPr>
                <a:xfrm>
                  <a:off x="1350500" y="899976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24" name="角丸四角形 431">
                  <a:extLst>
                    <a:ext uri="{FF2B5EF4-FFF2-40B4-BE49-F238E27FC236}">
                      <a16:creationId xmlns:a16="http://schemas.microsoft.com/office/drawing/2014/main" id="{AAD82751-5F65-40E1-925B-75EC101414FE}"/>
                    </a:ext>
                  </a:extLst>
                </p:cNvPr>
                <p:cNvSpPr/>
                <p:nvPr/>
              </p:nvSpPr>
              <p:spPr>
                <a:xfrm>
                  <a:off x="1496808" y="899976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26" name="角丸四角形 432">
                  <a:extLst>
                    <a:ext uri="{FF2B5EF4-FFF2-40B4-BE49-F238E27FC236}">
                      <a16:creationId xmlns:a16="http://schemas.microsoft.com/office/drawing/2014/main" id="{E525BA38-5C5C-45E3-BF8C-F78BE4CC1F92}"/>
                    </a:ext>
                  </a:extLst>
                </p:cNvPr>
                <p:cNvSpPr/>
                <p:nvPr/>
              </p:nvSpPr>
              <p:spPr>
                <a:xfrm>
                  <a:off x="1074320" y="1038639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27" name="角丸四角形 433">
                  <a:extLst>
                    <a:ext uri="{FF2B5EF4-FFF2-40B4-BE49-F238E27FC236}">
                      <a16:creationId xmlns:a16="http://schemas.microsoft.com/office/drawing/2014/main" id="{7E501503-27DD-4432-8687-F047FF15EDB8}"/>
                    </a:ext>
                  </a:extLst>
                </p:cNvPr>
                <p:cNvSpPr/>
                <p:nvPr/>
              </p:nvSpPr>
              <p:spPr>
                <a:xfrm>
                  <a:off x="1350500" y="1038639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28" name="角丸四角形 434">
                  <a:extLst>
                    <a:ext uri="{FF2B5EF4-FFF2-40B4-BE49-F238E27FC236}">
                      <a16:creationId xmlns:a16="http://schemas.microsoft.com/office/drawing/2014/main" id="{A06418F5-84CE-4B37-95FC-F23BDE2FF03F}"/>
                    </a:ext>
                  </a:extLst>
                </p:cNvPr>
                <p:cNvSpPr/>
                <p:nvPr/>
              </p:nvSpPr>
              <p:spPr>
                <a:xfrm>
                  <a:off x="1496808" y="1038639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</p:grpSp>
        </p:grp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95B76B76-48CA-454C-94FA-39DA84CE075A}"/>
              </a:ext>
            </a:extLst>
          </p:cNvPr>
          <p:cNvGrpSpPr/>
          <p:nvPr/>
        </p:nvGrpSpPr>
        <p:grpSpPr>
          <a:xfrm>
            <a:off x="4570445" y="2629527"/>
            <a:ext cx="614309" cy="672851"/>
            <a:chOff x="5182996" y="2621569"/>
            <a:chExt cx="614309" cy="672851"/>
          </a:xfrm>
        </p:grpSpPr>
        <p:sp>
          <p:nvSpPr>
            <p:cNvPr id="230" name="楕円 229">
              <a:extLst>
                <a:ext uri="{FF2B5EF4-FFF2-40B4-BE49-F238E27FC236}">
                  <a16:creationId xmlns:a16="http://schemas.microsoft.com/office/drawing/2014/main" id="{0FDB3C53-F6D5-46D7-905D-8087D68FDD25}"/>
                </a:ext>
              </a:extLst>
            </p:cNvPr>
            <p:cNvSpPr/>
            <p:nvPr/>
          </p:nvSpPr>
          <p:spPr>
            <a:xfrm>
              <a:off x="5182996" y="2621569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rgbClr val="FFCCFF"/>
                </a:gs>
                <a:gs pos="35000">
                  <a:srgbClr val="FFFFFF"/>
                </a:gs>
                <a:gs pos="100000">
                  <a:srgbClr val="FFCC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32" name="グループ化 231">
              <a:extLst>
                <a:ext uri="{FF2B5EF4-FFF2-40B4-BE49-F238E27FC236}">
                  <a16:creationId xmlns:a16="http://schemas.microsoft.com/office/drawing/2014/main" id="{8F78AC21-597C-4508-9EF9-5C630499B154}"/>
                </a:ext>
              </a:extLst>
            </p:cNvPr>
            <p:cNvGrpSpPr/>
            <p:nvPr/>
          </p:nvGrpSpPr>
          <p:grpSpPr>
            <a:xfrm>
              <a:off x="5313691" y="2829951"/>
              <a:ext cx="356914" cy="407549"/>
              <a:chOff x="1803795" y="906901"/>
              <a:chExt cx="356914" cy="407549"/>
            </a:xfrm>
          </p:grpSpPr>
          <p:sp>
            <p:nvSpPr>
              <p:cNvPr id="233" name="楕円 232">
                <a:extLst>
                  <a:ext uri="{FF2B5EF4-FFF2-40B4-BE49-F238E27FC236}">
                    <a16:creationId xmlns:a16="http://schemas.microsoft.com/office/drawing/2014/main" id="{10F24348-5330-4D05-9901-4784986DD799}"/>
                  </a:ext>
                </a:extLst>
              </p:cNvPr>
              <p:cNvSpPr/>
              <p:nvPr/>
            </p:nvSpPr>
            <p:spPr>
              <a:xfrm>
                <a:off x="1803795" y="906901"/>
                <a:ext cx="356914" cy="407549"/>
              </a:xfrm>
              <a:prstGeom prst="ellipse">
                <a:avLst/>
              </a:prstGeom>
              <a:gradFill flip="none" rotWithShape="1">
                <a:gsLst>
                  <a:gs pos="14000">
                    <a:srgbClr val="CC00CC"/>
                  </a:gs>
                  <a:gs pos="0">
                    <a:srgbClr val="FFCCFF">
                      <a:lumMod val="0"/>
                      <a:lumOff val="100000"/>
                    </a:srgbClr>
                  </a:gs>
                  <a:gs pos="60000">
                    <a:srgbClr val="FFCCFF">
                      <a:shade val="100000"/>
                      <a:satMod val="115000"/>
                      <a:lumMod val="67000"/>
                      <a:lumOff val="33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34" name="グループ化 233">
                <a:extLst>
                  <a:ext uri="{FF2B5EF4-FFF2-40B4-BE49-F238E27FC236}">
                    <a16:creationId xmlns:a16="http://schemas.microsoft.com/office/drawing/2014/main" id="{63C285AA-0E6B-46EB-ACA3-0B30D67BED5F}"/>
                  </a:ext>
                </a:extLst>
              </p:cNvPr>
              <p:cNvGrpSpPr/>
              <p:nvPr/>
            </p:nvGrpSpPr>
            <p:grpSpPr>
              <a:xfrm rot="5400000">
                <a:off x="1846818" y="1005191"/>
                <a:ext cx="259969" cy="239599"/>
                <a:chOff x="1074320" y="761314"/>
                <a:chExt cx="1140560" cy="388368"/>
              </a:xfrm>
            </p:grpSpPr>
            <p:sp>
              <p:nvSpPr>
                <p:cNvPr id="235" name="角丸四角形 426">
                  <a:extLst>
                    <a:ext uri="{FF2B5EF4-FFF2-40B4-BE49-F238E27FC236}">
                      <a16:creationId xmlns:a16="http://schemas.microsoft.com/office/drawing/2014/main" id="{1549AD56-0683-4AE5-91AF-FB820BF14EBC}"/>
                    </a:ext>
                  </a:extLst>
                </p:cNvPr>
                <p:cNvSpPr/>
                <p:nvPr/>
              </p:nvSpPr>
              <p:spPr>
                <a:xfrm>
                  <a:off x="1074320" y="761314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36" name="角丸四角形 427">
                  <a:extLst>
                    <a:ext uri="{FF2B5EF4-FFF2-40B4-BE49-F238E27FC236}">
                      <a16:creationId xmlns:a16="http://schemas.microsoft.com/office/drawing/2014/main" id="{4ED51FAD-BF89-4560-86BC-AF2B372FA668}"/>
                    </a:ext>
                  </a:extLst>
                </p:cNvPr>
                <p:cNvSpPr/>
                <p:nvPr/>
              </p:nvSpPr>
              <p:spPr>
                <a:xfrm>
                  <a:off x="1350500" y="761314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37" name="角丸四角形 428">
                  <a:extLst>
                    <a:ext uri="{FF2B5EF4-FFF2-40B4-BE49-F238E27FC236}">
                      <a16:creationId xmlns:a16="http://schemas.microsoft.com/office/drawing/2014/main" id="{FB186D15-D950-4725-ADFC-117CBBD6B7BC}"/>
                    </a:ext>
                  </a:extLst>
                </p:cNvPr>
                <p:cNvSpPr/>
                <p:nvPr/>
              </p:nvSpPr>
              <p:spPr>
                <a:xfrm>
                  <a:off x="1496808" y="761314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66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38" name="角丸四角形 429">
                  <a:extLst>
                    <a:ext uri="{FF2B5EF4-FFF2-40B4-BE49-F238E27FC236}">
                      <a16:creationId xmlns:a16="http://schemas.microsoft.com/office/drawing/2014/main" id="{3CACF7E7-31D0-4220-9E88-3E40D641ACD8}"/>
                    </a:ext>
                  </a:extLst>
                </p:cNvPr>
                <p:cNvSpPr/>
                <p:nvPr/>
              </p:nvSpPr>
              <p:spPr>
                <a:xfrm>
                  <a:off x="1074320" y="899976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39" name="角丸四角形 430">
                  <a:extLst>
                    <a:ext uri="{FF2B5EF4-FFF2-40B4-BE49-F238E27FC236}">
                      <a16:creationId xmlns:a16="http://schemas.microsoft.com/office/drawing/2014/main" id="{349199D0-8516-443E-8EB0-7DFE2743186C}"/>
                    </a:ext>
                  </a:extLst>
                </p:cNvPr>
                <p:cNvSpPr/>
                <p:nvPr/>
              </p:nvSpPr>
              <p:spPr>
                <a:xfrm>
                  <a:off x="1350500" y="899976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41" name="角丸四角形 431">
                  <a:extLst>
                    <a:ext uri="{FF2B5EF4-FFF2-40B4-BE49-F238E27FC236}">
                      <a16:creationId xmlns:a16="http://schemas.microsoft.com/office/drawing/2014/main" id="{7A6609C4-852E-403E-A6F0-AB79176C90F7}"/>
                    </a:ext>
                  </a:extLst>
                </p:cNvPr>
                <p:cNvSpPr/>
                <p:nvPr/>
              </p:nvSpPr>
              <p:spPr>
                <a:xfrm>
                  <a:off x="1496808" y="899976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FF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42" name="角丸四角形 432">
                  <a:extLst>
                    <a:ext uri="{FF2B5EF4-FFF2-40B4-BE49-F238E27FC236}">
                      <a16:creationId xmlns:a16="http://schemas.microsoft.com/office/drawing/2014/main" id="{498D033E-675C-4923-A394-CCAC6006A3A6}"/>
                    </a:ext>
                  </a:extLst>
                </p:cNvPr>
                <p:cNvSpPr/>
                <p:nvPr/>
              </p:nvSpPr>
              <p:spPr>
                <a:xfrm>
                  <a:off x="1074320" y="1038639"/>
                  <a:ext cx="269763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43" name="角丸四角形 433">
                  <a:extLst>
                    <a:ext uri="{FF2B5EF4-FFF2-40B4-BE49-F238E27FC236}">
                      <a16:creationId xmlns:a16="http://schemas.microsoft.com/office/drawing/2014/main" id="{7548CB3D-6884-46D3-9244-9130792A83B3}"/>
                    </a:ext>
                  </a:extLst>
                </p:cNvPr>
                <p:cNvSpPr/>
                <p:nvPr/>
              </p:nvSpPr>
              <p:spPr>
                <a:xfrm>
                  <a:off x="1350500" y="1038639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244" name="角丸四角形 434">
                  <a:extLst>
                    <a:ext uri="{FF2B5EF4-FFF2-40B4-BE49-F238E27FC236}">
                      <a16:creationId xmlns:a16="http://schemas.microsoft.com/office/drawing/2014/main" id="{6C45454E-F445-484A-844D-2B4C20D10869}"/>
                    </a:ext>
                  </a:extLst>
                </p:cNvPr>
                <p:cNvSpPr/>
                <p:nvPr/>
              </p:nvSpPr>
              <p:spPr>
                <a:xfrm>
                  <a:off x="1496808" y="1038639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rgbClr val="FF9933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</p:grpSp>
        </p:grpSp>
      </p:grpSp>
      <p:sp>
        <p:nvSpPr>
          <p:cNvPr id="248" name="楕円 247">
            <a:extLst>
              <a:ext uri="{FF2B5EF4-FFF2-40B4-BE49-F238E27FC236}">
                <a16:creationId xmlns:a16="http://schemas.microsoft.com/office/drawing/2014/main" id="{6C9CE615-9577-43D0-8BC4-6D451156DFFE}"/>
              </a:ext>
            </a:extLst>
          </p:cNvPr>
          <p:cNvSpPr/>
          <p:nvPr/>
        </p:nvSpPr>
        <p:spPr>
          <a:xfrm>
            <a:off x="4456636" y="1376973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49" name="グループ化 248">
            <a:extLst>
              <a:ext uri="{FF2B5EF4-FFF2-40B4-BE49-F238E27FC236}">
                <a16:creationId xmlns:a16="http://schemas.microsoft.com/office/drawing/2014/main" id="{B0A650B8-B5AC-4F96-8F00-1BE032BAE4D5}"/>
              </a:ext>
            </a:extLst>
          </p:cNvPr>
          <p:cNvGrpSpPr/>
          <p:nvPr/>
        </p:nvGrpSpPr>
        <p:grpSpPr>
          <a:xfrm>
            <a:off x="4587331" y="1585355"/>
            <a:ext cx="356914" cy="407549"/>
            <a:chOff x="1803795" y="906901"/>
            <a:chExt cx="356914" cy="407549"/>
          </a:xfrm>
        </p:grpSpPr>
        <p:sp>
          <p:nvSpPr>
            <p:cNvPr id="250" name="楕円 249">
              <a:extLst>
                <a:ext uri="{FF2B5EF4-FFF2-40B4-BE49-F238E27FC236}">
                  <a16:creationId xmlns:a16="http://schemas.microsoft.com/office/drawing/2014/main" id="{E941084B-48AC-45EF-B957-125C3301437B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51" name="グループ化 250">
              <a:extLst>
                <a:ext uri="{FF2B5EF4-FFF2-40B4-BE49-F238E27FC236}">
                  <a16:creationId xmlns:a16="http://schemas.microsoft.com/office/drawing/2014/main" id="{90541997-6409-4AA6-AFC1-5C5CECE45865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252" name="角丸四角形 426">
                <a:extLst>
                  <a:ext uri="{FF2B5EF4-FFF2-40B4-BE49-F238E27FC236}">
                    <a16:creationId xmlns:a16="http://schemas.microsoft.com/office/drawing/2014/main" id="{46F640DB-9DFC-4C66-91CA-1068C85FA04B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53" name="角丸四角形 427">
                <a:extLst>
                  <a:ext uri="{FF2B5EF4-FFF2-40B4-BE49-F238E27FC236}">
                    <a16:creationId xmlns:a16="http://schemas.microsoft.com/office/drawing/2014/main" id="{4EC60BA2-B7F9-40DF-9ECE-053FEA5C8BCB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54" name="角丸四角形 428">
                <a:extLst>
                  <a:ext uri="{FF2B5EF4-FFF2-40B4-BE49-F238E27FC236}">
                    <a16:creationId xmlns:a16="http://schemas.microsoft.com/office/drawing/2014/main" id="{DC4BD1D1-F695-497F-A084-654BA1A8FBAA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55" name="角丸四角形 429">
                <a:extLst>
                  <a:ext uri="{FF2B5EF4-FFF2-40B4-BE49-F238E27FC236}">
                    <a16:creationId xmlns:a16="http://schemas.microsoft.com/office/drawing/2014/main" id="{D84B586D-6A5A-41D0-9493-EE77B492F457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70" name="角丸四角形 430">
                <a:extLst>
                  <a:ext uri="{FF2B5EF4-FFF2-40B4-BE49-F238E27FC236}">
                    <a16:creationId xmlns:a16="http://schemas.microsoft.com/office/drawing/2014/main" id="{A6A13EF1-AC58-499A-9880-ED2E6DC9EE12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74" name="角丸四角形 431">
                <a:extLst>
                  <a:ext uri="{FF2B5EF4-FFF2-40B4-BE49-F238E27FC236}">
                    <a16:creationId xmlns:a16="http://schemas.microsoft.com/office/drawing/2014/main" id="{7D6A165F-22C9-43CC-8DA6-8E00F2FF8522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75" name="角丸四角形 432">
                <a:extLst>
                  <a:ext uri="{FF2B5EF4-FFF2-40B4-BE49-F238E27FC236}">
                    <a16:creationId xmlns:a16="http://schemas.microsoft.com/office/drawing/2014/main" id="{2B461C19-774B-46F5-8FA0-9672FAADA53F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77" name="角丸四角形 433">
                <a:extLst>
                  <a:ext uri="{FF2B5EF4-FFF2-40B4-BE49-F238E27FC236}">
                    <a16:creationId xmlns:a16="http://schemas.microsoft.com/office/drawing/2014/main" id="{9A50858C-1A16-43D4-9173-05DAE1F9C17B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87" name="角丸四角形 434">
                <a:extLst>
                  <a:ext uri="{FF2B5EF4-FFF2-40B4-BE49-F238E27FC236}">
                    <a16:creationId xmlns:a16="http://schemas.microsoft.com/office/drawing/2014/main" id="{51D749AD-1690-4BF7-987E-C8AC39C04593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FAB59F43-CD68-4CDB-A396-848B11CE6727}"/>
              </a:ext>
            </a:extLst>
          </p:cNvPr>
          <p:cNvGrpSpPr/>
          <p:nvPr/>
        </p:nvGrpSpPr>
        <p:grpSpPr>
          <a:xfrm>
            <a:off x="4806893" y="1789558"/>
            <a:ext cx="76082" cy="138336"/>
            <a:chOff x="3627704" y="1153750"/>
            <a:chExt cx="102068" cy="117678"/>
          </a:xfrm>
        </p:grpSpPr>
        <p:sp>
          <p:nvSpPr>
            <p:cNvPr id="16" name="四角形: 角を丸くする 15">
              <a:extLst>
                <a:ext uri="{FF2B5EF4-FFF2-40B4-BE49-F238E27FC236}">
                  <a16:creationId xmlns:a16="http://schemas.microsoft.com/office/drawing/2014/main" id="{4723AD39-722E-470B-826B-575948D815A7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8" name="四角形: 角を丸くする 287">
              <a:extLst>
                <a:ext uri="{FF2B5EF4-FFF2-40B4-BE49-F238E27FC236}">
                  <a16:creationId xmlns:a16="http://schemas.microsoft.com/office/drawing/2014/main" id="{676F32AB-B680-421D-872C-C81177D6927C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90" name="楕円 289">
            <a:extLst>
              <a:ext uri="{FF2B5EF4-FFF2-40B4-BE49-F238E27FC236}">
                <a16:creationId xmlns:a16="http://schemas.microsoft.com/office/drawing/2014/main" id="{08BDE1B9-90B6-4E58-83DD-6B79639788A7}"/>
              </a:ext>
            </a:extLst>
          </p:cNvPr>
          <p:cNvSpPr/>
          <p:nvPr/>
        </p:nvSpPr>
        <p:spPr>
          <a:xfrm>
            <a:off x="5009763" y="2024256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91" name="グループ化 290">
            <a:extLst>
              <a:ext uri="{FF2B5EF4-FFF2-40B4-BE49-F238E27FC236}">
                <a16:creationId xmlns:a16="http://schemas.microsoft.com/office/drawing/2014/main" id="{F38F3F37-CD1D-4BF2-B222-207515C4A04A}"/>
              </a:ext>
            </a:extLst>
          </p:cNvPr>
          <p:cNvGrpSpPr/>
          <p:nvPr/>
        </p:nvGrpSpPr>
        <p:grpSpPr>
          <a:xfrm>
            <a:off x="5140458" y="2232638"/>
            <a:ext cx="356914" cy="407549"/>
            <a:chOff x="1803795" y="906901"/>
            <a:chExt cx="356914" cy="407549"/>
          </a:xfrm>
        </p:grpSpPr>
        <p:sp>
          <p:nvSpPr>
            <p:cNvPr id="292" name="楕円 291">
              <a:extLst>
                <a:ext uri="{FF2B5EF4-FFF2-40B4-BE49-F238E27FC236}">
                  <a16:creationId xmlns:a16="http://schemas.microsoft.com/office/drawing/2014/main" id="{0A9BF7FD-7AD0-417D-9248-4A3E1D665FD9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93" name="グループ化 292">
              <a:extLst>
                <a:ext uri="{FF2B5EF4-FFF2-40B4-BE49-F238E27FC236}">
                  <a16:creationId xmlns:a16="http://schemas.microsoft.com/office/drawing/2014/main" id="{51E1BB59-CA48-42D3-9BF1-A0C880724768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294" name="角丸四角形 426">
                <a:extLst>
                  <a:ext uri="{FF2B5EF4-FFF2-40B4-BE49-F238E27FC236}">
                    <a16:creationId xmlns:a16="http://schemas.microsoft.com/office/drawing/2014/main" id="{B01A6B94-9F3A-4463-87E2-25B4D7B35AA6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95" name="角丸四角形 427">
                <a:extLst>
                  <a:ext uri="{FF2B5EF4-FFF2-40B4-BE49-F238E27FC236}">
                    <a16:creationId xmlns:a16="http://schemas.microsoft.com/office/drawing/2014/main" id="{43F21B9F-8917-4724-AA9D-C52D8B4D2C4C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96" name="角丸四角形 428">
                <a:extLst>
                  <a:ext uri="{FF2B5EF4-FFF2-40B4-BE49-F238E27FC236}">
                    <a16:creationId xmlns:a16="http://schemas.microsoft.com/office/drawing/2014/main" id="{F9B97E5D-AEB1-46AB-9702-A3D7E50CFD68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97" name="角丸四角形 429">
                <a:extLst>
                  <a:ext uri="{FF2B5EF4-FFF2-40B4-BE49-F238E27FC236}">
                    <a16:creationId xmlns:a16="http://schemas.microsoft.com/office/drawing/2014/main" id="{E038EE0E-92CA-422D-99B3-B7688CCB3EEC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98" name="角丸四角形 430">
                <a:extLst>
                  <a:ext uri="{FF2B5EF4-FFF2-40B4-BE49-F238E27FC236}">
                    <a16:creationId xmlns:a16="http://schemas.microsoft.com/office/drawing/2014/main" id="{8175902A-7877-4068-8A66-1010363A235A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299" name="角丸四角形 431">
                <a:extLst>
                  <a:ext uri="{FF2B5EF4-FFF2-40B4-BE49-F238E27FC236}">
                    <a16:creationId xmlns:a16="http://schemas.microsoft.com/office/drawing/2014/main" id="{A6956EE3-32D6-4E88-AAA8-3702BC24E892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00" name="角丸四角形 432">
                <a:extLst>
                  <a:ext uri="{FF2B5EF4-FFF2-40B4-BE49-F238E27FC236}">
                    <a16:creationId xmlns:a16="http://schemas.microsoft.com/office/drawing/2014/main" id="{F3DDDB02-B1B7-4ED3-8EB1-EB2F0E971405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01" name="角丸四角形 433">
                <a:extLst>
                  <a:ext uri="{FF2B5EF4-FFF2-40B4-BE49-F238E27FC236}">
                    <a16:creationId xmlns:a16="http://schemas.microsoft.com/office/drawing/2014/main" id="{12A7BC78-1410-4202-9CA2-47E84606DD7E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02" name="角丸四角形 434">
                <a:extLst>
                  <a:ext uri="{FF2B5EF4-FFF2-40B4-BE49-F238E27FC236}">
                    <a16:creationId xmlns:a16="http://schemas.microsoft.com/office/drawing/2014/main" id="{03AD2A7B-06B2-4263-9436-CCE5F7BBB3DB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303" name="グループ化 302">
            <a:extLst>
              <a:ext uri="{FF2B5EF4-FFF2-40B4-BE49-F238E27FC236}">
                <a16:creationId xmlns:a16="http://schemas.microsoft.com/office/drawing/2014/main" id="{61EC0998-FD65-4CAF-8451-9F1C138495CB}"/>
              </a:ext>
            </a:extLst>
          </p:cNvPr>
          <p:cNvGrpSpPr/>
          <p:nvPr/>
        </p:nvGrpSpPr>
        <p:grpSpPr>
          <a:xfrm>
            <a:off x="5283803" y="2437597"/>
            <a:ext cx="76082" cy="138336"/>
            <a:chOff x="3627704" y="1153750"/>
            <a:chExt cx="102068" cy="117678"/>
          </a:xfrm>
        </p:grpSpPr>
        <p:sp>
          <p:nvSpPr>
            <p:cNvPr id="304" name="四角形: 角を丸くする 303">
              <a:extLst>
                <a:ext uri="{FF2B5EF4-FFF2-40B4-BE49-F238E27FC236}">
                  <a16:creationId xmlns:a16="http://schemas.microsoft.com/office/drawing/2014/main" id="{BF5CA0EC-0CD2-4940-83CA-3622008D585C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5" name="四角形: 角を丸くする 304">
              <a:extLst>
                <a:ext uri="{FF2B5EF4-FFF2-40B4-BE49-F238E27FC236}">
                  <a16:creationId xmlns:a16="http://schemas.microsoft.com/office/drawing/2014/main" id="{2B7A4188-CFDB-4177-9367-BB1305BF11EE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22" name="楕円 321">
            <a:extLst>
              <a:ext uri="{FF2B5EF4-FFF2-40B4-BE49-F238E27FC236}">
                <a16:creationId xmlns:a16="http://schemas.microsoft.com/office/drawing/2014/main" id="{3B1F110F-1529-4F34-89AB-2561E8EAB320}"/>
              </a:ext>
            </a:extLst>
          </p:cNvPr>
          <p:cNvSpPr/>
          <p:nvPr/>
        </p:nvSpPr>
        <p:spPr>
          <a:xfrm>
            <a:off x="4186981" y="2029970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23" name="グループ化 322">
            <a:extLst>
              <a:ext uri="{FF2B5EF4-FFF2-40B4-BE49-F238E27FC236}">
                <a16:creationId xmlns:a16="http://schemas.microsoft.com/office/drawing/2014/main" id="{9B832250-B59F-44F0-B31E-3B1CEDC8876D}"/>
              </a:ext>
            </a:extLst>
          </p:cNvPr>
          <p:cNvGrpSpPr/>
          <p:nvPr/>
        </p:nvGrpSpPr>
        <p:grpSpPr>
          <a:xfrm>
            <a:off x="4317676" y="2238352"/>
            <a:ext cx="356914" cy="407549"/>
            <a:chOff x="1803795" y="906901"/>
            <a:chExt cx="356914" cy="407549"/>
          </a:xfrm>
        </p:grpSpPr>
        <p:sp>
          <p:nvSpPr>
            <p:cNvPr id="324" name="楕円 323">
              <a:extLst>
                <a:ext uri="{FF2B5EF4-FFF2-40B4-BE49-F238E27FC236}">
                  <a16:creationId xmlns:a16="http://schemas.microsoft.com/office/drawing/2014/main" id="{BD47C9A3-E886-42B6-82E0-A666842C2410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25" name="グループ化 324">
              <a:extLst>
                <a:ext uri="{FF2B5EF4-FFF2-40B4-BE49-F238E27FC236}">
                  <a16:creationId xmlns:a16="http://schemas.microsoft.com/office/drawing/2014/main" id="{9DDFF8A9-2B5D-434F-9B95-C94532FE8B91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326" name="角丸四角形 426">
                <a:extLst>
                  <a:ext uri="{FF2B5EF4-FFF2-40B4-BE49-F238E27FC236}">
                    <a16:creationId xmlns:a16="http://schemas.microsoft.com/office/drawing/2014/main" id="{D59063E5-67B5-43BC-B424-8E36C3E68545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27" name="角丸四角形 427">
                <a:extLst>
                  <a:ext uri="{FF2B5EF4-FFF2-40B4-BE49-F238E27FC236}">
                    <a16:creationId xmlns:a16="http://schemas.microsoft.com/office/drawing/2014/main" id="{B14FC978-E354-4FCB-9621-E397C246B8C4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28" name="角丸四角形 428">
                <a:extLst>
                  <a:ext uri="{FF2B5EF4-FFF2-40B4-BE49-F238E27FC236}">
                    <a16:creationId xmlns:a16="http://schemas.microsoft.com/office/drawing/2014/main" id="{98525A19-106F-457D-94E1-AFEE7F2999E4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29" name="角丸四角形 429">
                <a:extLst>
                  <a:ext uri="{FF2B5EF4-FFF2-40B4-BE49-F238E27FC236}">
                    <a16:creationId xmlns:a16="http://schemas.microsoft.com/office/drawing/2014/main" id="{196B88A6-FB98-47BA-BB02-F087918BD648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30" name="角丸四角形 430">
                <a:extLst>
                  <a:ext uri="{FF2B5EF4-FFF2-40B4-BE49-F238E27FC236}">
                    <a16:creationId xmlns:a16="http://schemas.microsoft.com/office/drawing/2014/main" id="{C8585E91-845C-42E4-B372-FC63CEDF5819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31" name="角丸四角形 431">
                <a:extLst>
                  <a:ext uri="{FF2B5EF4-FFF2-40B4-BE49-F238E27FC236}">
                    <a16:creationId xmlns:a16="http://schemas.microsoft.com/office/drawing/2014/main" id="{1B2E7DCA-D104-4427-AB97-848B81959CB1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32" name="角丸四角形 432">
                <a:extLst>
                  <a:ext uri="{FF2B5EF4-FFF2-40B4-BE49-F238E27FC236}">
                    <a16:creationId xmlns:a16="http://schemas.microsoft.com/office/drawing/2014/main" id="{43E53362-53C0-4582-8E0A-0E8695E12B31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33" name="角丸四角形 433">
                <a:extLst>
                  <a:ext uri="{FF2B5EF4-FFF2-40B4-BE49-F238E27FC236}">
                    <a16:creationId xmlns:a16="http://schemas.microsoft.com/office/drawing/2014/main" id="{5FBEBC9C-0CB7-4148-8B3F-602113F08838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34" name="角丸四角形 434">
                <a:extLst>
                  <a:ext uri="{FF2B5EF4-FFF2-40B4-BE49-F238E27FC236}">
                    <a16:creationId xmlns:a16="http://schemas.microsoft.com/office/drawing/2014/main" id="{5D1567AA-B08C-43E1-AC9A-2C8396BB8196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338" name="グループ化 337">
            <a:extLst>
              <a:ext uri="{FF2B5EF4-FFF2-40B4-BE49-F238E27FC236}">
                <a16:creationId xmlns:a16="http://schemas.microsoft.com/office/drawing/2014/main" id="{97F8AA25-CABA-4D41-8B14-4131C367B765}"/>
              </a:ext>
            </a:extLst>
          </p:cNvPr>
          <p:cNvGrpSpPr/>
          <p:nvPr/>
        </p:nvGrpSpPr>
        <p:grpSpPr>
          <a:xfrm>
            <a:off x="4367096" y="2442376"/>
            <a:ext cx="76082" cy="138336"/>
            <a:chOff x="3627704" y="1153750"/>
            <a:chExt cx="102068" cy="117678"/>
          </a:xfrm>
        </p:grpSpPr>
        <p:sp>
          <p:nvSpPr>
            <p:cNvPr id="339" name="四角形: 角を丸くする 338">
              <a:extLst>
                <a:ext uri="{FF2B5EF4-FFF2-40B4-BE49-F238E27FC236}">
                  <a16:creationId xmlns:a16="http://schemas.microsoft.com/office/drawing/2014/main" id="{F031FC4D-C201-42F0-A765-D659184DAB9D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0" name="四角形: 角を丸くする 339">
              <a:extLst>
                <a:ext uri="{FF2B5EF4-FFF2-40B4-BE49-F238E27FC236}">
                  <a16:creationId xmlns:a16="http://schemas.microsoft.com/office/drawing/2014/main" id="{2FCF86BD-5565-4DD7-AC91-E73AB325FCCE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41" name="グループ化 340">
            <a:extLst>
              <a:ext uri="{FF2B5EF4-FFF2-40B4-BE49-F238E27FC236}">
                <a16:creationId xmlns:a16="http://schemas.microsoft.com/office/drawing/2014/main" id="{F7B8F866-351B-4C15-AE0C-DFC184E7EAF1}"/>
              </a:ext>
            </a:extLst>
          </p:cNvPr>
          <p:cNvGrpSpPr/>
          <p:nvPr/>
        </p:nvGrpSpPr>
        <p:grpSpPr>
          <a:xfrm>
            <a:off x="7531949" y="1322649"/>
            <a:ext cx="598877" cy="655948"/>
            <a:chOff x="5416463" y="626935"/>
            <a:chExt cx="614309" cy="672851"/>
          </a:xfrm>
        </p:grpSpPr>
        <p:sp>
          <p:nvSpPr>
            <p:cNvPr id="342" name="楕円 341">
              <a:extLst>
                <a:ext uri="{FF2B5EF4-FFF2-40B4-BE49-F238E27FC236}">
                  <a16:creationId xmlns:a16="http://schemas.microsoft.com/office/drawing/2014/main" id="{FE3F04FD-F243-4158-BFEE-D59C7A7BCFBB}"/>
                </a:ext>
              </a:extLst>
            </p:cNvPr>
            <p:cNvSpPr/>
            <p:nvPr/>
          </p:nvSpPr>
          <p:spPr>
            <a:xfrm>
              <a:off x="5416463" y="626935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chemeClr val="bg1">
                    <a:lumMod val="50000"/>
                  </a:schemeClr>
                </a:gs>
                <a:gs pos="35000">
                  <a:srgbClr val="FFFFFF"/>
                </a:gs>
                <a:gs pos="99000">
                  <a:schemeClr val="tx1">
                    <a:lumMod val="50000"/>
                    <a:lumOff val="50000"/>
                  </a:scheme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43" name="グループ化 342">
              <a:extLst>
                <a:ext uri="{FF2B5EF4-FFF2-40B4-BE49-F238E27FC236}">
                  <a16:creationId xmlns:a16="http://schemas.microsoft.com/office/drawing/2014/main" id="{F9CE37B1-83CE-4663-A1C6-B09ADBF2A36C}"/>
                </a:ext>
              </a:extLst>
            </p:cNvPr>
            <p:cNvGrpSpPr/>
            <p:nvPr/>
          </p:nvGrpSpPr>
          <p:grpSpPr>
            <a:xfrm>
              <a:off x="5547158" y="835317"/>
              <a:ext cx="356914" cy="407549"/>
              <a:chOff x="1803795" y="906901"/>
              <a:chExt cx="356914" cy="407549"/>
            </a:xfrm>
          </p:grpSpPr>
          <p:sp>
            <p:nvSpPr>
              <p:cNvPr id="344" name="楕円 343">
                <a:extLst>
                  <a:ext uri="{FF2B5EF4-FFF2-40B4-BE49-F238E27FC236}">
                    <a16:creationId xmlns:a16="http://schemas.microsoft.com/office/drawing/2014/main" id="{1C68B88B-E314-4767-8658-32DB02D199B7}"/>
                  </a:ext>
                </a:extLst>
              </p:cNvPr>
              <p:cNvSpPr/>
              <p:nvPr/>
            </p:nvSpPr>
            <p:spPr>
              <a:xfrm>
                <a:off x="1803795" y="906901"/>
                <a:ext cx="356914" cy="407549"/>
              </a:xfrm>
              <a:prstGeom prst="ellipse">
                <a:avLst/>
              </a:prstGeom>
              <a:gradFill flip="none" rotWithShape="0">
                <a:gsLst>
                  <a:gs pos="74000">
                    <a:schemeClr val="tx1">
                      <a:lumMod val="65000"/>
                      <a:lumOff val="35000"/>
                    </a:schemeClr>
                  </a:gs>
                  <a:gs pos="0">
                    <a:schemeClr val="tx1">
                      <a:lumMod val="50000"/>
                      <a:lumOff val="50000"/>
                    </a:schemeClr>
                  </a:gs>
                  <a:gs pos="60000">
                    <a:schemeClr val="bg2">
                      <a:lumMod val="9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345" name="グループ化 344">
                <a:extLst>
                  <a:ext uri="{FF2B5EF4-FFF2-40B4-BE49-F238E27FC236}">
                    <a16:creationId xmlns:a16="http://schemas.microsoft.com/office/drawing/2014/main" id="{ECB97599-1050-453C-B0DD-B0DBAC2BA47B}"/>
                  </a:ext>
                </a:extLst>
              </p:cNvPr>
              <p:cNvGrpSpPr/>
              <p:nvPr/>
            </p:nvGrpSpPr>
            <p:grpSpPr>
              <a:xfrm rot="5400000">
                <a:off x="1844654" y="1003030"/>
                <a:ext cx="264296" cy="239600"/>
                <a:chOff x="1055340" y="761314"/>
                <a:chExt cx="1159545" cy="388369"/>
              </a:xfrm>
            </p:grpSpPr>
            <p:sp>
              <p:nvSpPr>
                <p:cNvPr id="346" name="角丸四角形 426">
                  <a:extLst>
                    <a:ext uri="{FF2B5EF4-FFF2-40B4-BE49-F238E27FC236}">
                      <a16:creationId xmlns:a16="http://schemas.microsoft.com/office/drawing/2014/main" id="{CAAAC6F5-82F9-4FB9-B28C-F3831C94945C}"/>
                    </a:ext>
                  </a:extLst>
                </p:cNvPr>
                <p:cNvSpPr/>
                <p:nvPr/>
              </p:nvSpPr>
              <p:spPr>
                <a:xfrm>
                  <a:off x="1055340" y="761314"/>
                  <a:ext cx="302010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47" name="角丸四角形 427">
                  <a:extLst>
                    <a:ext uri="{FF2B5EF4-FFF2-40B4-BE49-F238E27FC236}">
                      <a16:creationId xmlns:a16="http://schemas.microsoft.com/office/drawing/2014/main" id="{E6BF2B7B-7256-4838-84C4-587D4C496E47}"/>
                    </a:ext>
                  </a:extLst>
                </p:cNvPr>
                <p:cNvSpPr/>
                <p:nvPr/>
              </p:nvSpPr>
              <p:spPr>
                <a:xfrm>
                  <a:off x="1350500" y="761314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48" name="角丸四角形 428">
                  <a:extLst>
                    <a:ext uri="{FF2B5EF4-FFF2-40B4-BE49-F238E27FC236}">
                      <a16:creationId xmlns:a16="http://schemas.microsoft.com/office/drawing/2014/main" id="{7EDCCC50-2865-4346-9F5E-B50F4A2CED89}"/>
                    </a:ext>
                  </a:extLst>
                </p:cNvPr>
                <p:cNvSpPr/>
                <p:nvPr/>
              </p:nvSpPr>
              <p:spPr>
                <a:xfrm>
                  <a:off x="1496808" y="761314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49" name="角丸四角形 429">
                  <a:extLst>
                    <a:ext uri="{FF2B5EF4-FFF2-40B4-BE49-F238E27FC236}">
                      <a16:creationId xmlns:a16="http://schemas.microsoft.com/office/drawing/2014/main" id="{B0EB4791-1D75-4D4C-882E-8893139491B9}"/>
                    </a:ext>
                  </a:extLst>
                </p:cNvPr>
                <p:cNvSpPr/>
                <p:nvPr/>
              </p:nvSpPr>
              <p:spPr>
                <a:xfrm>
                  <a:off x="1074320" y="899976"/>
                  <a:ext cx="269764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50" name="角丸四角形 430">
                  <a:extLst>
                    <a:ext uri="{FF2B5EF4-FFF2-40B4-BE49-F238E27FC236}">
                      <a16:creationId xmlns:a16="http://schemas.microsoft.com/office/drawing/2014/main" id="{2224B5A1-D1FF-4D3D-B131-B3579496E162}"/>
                    </a:ext>
                  </a:extLst>
                </p:cNvPr>
                <p:cNvSpPr/>
                <p:nvPr/>
              </p:nvSpPr>
              <p:spPr>
                <a:xfrm>
                  <a:off x="1350500" y="899976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51" name="角丸四角形 431">
                  <a:extLst>
                    <a:ext uri="{FF2B5EF4-FFF2-40B4-BE49-F238E27FC236}">
                      <a16:creationId xmlns:a16="http://schemas.microsoft.com/office/drawing/2014/main" id="{30B72026-2555-4952-8678-C6573CE4EA7E}"/>
                    </a:ext>
                  </a:extLst>
                </p:cNvPr>
                <p:cNvSpPr/>
                <p:nvPr/>
              </p:nvSpPr>
              <p:spPr>
                <a:xfrm>
                  <a:off x="1496810" y="899977"/>
                  <a:ext cx="718071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52" name="角丸四角形 432">
                  <a:extLst>
                    <a:ext uri="{FF2B5EF4-FFF2-40B4-BE49-F238E27FC236}">
                      <a16:creationId xmlns:a16="http://schemas.microsoft.com/office/drawing/2014/main" id="{A9CCC9C9-A656-433F-8283-6B39C33729C7}"/>
                    </a:ext>
                  </a:extLst>
                </p:cNvPr>
                <p:cNvSpPr/>
                <p:nvPr/>
              </p:nvSpPr>
              <p:spPr>
                <a:xfrm>
                  <a:off x="1074309" y="1038637"/>
                  <a:ext cx="269765" cy="111044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53" name="角丸四角形 433">
                  <a:extLst>
                    <a:ext uri="{FF2B5EF4-FFF2-40B4-BE49-F238E27FC236}">
                      <a16:creationId xmlns:a16="http://schemas.microsoft.com/office/drawing/2014/main" id="{E83F11A5-29BC-404D-8E36-8AE502290911}"/>
                    </a:ext>
                  </a:extLst>
                </p:cNvPr>
                <p:cNvSpPr/>
                <p:nvPr/>
              </p:nvSpPr>
              <p:spPr>
                <a:xfrm>
                  <a:off x="1350495" y="1038639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354" name="角丸四角形 434">
                  <a:extLst>
                    <a:ext uri="{FF2B5EF4-FFF2-40B4-BE49-F238E27FC236}">
                      <a16:creationId xmlns:a16="http://schemas.microsoft.com/office/drawing/2014/main" id="{057C712B-1643-4C61-9C2C-3C8A173167F6}"/>
                    </a:ext>
                  </a:extLst>
                </p:cNvPr>
                <p:cNvSpPr/>
                <p:nvPr/>
              </p:nvSpPr>
              <p:spPr>
                <a:xfrm>
                  <a:off x="1496809" y="1038639"/>
                  <a:ext cx="718076" cy="111044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</p:grpSp>
        </p:grpSp>
      </p:grpSp>
      <p:sp>
        <p:nvSpPr>
          <p:cNvPr id="369" name="楕円 368">
            <a:extLst>
              <a:ext uri="{FF2B5EF4-FFF2-40B4-BE49-F238E27FC236}">
                <a16:creationId xmlns:a16="http://schemas.microsoft.com/office/drawing/2014/main" id="{DFBC59E6-CECF-4274-B106-B7DF820B15E1}"/>
              </a:ext>
            </a:extLst>
          </p:cNvPr>
          <p:cNvSpPr/>
          <p:nvPr/>
        </p:nvSpPr>
        <p:spPr>
          <a:xfrm>
            <a:off x="6841161" y="1413410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70" name="グループ化 369">
            <a:extLst>
              <a:ext uri="{FF2B5EF4-FFF2-40B4-BE49-F238E27FC236}">
                <a16:creationId xmlns:a16="http://schemas.microsoft.com/office/drawing/2014/main" id="{2C148396-5F9D-4F22-8D7C-D2321EAE6817}"/>
              </a:ext>
            </a:extLst>
          </p:cNvPr>
          <p:cNvGrpSpPr/>
          <p:nvPr/>
        </p:nvGrpSpPr>
        <p:grpSpPr>
          <a:xfrm>
            <a:off x="6971856" y="1621792"/>
            <a:ext cx="356914" cy="407549"/>
            <a:chOff x="1803795" y="906901"/>
            <a:chExt cx="356914" cy="407549"/>
          </a:xfrm>
        </p:grpSpPr>
        <p:sp>
          <p:nvSpPr>
            <p:cNvPr id="371" name="楕円 370">
              <a:extLst>
                <a:ext uri="{FF2B5EF4-FFF2-40B4-BE49-F238E27FC236}">
                  <a16:creationId xmlns:a16="http://schemas.microsoft.com/office/drawing/2014/main" id="{06713E3C-48AA-4E89-B5F6-087D55FA3784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72" name="グループ化 371">
              <a:extLst>
                <a:ext uri="{FF2B5EF4-FFF2-40B4-BE49-F238E27FC236}">
                  <a16:creationId xmlns:a16="http://schemas.microsoft.com/office/drawing/2014/main" id="{BDB25C14-2A7E-4C23-951B-EF8684B2C47D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373" name="角丸四角形 426">
                <a:extLst>
                  <a:ext uri="{FF2B5EF4-FFF2-40B4-BE49-F238E27FC236}">
                    <a16:creationId xmlns:a16="http://schemas.microsoft.com/office/drawing/2014/main" id="{C1CD51FA-0FB9-43DB-AD87-47A9D13E2E0C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4" name="角丸四角形 427">
                <a:extLst>
                  <a:ext uri="{FF2B5EF4-FFF2-40B4-BE49-F238E27FC236}">
                    <a16:creationId xmlns:a16="http://schemas.microsoft.com/office/drawing/2014/main" id="{F3BD2401-6000-4065-8108-44F9842B21A3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5" name="角丸四角形 428">
                <a:extLst>
                  <a:ext uri="{FF2B5EF4-FFF2-40B4-BE49-F238E27FC236}">
                    <a16:creationId xmlns:a16="http://schemas.microsoft.com/office/drawing/2014/main" id="{BF0AFFE1-0ACD-4A34-B2A9-08A150955B0D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6" name="角丸四角形 429">
                <a:extLst>
                  <a:ext uri="{FF2B5EF4-FFF2-40B4-BE49-F238E27FC236}">
                    <a16:creationId xmlns:a16="http://schemas.microsoft.com/office/drawing/2014/main" id="{6651A45F-4313-49AC-BACF-B7BF1A90A315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7" name="角丸四角形 430">
                <a:extLst>
                  <a:ext uri="{FF2B5EF4-FFF2-40B4-BE49-F238E27FC236}">
                    <a16:creationId xmlns:a16="http://schemas.microsoft.com/office/drawing/2014/main" id="{EE006E3A-A7ED-4968-8C73-68C9EF34A034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8" name="角丸四角形 431">
                <a:extLst>
                  <a:ext uri="{FF2B5EF4-FFF2-40B4-BE49-F238E27FC236}">
                    <a16:creationId xmlns:a16="http://schemas.microsoft.com/office/drawing/2014/main" id="{FC972DF2-E549-49D8-A264-AA0B8B99472C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79" name="角丸四角形 432">
                <a:extLst>
                  <a:ext uri="{FF2B5EF4-FFF2-40B4-BE49-F238E27FC236}">
                    <a16:creationId xmlns:a16="http://schemas.microsoft.com/office/drawing/2014/main" id="{374BC94C-AFE1-42A5-AC66-48D007FBA598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80" name="角丸四角形 433">
                <a:extLst>
                  <a:ext uri="{FF2B5EF4-FFF2-40B4-BE49-F238E27FC236}">
                    <a16:creationId xmlns:a16="http://schemas.microsoft.com/office/drawing/2014/main" id="{7E1A839F-2F07-49CD-9ED7-7847B502A8CE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81" name="角丸四角形 434">
                <a:extLst>
                  <a:ext uri="{FF2B5EF4-FFF2-40B4-BE49-F238E27FC236}">
                    <a16:creationId xmlns:a16="http://schemas.microsoft.com/office/drawing/2014/main" id="{1ACB0CFC-80CB-497A-AFC0-C1E003018E7C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382" name="グループ化 381">
            <a:extLst>
              <a:ext uri="{FF2B5EF4-FFF2-40B4-BE49-F238E27FC236}">
                <a16:creationId xmlns:a16="http://schemas.microsoft.com/office/drawing/2014/main" id="{9829E4B9-DA02-49BE-8043-E769A7DE677D}"/>
              </a:ext>
            </a:extLst>
          </p:cNvPr>
          <p:cNvGrpSpPr/>
          <p:nvPr/>
        </p:nvGrpSpPr>
        <p:grpSpPr>
          <a:xfrm>
            <a:off x="7191418" y="1825995"/>
            <a:ext cx="76082" cy="138336"/>
            <a:chOff x="3627704" y="1153750"/>
            <a:chExt cx="102068" cy="117678"/>
          </a:xfrm>
        </p:grpSpPr>
        <p:sp>
          <p:nvSpPr>
            <p:cNvPr id="383" name="四角形: 角を丸くする 382">
              <a:extLst>
                <a:ext uri="{FF2B5EF4-FFF2-40B4-BE49-F238E27FC236}">
                  <a16:creationId xmlns:a16="http://schemas.microsoft.com/office/drawing/2014/main" id="{6C119D42-3C9B-49FD-A85C-36E1FFEC6847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4" name="四角形: 角を丸くする 383">
              <a:extLst>
                <a:ext uri="{FF2B5EF4-FFF2-40B4-BE49-F238E27FC236}">
                  <a16:creationId xmlns:a16="http://schemas.microsoft.com/office/drawing/2014/main" id="{B7E3D1D2-F8BD-44E7-883D-0D48AA535D6C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85" name="楕円 384">
            <a:extLst>
              <a:ext uri="{FF2B5EF4-FFF2-40B4-BE49-F238E27FC236}">
                <a16:creationId xmlns:a16="http://schemas.microsoft.com/office/drawing/2014/main" id="{C21BE8D2-1C0C-4CB5-9D85-BF3298BEB43D}"/>
              </a:ext>
            </a:extLst>
          </p:cNvPr>
          <p:cNvSpPr/>
          <p:nvPr/>
        </p:nvSpPr>
        <p:spPr>
          <a:xfrm>
            <a:off x="7394288" y="2060693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86" name="グループ化 385">
            <a:extLst>
              <a:ext uri="{FF2B5EF4-FFF2-40B4-BE49-F238E27FC236}">
                <a16:creationId xmlns:a16="http://schemas.microsoft.com/office/drawing/2014/main" id="{6BB32373-A2D0-490C-8AB4-BF4673968544}"/>
              </a:ext>
            </a:extLst>
          </p:cNvPr>
          <p:cNvGrpSpPr/>
          <p:nvPr/>
        </p:nvGrpSpPr>
        <p:grpSpPr>
          <a:xfrm>
            <a:off x="7524983" y="2269075"/>
            <a:ext cx="356914" cy="407549"/>
            <a:chOff x="1803795" y="906901"/>
            <a:chExt cx="356914" cy="407549"/>
          </a:xfrm>
        </p:grpSpPr>
        <p:sp>
          <p:nvSpPr>
            <p:cNvPr id="387" name="楕円 386">
              <a:extLst>
                <a:ext uri="{FF2B5EF4-FFF2-40B4-BE49-F238E27FC236}">
                  <a16:creationId xmlns:a16="http://schemas.microsoft.com/office/drawing/2014/main" id="{2AA5F9D9-1904-49CD-8DDF-B50EC8C2A4B4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88" name="グループ化 387">
              <a:extLst>
                <a:ext uri="{FF2B5EF4-FFF2-40B4-BE49-F238E27FC236}">
                  <a16:creationId xmlns:a16="http://schemas.microsoft.com/office/drawing/2014/main" id="{F0A3FA6A-8A84-4D25-829C-1EE30E2E9F10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389" name="角丸四角形 426">
                <a:extLst>
                  <a:ext uri="{FF2B5EF4-FFF2-40B4-BE49-F238E27FC236}">
                    <a16:creationId xmlns:a16="http://schemas.microsoft.com/office/drawing/2014/main" id="{83C93615-BB05-4E79-871A-BC1470D8A5E4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0" name="角丸四角形 427">
                <a:extLst>
                  <a:ext uri="{FF2B5EF4-FFF2-40B4-BE49-F238E27FC236}">
                    <a16:creationId xmlns:a16="http://schemas.microsoft.com/office/drawing/2014/main" id="{C0789DB3-063C-47EE-AAEF-BC7852319B1A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1" name="角丸四角形 428">
                <a:extLst>
                  <a:ext uri="{FF2B5EF4-FFF2-40B4-BE49-F238E27FC236}">
                    <a16:creationId xmlns:a16="http://schemas.microsoft.com/office/drawing/2014/main" id="{F28D1051-8AF8-4349-B826-5B16F76BA6A2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2" name="角丸四角形 429">
                <a:extLst>
                  <a:ext uri="{FF2B5EF4-FFF2-40B4-BE49-F238E27FC236}">
                    <a16:creationId xmlns:a16="http://schemas.microsoft.com/office/drawing/2014/main" id="{AE6890D0-2CB0-4ADD-948A-9D467B5200B8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3" name="角丸四角形 430">
                <a:extLst>
                  <a:ext uri="{FF2B5EF4-FFF2-40B4-BE49-F238E27FC236}">
                    <a16:creationId xmlns:a16="http://schemas.microsoft.com/office/drawing/2014/main" id="{68987300-2BBE-4387-AF9A-CF9095B6E555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4" name="角丸四角形 431">
                <a:extLst>
                  <a:ext uri="{FF2B5EF4-FFF2-40B4-BE49-F238E27FC236}">
                    <a16:creationId xmlns:a16="http://schemas.microsoft.com/office/drawing/2014/main" id="{6E03AF82-7F54-4661-83F5-A847660EF8C6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5" name="角丸四角形 432">
                <a:extLst>
                  <a:ext uri="{FF2B5EF4-FFF2-40B4-BE49-F238E27FC236}">
                    <a16:creationId xmlns:a16="http://schemas.microsoft.com/office/drawing/2014/main" id="{D7117360-5F02-49AC-BEAF-2A66D4B5E29A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6" name="角丸四角形 433">
                <a:extLst>
                  <a:ext uri="{FF2B5EF4-FFF2-40B4-BE49-F238E27FC236}">
                    <a16:creationId xmlns:a16="http://schemas.microsoft.com/office/drawing/2014/main" id="{D77DC02F-E354-49C1-988D-4E7459320B06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397" name="角丸四角形 434">
                <a:extLst>
                  <a:ext uri="{FF2B5EF4-FFF2-40B4-BE49-F238E27FC236}">
                    <a16:creationId xmlns:a16="http://schemas.microsoft.com/office/drawing/2014/main" id="{69C299A2-6C93-4DD8-989E-20CDDBF3922A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398" name="グループ化 397">
            <a:extLst>
              <a:ext uri="{FF2B5EF4-FFF2-40B4-BE49-F238E27FC236}">
                <a16:creationId xmlns:a16="http://schemas.microsoft.com/office/drawing/2014/main" id="{3EA4FCD5-7DD1-4E58-84C0-57CCBDF5E962}"/>
              </a:ext>
            </a:extLst>
          </p:cNvPr>
          <p:cNvGrpSpPr/>
          <p:nvPr/>
        </p:nvGrpSpPr>
        <p:grpSpPr>
          <a:xfrm>
            <a:off x="7668328" y="2474034"/>
            <a:ext cx="76082" cy="138336"/>
            <a:chOff x="3627704" y="1153750"/>
            <a:chExt cx="102068" cy="117678"/>
          </a:xfrm>
        </p:grpSpPr>
        <p:sp>
          <p:nvSpPr>
            <p:cNvPr id="399" name="四角形: 角を丸くする 398">
              <a:extLst>
                <a:ext uri="{FF2B5EF4-FFF2-40B4-BE49-F238E27FC236}">
                  <a16:creationId xmlns:a16="http://schemas.microsoft.com/office/drawing/2014/main" id="{1E5DD329-8BFA-4AA3-8682-8D291C51A986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0" name="四角形: 角を丸くする 399">
              <a:extLst>
                <a:ext uri="{FF2B5EF4-FFF2-40B4-BE49-F238E27FC236}">
                  <a16:creationId xmlns:a16="http://schemas.microsoft.com/office/drawing/2014/main" id="{60FFE238-91BA-4FC1-B8AD-7F1494E7C91A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01" name="楕円 400">
            <a:extLst>
              <a:ext uri="{FF2B5EF4-FFF2-40B4-BE49-F238E27FC236}">
                <a16:creationId xmlns:a16="http://schemas.microsoft.com/office/drawing/2014/main" id="{F1A7E574-C4F7-4BE3-9FD5-9E913BA5022D}"/>
              </a:ext>
            </a:extLst>
          </p:cNvPr>
          <p:cNvSpPr/>
          <p:nvPr/>
        </p:nvSpPr>
        <p:spPr>
          <a:xfrm>
            <a:off x="6571506" y="2066407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02" name="グループ化 401">
            <a:extLst>
              <a:ext uri="{FF2B5EF4-FFF2-40B4-BE49-F238E27FC236}">
                <a16:creationId xmlns:a16="http://schemas.microsoft.com/office/drawing/2014/main" id="{7895478F-29EF-4EC9-A6DE-D2F928D2A92E}"/>
              </a:ext>
            </a:extLst>
          </p:cNvPr>
          <p:cNvGrpSpPr/>
          <p:nvPr/>
        </p:nvGrpSpPr>
        <p:grpSpPr>
          <a:xfrm>
            <a:off x="6702201" y="2274789"/>
            <a:ext cx="356914" cy="407549"/>
            <a:chOff x="1803795" y="906901"/>
            <a:chExt cx="356914" cy="407549"/>
          </a:xfrm>
        </p:grpSpPr>
        <p:sp>
          <p:nvSpPr>
            <p:cNvPr id="403" name="楕円 402">
              <a:extLst>
                <a:ext uri="{FF2B5EF4-FFF2-40B4-BE49-F238E27FC236}">
                  <a16:creationId xmlns:a16="http://schemas.microsoft.com/office/drawing/2014/main" id="{BF2AC429-B2E8-45AC-90B1-8C3F5CFD642D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4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6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04" name="グループ化 403">
              <a:extLst>
                <a:ext uri="{FF2B5EF4-FFF2-40B4-BE49-F238E27FC236}">
                  <a16:creationId xmlns:a16="http://schemas.microsoft.com/office/drawing/2014/main" id="{4C1B1604-0698-4F10-811A-18E0856DC422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405" name="角丸四角形 426">
                <a:extLst>
                  <a:ext uri="{FF2B5EF4-FFF2-40B4-BE49-F238E27FC236}">
                    <a16:creationId xmlns:a16="http://schemas.microsoft.com/office/drawing/2014/main" id="{CAC65031-701A-4C0E-A3C1-DF159BCE8CE1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06" name="角丸四角形 427">
                <a:extLst>
                  <a:ext uri="{FF2B5EF4-FFF2-40B4-BE49-F238E27FC236}">
                    <a16:creationId xmlns:a16="http://schemas.microsoft.com/office/drawing/2014/main" id="{FAEE3D5E-078A-4577-8CCC-7463C94EAFD2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07" name="角丸四角形 428">
                <a:extLst>
                  <a:ext uri="{FF2B5EF4-FFF2-40B4-BE49-F238E27FC236}">
                    <a16:creationId xmlns:a16="http://schemas.microsoft.com/office/drawing/2014/main" id="{C5E972CD-7C14-4CD7-B4C4-1EFA49399D7D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08" name="角丸四角形 429">
                <a:extLst>
                  <a:ext uri="{FF2B5EF4-FFF2-40B4-BE49-F238E27FC236}">
                    <a16:creationId xmlns:a16="http://schemas.microsoft.com/office/drawing/2014/main" id="{7CE117DC-4E7F-4B88-9AF2-FDA067ADBAF7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09" name="角丸四角形 430">
                <a:extLst>
                  <a:ext uri="{FF2B5EF4-FFF2-40B4-BE49-F238E27FC236}">
                    <a16:creationId xmlns:a16="http://schemas.microsoft.com/office/drawing/2014/main" id="{D9A08783-D600-4B02-B144-FA2926B9470F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10" name="角丸四角形 431">
                <a:extLst>
                  <a:ext uri="{FF2B5EF4-FFF2-40B4-BE49-F238E27FC236}">
                    <a16:creationId xmlns:a16="http://schemas.microsoft.com/office/drawing/2014/main" id="{9CF93FD9-DA19-4F17-82A2-DD85945987A7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11" name="角丸四角形 432">
                <a:extLst>
                  <a:ext uri="{FF2B5EF4-FFF2-40B4-BE49-F238E27FC236}">
                    <a16:creationId xmlns:a16="http://schemas.microsoft.com/office/drawing/2014/main" id="{E4D82DF1-CA3F-403A-857A-00368EA31285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12" name="角丸四角形 433">
                <a:extLst>
                  <a:ext uri="{FF2B5EF4-FFF2-40B4-BE49-F238E27FC236}">
                    <a16:creationId xmlns:a16="http://schemas.microsoft.com/office/drawing/2014/main" id="{47DC4787-2061-45D2-ABFF-0AE194A33A19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413" name="角丸四角形 434">
                <a:extLst>
                  <a:ext uri="{FF2B5EF4-FFF2-40B4-BE49-F238E27FC236}">
                    <a16:creationId xmlns:a16="http://schemas.microsoft.com/office/drawing/2014/main" id="{01548BFF-9A4A-4523-8B6E-CF92D88204BE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414" name="グループ化 413">
            <a:extLst>
              <a:ext uri="{FF2B5EF4-FFF2-40B4-BE49-F238E27FC236}">
                <a16:creationId xmlns:a16="http://schemas.microsoft.com/office/drawing/2014/main" id="{5A973FF5-5C6D-469C-8C04-6618FD7AF11F}"/>
              </a:ext>
            </a:extLst>
          </p:cNvPr>
          <p:cNvGrpSpPr/>
          <p:nvPr/>
        </p:nvGrpSpPr>
        <p:grpSpPr>
          <a:xfrm>
            <a:off x="6751621" y="2478813"/>
            <a:ext cx="76082" cy="138336"/>
            <a:chOff x="3627704" y="1153750"/>
            <a:chExt cx="102068" cy="117678"/>
          </a:xfrm>
        </p:grpSpPr>
        <p:sp>
          <p:nvSpPr>
            <p:cNvPr id="415" name="四角形: 角を丸くする 414">
              <a:extLst>
                <a:ext uri="{FF2B5EF4-FFF2-40B4-BE49-F238E27FC236}">
                  <a16:creationId xmlns:a16="http://schemas.microsoft.com/office/drawing/2014/main" id="{FDE64CA5-3227-4EE1-A478-E2C54111DDA2}"/>
                </a:ext>
              </a:extLst>
            </p:cNvPr>
            <p:cNvSpPr/>
            <p:nvPr/>
          </p:nvSpPr>
          <p:spPr>
            <a:xfrm>
              <a:off x="3627705" y="1153750"/>
              <a:ext cx="102067" cy="117678"/>
            </a:xfrm>
            <a:prstGeom prst="roundRect">
              <a:avLst/>
            </a:prstGeom>
            <a:solidFill>
              <a:srgbClr val="008000">
                <a:alpha val="92941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6" name="四角形: 角を丸くする 415">
              <a:extLst>
                <a:ext uri="{FF2B5EF4-FFF2-40B4-BE49-F238E27FC236}">
                  <a16:creationId xmlns:a16="http://schemas.microsoft.com/office/drawing/2014/main" id="{384B7BBF-CF4C-48CB-A919-0218002D1602}"/>
                </a:ext>
              </a:extLst>
            </p:cNvPr>
            <p:cNvSpPr/>
            <p:nvPr/>
          </p:nvSpPr>
          <p:spPr>
            <a:xfrm flipH="1" flipV="1">
              <a:off x="3627704" y="1170816"/>
              <a:ext cx="102065" cy="75138"/>
            </a:xfrm>
            <a:prstGeom prst="round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8613051C-E80C-4946-8C89-11DB29941E2E}"/>
              </a:ext>
            </a:extLst>
          </p:cNvPr>
          <p:cNvGrpSpPr/>
          <p:nvPr/>
        </p:nvGrpSpPr>
        <p:grpSpPr>
          <a:xfrm>
            <a:off x="9302806" y="1494238"/>
            <a:ext cx="614309" cy="672851"/>
            <a:chOff x="9302806" y="1494238"/>
            <a:chExt cx="614309" cy="672851"/>
          </a:xfrm>
        </p:grpSpPr>
        <p:sp>
          <p:nvSpPr>
            <p:cNvPr id="493" name="楕円 492">
              <a:extLst>
                <a:ext uri="{FF2B5EF4-FFF2-40B4-BE49-F238E27FC236}">
                  <a16:creationId xmlns:a16="http://schemas.microsoft.com/office/drawing/2014/main" id="{46C97CB6-A7D7-435A-BC8A-A64A085255C1}"/>
                </a:ext>
              </a:extLst>
            </p:cNvPr>
            <p:cNvSpPr/>
            <p:nvPr/>
          </p:nvSpPr>
          <p:spPr>
            <a:xfrm>
              <a:off x="9302806" y="1494238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rgbClr val="FFCCFF"/>
                </a:gs>
                <a:gs pos="35000">
                  <a:srgbClr val="FFFFFF"/>
                </a:gs>
                <a:gs pos="100000">
                  <a:srgbClr val="FFCC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5" name="楕円 494">
              <a:extLst>
                <a:ext uri="{FF2B5EF4-FFF2-40B4-BE49-F238E27FC236}">
                  <a16:creationId xmlns:a16="http://schemas.microsoft.com/office/drawing/2014/main" id="{A19DC4F3-167E-4C04-AFD0-C70AD21C18D2}"/>
                </a:ext>
              </a:extLst>
            </p:cNvPr>
            <p:cNvSpPr/>
            <p:nvPr/>
          </p:nvSpPr>
          <p:spPr>
            <a:xfrm>
              <a:off x="9433501" y="1702620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3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96" name="グループ化 495">
              <a:extLst>
                <a:ext uri="{FF2B5EF4-FFF2-40B4-BE49-F238E27FC236}">
                  <a16:creationId xmlns:a16="http://schemas.microsoft.com/office/drawing/2014/main" id="{1CDF3CCB-C8AC-457A-B895-20640693A002}"/>
                </a:ext>
              </a:extLst>
            </p:cNvPr>
            <p:cNvGrpSpPr/>
            <p:nvPr/>
          </p:nvGrpSpPr>
          <p:grpSpPr>
            <a:xfrm rot="5400000">
              <a:off x="9433752" y="1843683"/>
              <a:ext cx="259969" cy="154053"/>
              <a:chOff x="1074320" y="899976"/>
              <a:chExt cx="1140560" cy="249706"/>
            </a:xfrm>
          </p:grpSpPr>
          <p:sp>
            <p:nvSpPr>
              <p:cNvPr id="500" name="角丸四角形 429">
                <a:extLst>
                  <a:ext uri="{FF2B5EF4-FFF2-40B4-BE49-F238E27FC236}">
                    <a16:creationId xmlns:a16="http://schemas.microsoft.com/office/drawing/2014/main" id="{E8C9F42E-A916-4EF3-B788-D0984FBF721D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01" name="角丸四角形 430">
                <a:extLst>
                  <a:ext uri="{FF2B5EF4-FFF2-40B4-BE49-F238E27FC236}">
                    <a16:creationId xmlns:a16="http://schemas.microsoft.com/office/drawing/2014/main" id="{CD507B06-C81D-45A8-9002-B8F76603DEFD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02" name="角丸四角形 431">
                <a:extLst>
                  <a:ext uri="{FF2B5EF4-FFF2-40B4-BE49-F238E27FC236}">
                    <a16:creationId xmlns:a16="http://schemas.microsoft.com/office/drawing/2014/main" id="{07698872-78F0-4BBA-B92B-05D8788D6A19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03" name="角丸四角形 432">
                <a:extLst>
                  <a:ext uri="{FF2B5EF4-FFF2-40B4-BE49-F238E27FC236}">
                    <a16:creationId xmlns:a16="http://schemas.microsoft.com/office/drawing/2014/main" id="{4B931BBA-16C0-464A-B2CE-3ADFFE04A005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04" name="角丸四角形 433">
                <a:extLst>
                  <a:ext uri="{FF2B5EF4-FFF2-40B4-BE49-F238E27FC236}">
                    <a16:creationId xmlns:a16="http://schemas.microsoft.com/office/drawing/2014/main" id="{0A3F2EE5-2AF3-4C93-9EC9-2F2E6BE5EA36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05" name="角丸四角形 434">
                <a:extLst>
                  <a:ext uri="{FF2B5EF4-FFF2-40B4-BE49-F238E27FC236}">
                    <a16:creationId xmlns:a16="http://schemas.microsoft.com/office/drawing/2014/main" id="{156D5BB7-2526-4BCC-85D8-5823CB2BA980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509" name="楕円 508">
            <a:extLst>
              <a:ext uri="{FF2B5EF4-FFF2-40B4-BE49-F238E27FC236}">
                <a16:creationId xmlns:a16="http://schemas.microsoft.com/office/drawing/2014/main" id="{855EA830-BE86-43BC-A83B-6EA8B8CDFE9E}"/>
              </a:ext>
            </a:extLst>
          </p:cNvPr>
          <p:cNvSpPr/>
          <p:nvPr/>
        </p:nvSpPr>
        <p:spPr>
          <a:xfrm>
            <a:off x="9855934" y="2184688"/>
            <a:ext cx="589602" cy="629684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10" name="グループ化 509">
            <a:extLst>
              <a:ext uri="{FF2B5EF4-FFF2-40B4-BE49-F238E27FC236}">
                <a16:creationId xmlns:a16="http://schemas.microsoft.com/office/drawing/2014/main" id="{A301F2D9-664C-406A-ADF8-5CE47738919C}"/>
              </a:ext>
            </a:extLst>
          </p:cNvPr>
          <p:cNvGrpSpPr/>
          <p:nvPr/>
        </p:nvGrpSpPr>
        <p:grpSpPr>
          <a:xfrm>
            <a:off x="9977489" y="2346345"/>
            <a:ext cx="331546" cy="402102"/>
            <a:chOff x="1803795" y="906901"/>
            <a:chExt cx="356914" cy="407549"/>
          </a:xfrm>
        </p:grpSpPr>
        <p:sp>
          <p:nvSpPr>
            <p:cNvPr id="511" name="楕円 510">
              <a:extLst>
                <a:ext uri="{FF2B5EF4-FFF2-40B4-BE49-F238E27FC236}">
                  <a16:creationId xmlns:a16="http://schemas.microsoft.com/office/drawing/2014/main" id="{751B0AF0-3C9F-4E4B-B57B-070E44678E23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47760">
                  <a:srgbClr val="FFE2FF"/>
                </a:gs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1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12" name="グループ化 511">
              <a:extLst>
                <a:ext uri="{FF2B5EF4-FFF2-40B4-BE49-F238E27FC236}">
                  <a16:creationId xmlns:a16="http://schemas.microsoft.com/office/drawing/2014/main" id="{CE321272-C1C6-45F6-BCFB-D8CFDD41543D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513" name="角丸四角形 426">
                <a:extLst>
                  <a:ext uri="{FF2B5EF4-FFF2-40B4-BE49-F238E27FC236}">
                    <a16:creationId xmlns:a16="http://schemas.microsoft.com/office/drawing/2014/main" id="{7AB29F5F-F636-4235-A840-9137F76BA9F7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14" name="角丸四角形 427">
                <a:extLst>
                  <a:ext uri="{FF2B5EF4-FFF2-40B4-BE49-F238E27FC236}">
                    <a16:creationId xmlns:a16="http://schemas.microsoft.com/office/drawing/2014/main" id="{47B081F7-99B4-4A7E-9A9F-82CF235CD983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15" name="角丸四角形 428">
                <a:extLst>
                  <a:ext uri="{FF2B5EF4-FFF2-40B4-BE49-F238E27FC236}">
                    <a16:creationId xmlns:a16="http://schemas.microsoft.com/office/drawing/2014/main" id="{8760A0A0-C43E-435C-AE7C-904CB0E1F76C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19" name="角丸四角形 432">
                <a:extLst>
                  <a:ext uri="{FF2B5EF4-FFF2-40B4-BE49-F238E27FC236}">
                    <a16:creationId xmlns:a16="http://schemas.microsoft.com/office/drawing/2014/main" id="{9C99D6D2-F8BF-4445-B8F9-58121BCCD24C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20" name="角丸四角形 433">
                <a:extLst>
                  <a:ext uri="{FF2B5EF4-FFF2-40B4-BE49-F238E27FC236}">
                    <a16:creationId xmlns:a16="http://schemas.microsoft.com/office/drawing/2014/main" id="{A0288B14-A188-4CD7-A8C0-504E883D3B17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21" name="角丸四角形 434">
                <a:extLst>
                  <a:ext uri="{FF2B5EF4-FFF2-40B4-BE49-F238E27FC236}">
                    <a16:creationId xmlns:a16="http://schemas.microsoft.com/office/drawing/2014/main" id="{A61FFA27-06B3-4121-8DB5-2A93CA96A677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525" name="楕円 524">
            <a:extLst>
              <a:ext uri="{FF2B5EF4-FFF2-40B4-BE49-F238E27FC236}">
                <a16:creationId xmlns:a16="http://schemas.microsoft.com/office/drawing/2014/main" id="{8CB0460E-10A7-4765-AAC9-6743B65D2CD8}"/>
              </a:ext>
            </a:extLst>
          </p:cNvPr>
          <p:cNvSpPr/>
          <p:nvPr/>
        </p:nvSpPr>
        <p:spPr>
          <a:xfrm>
            <a:off x="9033151" y="2147235"/>
            <a:ext cx="614309" cy="672851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26" name="グループ化 525">
            <a:extLst>
              <a:ext uri="{FF2B5EF4-FFF2-40B4-BE49-F238E27FC236}">
                <a16:creationId xmlns:a16="http://schemas.microsoft.com/office/drawing/2014/main" id="{5A2EC338-3E75-4926-8CE2-4AAFEA4E3F8D}"/>
              </a:ext>
            </a:extLst>
          </p:cNvPr>
          <p:cNvGrpSpPr/>
          <p:nvPr/>
        </p:nvGrpSpPr>
        <p:grpSpPr>
          <a:xfrm>
            <a:off x="9163846" y="2355617"/>
            <a:ext cx="356914" cy="407549"/>
            <a:chOff x="1803795" y="906901"/>
            <a:chExt cx="356914" cy="407549"/>
          </a:xfrm>
        </p:grpSpPr>
        <p:sp>
          <p:nvSpPr>
            <p:cNvPr id="527" name="楕円 526">
              <a:extLst>
                <a:ext uri="{FF2B5EF4-FFF2-40B4-BE49-F238E27FC236}">
                  <a16:creationId xmlns:a16="http://schemas.microsoft.com/office/drawing/2014/main" id="{B6978449-88E0-45D8-8E90-2D2987381261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28" name="グループ化 527">
              <a:extLst>
                <a:ext uri="{FF2B5EF4-FFF2-40B4-BE49-F238E27FC236}">
                  <a16:creationId xmlns:a16="http://schemas.microsoft.com/office/drawing/2014/main" id="{246CC935-D99E-4DE8-AC41-622167EA02C6}"/>
                </a:ext>
              </a:extLst>
            </p:cNvPr>
            <p:cNvGrpSpPr/>
            <p:nvPr/>
          </p:nvGrpSpPr>
          <p:grpSpPr>
            <a:xfrm rot="5400000">
              <a:off x="1889590" y="1047964"/>
              <a:ext cx="259969" cy="154053"/>
              <a:chOff x="1074320" y="761314"/>
              <a:chExt cx="1140560" cy="249705"/>
            </a:xfrm>
          </p:grpSpPr>
          <p:sp>
            <p:nvSpPr>
              <p:cNvPr id="529" name="角丸四角形 426">
                <a:extLst>
                  <a:ext uri="{FF2B5EF4-FFF2-40B4-BE49-F238E27FC236}">
                    <a16:creationId xmlns:a16="http://schemas.microsoft.com/office/drawing/2014/main" id="{B99BF8F8-1F51-444C-8088-EC87279B2887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30" name="角丸四角形 427">
                <a:extLst>
                  <a:ext uri="{FF2B5EF4-FFF2-40B4-BE49-F238E27FC236}">
                    <a16:creationId xmlns:a16="http://schemas.microsoft.com/office/drawing/2014/main" id="{074AAD36-76F4-4B89-A44E-F856B45FD1EF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31" name="角丸四角形 428">
                <a:extLst>
                  <a:ext uri="{FF2B5EF4-FFF2-40B4-BE49-F238E27FC236}">
                    <a16:creationId xmlns:a16="http://schemas.microsoft.com/office/drawing/2014/main" id="{E4CE9F88-A86A-4ECC-92B9-CB0FD59A2C54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32" name="角丸四角形 429">
                <a:extLst>
                  <a:ext uri="{FF2B5EF4-FFF2-40B4-BE49-F238E27FC236}">
                    <a16:creationId xmlns:a16="http://schemas.microsoft.com/office/drawing/2014/main" id="{8C26D32C-4B90-4BD5-B9CD-19D728F0BF80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33" name="角丸四角形 430">
                <a:extLst>
                  <a:ext uri="{FF2B5EF4-FFF2-40B4-BE49-F238E27FC236}">
                    <a16:creationId xmlns:a16="http://schemas.microsoft.com/office/drawing/2014/main" id="{23333433-66F7-4D25-9D4F-28F1760DCB94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34" name="角丸四角形 431">
                <a:extLst>
                  <a:ext uri="{FF2B5EF4-FFF2-40B4-BE49-F238E27FC236}">
                    <a16:creationId xmlns:a16="http://schemas.microsoft.com/office/drawing/2014/main" id="{213AA98A-8042-4125-BB01-E5B17F0FAD08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541" name="グループ化 540">
            <a:extLst>
              <a:ext uri="{FF2B5EF4-FFF2-40B4-BE49-F238E27FC236}">
                <a16:creationId xmlns:a16="http://schemas.microsoft.com/office/drawing/2014/main" id="{B727F158-AEE7-45A0-9C98-89DADD21FBC8}"/>
              </a:ext>
            </a:extLst>
          </p:cNvPr>
          <p:cNvGrpSpPr/>
          <p:nvPr/>
        </p:nvGrpSpPr>
        <p:grpSpPr>
          <a:xfrm>
            <a:off x="6919117" y="2712100"/>
            <a:ext cx="598877" cy="655948"/>
            <a:chOff x="5416463" y="626935"/>
            <a:chExt cx="614309" cy="672851"/>
          </a:xfrm>
        </p:grpSpPr>
        <p:sp>
          <p:nvSpPr>
            <p:cNvPr id="542" name="楕円 541">
              <a:extLst>
                <a:ext uri="{FF2B5EF4-FFF2-40B4-BE49-F238E27FC236}">
                  <a16:creationId xmlns:a16="http://schemas.microsoft.com/office/drawing/2014/main" id="{C8BC412F-01FC-4B98-B23A-3AC75A418720}"/>
                </a:ext>
              </a:extLst>
            </p:cNvPr>
            <p:cNvSpPr/>
            <p:nvPr/>
          </p:nvSpPr>
          <p:spPr>
            <a:xfrm>
              <a:off x="5416463" y="626935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chemeClr val="bg1">
                    <a:lumMod val="50000"/>
                  </a:schemeClr>
                </a:gs>
                <a:gs pos="35000">
                  <a:srgbClr val="FFFFFF"/>
                </a:gs>
                <a:gs pos="99000">
                  <a:schemeClr val="tx1">
                    <a:lumMod val="50000"/>
                    <a:lumOff val="50000"/>
                  </a:scheme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43" name="グループ化 542">
              <a:extLst>
                <a:ext uri="{FF2B5EF4-FFF2-40B4-BE49-F238E27FC236}">
                  <a16:creationId xmlns:a16="http://schemas.microsoft.com/office/drawing/2014/main" id="{654CB5DB-3F7D-429D-ADFA-45B2B01483C3}"/>
                </a:ext>
              </a:extLst>
            </p:cNvPr>
            <p:cNvGrpSpPr/>
            <p:nvPr/>
          </p:nvGrpSpPr>
          <p:grpSpPr>
            <a:xfrm>
              <a:off x="5547158" y="835317"/>
              <a:ext cx="356914" cy="407549"/>
              <a:chOff x="1803795" y="906901"/>
              <a:chExt cx="356914" cy="407549"/>
            </a:xfrm>
          </p:grpSpPr>
          <p:sp>
            <p:nvSpPr>
              <p:cNvPr id="544" name="楕円 543">
                <a:extLst>
                  <a:ext uri="{FF2B5EF4-FFF2-40B4-BE49-F238E27FC236}">
                    <a16:creationId xmlns:a16="http://schemas.microsoft.com/office/drawing/2014/main" id="{D206C7A9-0C46-45B0-B984-0672811C3D2E}"/>
                  </a:ext>
                </a:extLst>
              </p:cNvPr>
              <p:cNvSpPr/>
              <p:nvPr/>
            </p:nvSpPr>
            <p:spPr>
              <a:xfrm>
                <a:off x="1803795" y="906901"/>
                <a:ext cx="356914" cy="407549"/>
              </a:xfrm>
              <a:prstGeom prst="ellipse">
                <a:avLst/>
              </a:prstGeom>
              <a:gradFill flip="none" rotWithShape="0">
                <a:gsLst>
                  <a:gs pos="74000">
                    <a:schemeClr val="tx1">
                      <a:lumMod val="65000"/>
                      <a:lumOff val="35000"/>
                    </a:schemeClr>
                  </a:gs>
                  <a:gs pos="0">
                    <a:schemeClr val="tx1">
                      <a:lumMod val="50000"/>
                      <a:lumOff val="50000"/>
                    </a:schemeClr>
                  </a:gs>
                  <a:gs pos="60000">
                    <a:schemeClr val="bg2">
                      <a:lumMod val="9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545" name="グループ化 544">
                <a:extLst>
                  <a:ext uri="{FF2B5EF4-FFF2-40B4-BE49-F238E27FC236}">
                    <a16:creationId xmlns:a16="http://schemas.microsoft.com/office/drawing/2014/main" id="{930B490B-4B5E-47B6-983F-80647B06A30D}"/>
                  </a:ext>
                </a:extLst>
              </p:cNvPr>
              <p:cNvGrpSpPr/>
              <p:nvPr/>
            </p:nvGrpSpPr>
            <p:grpSpPr>
              <a:xfrm rot="5400000">
                <a:off x="1844654" y="1003030"/>
                <a:ext cx="264296" cy="239600"/>
                <a:chOff x="1055340" y="761314"/>
                <a:chExt cx="1159545" cy="388369"/>
              </a:xfrm>
            </p:grpSpPr>
            <p:sp>
              <p:nvSpPr>
                <p:cNvPr id="546" name="角丸四角形 426">
                  <a:extLst>
                    <a:ext uri="{FF2B5EF4-FFF2-40B4-BE49-F238E27FC236}">
                      <a16:creationId xmlns:a16="http://schemas.microsoft.com/office/drawing/2014/main" id="{D38C9322-26B1-496E-BFE6-191968A682C7}"/>
                    </a:ext>
                  </a:extLst>
                </p:cNvPr>
                <p:cNvSpPr/>
                <p:nvPr/>
              </p:nvSpPr>
              <p:spPr>
                <a:xfrm>
                  <a:off x="1055340" y="761314"/>
                  <a:ext cx="302010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47" name="角丸四角形 427">
                  <a:extLst>
                    <a:ext uri="{FF2B5EF4-FFF2-40B4-BE49-F238E27FC236}">
                      <a16:creationId xmlns:a16="http://schemas.microsoft.com/office/drawing/2014/main" id="{46DA229C-CCE4-4752-9DF3-8D877CBCA17C}"/>
                    </a:ext>
                  </a:extLst>
                </p:cNvPr>
                <p:cNvSpPr/>
                <p:nvPr/>
              </p:nvSpPr>
              <p:spPr>
                <a:xfrm>
                  <a:off x="1350500" y="761314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48" name="角丸四角形 428">
                  <a:extLst>
                    <a:ext uri="{FF2B5EF4-FFF2-40B4-BE49-F238E27FC236}">
                      <a16:creationId xmlns:a16="http://schemas.microsoft.com/office/drawing/2014/main" id="{5178413E-FFBD-4940-9C53-CBCD81615537}"/>
                    </a:ext>
                  </a:extLst>
                </p:cNvPr>
                <p:cNvSpPr/>
                <p:nvPr/>
              </p:nvSpPr>
              <p:spPr>
                <a:xfrm>
                  <a:off x="1496808" y="761314"/>
                  <a:ext cx="718072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49" name="角丸四角形 429">
                  <a:extLst>
                    <a:ext uri="{FF2B5EF4-FFF2-40B4-BE49-F238E27FC236}">
                      <a16:creationId xmlns:a16="http://schemas.microsoft.com/office/drawing/2014/main" id="{FF11E2C7-AD98-4898-B95B-372E550744BD}"/>
                    </a:ext>
                  </a:extLst>
                </p:cNvPr>
                <p:cNvSpPr/>
                <p:nvPr/>
              </p:nvSpPr>
              <p:spPr>
                <a:xfrm>
                  <a:off x="1074320" y="899976"/>
                  <a:ext cx="269764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50" name="角丸四角形 430">
                  <a:extLst>
                    <a:ext uri="{FF2B5EF4-FFF2-40B4-BE49-F238E27FC236}">
                      <a16:creationId xmlns:a16="http://schemas.microsoft.com/office/drawing/2014/main" id="{540940D6-9A9D-41F0-8EF6-AF58619003B2}"/>
                    </a:ext>
                  </a:extLst>
                </p:cNvPr>
                <p:cNvSpPr/>
                <p:nvPr/>
              </p:nvSpPr>
              <p:spPr>
                <a:xfrm>
                  <a:off x="1350500" y="899976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51" name="角丸四角形 431">
                  <a:extLst>
                    <a:ext uri="{FF2B5EF4-FFF2-40B4-BE49-F238E27FC236}">
                      <a16:creationId xmlns:a16="http://schemas.microsoft.com/office/drawing/2014/main" id="{E1EB6402-4632-4A23-BCBB-0BEADF6B8B48}"/>
                    </a:ext>
                  </a:extLst>
                </p:cNvPr>
                <p:cNvSpPr/>
                <p:nvPr/>
              </p:nvSpPr>
              <p:spPr>
                <a:xfrm>
                  <a:off x="1496810" y="899977"/>
                  <a:ext cx="718071" cy="111043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52" name="角丸四角形 432">
                  <a:extLst>
                    <a:ext uri="{FF2B5EF4-FFF2-40B4-BE49-F238E27FC236}">
                      <a16:creationId xmlns:a16="http://schemas.microsoft.com/office/drawing/2014/main" id="{50B324C2-3CAF-4FCA-99B4-9940FE6CBA0A}"/>
                    </a:ext>
                  </a:extLst>
                </p:cNvPr>
                <p:cNvSpPr/>
                <p:nvPr/>
              </p:nvSpPr>
              <p:spPr>
                <a:xfrm>
                  <a:off x="1074309" y="1038637"/>
                  <a:ext cx="269765" cy="111044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53" name="角丸四角形 433">
                  <a:extLst>
                    <a:ext uri="{FF2B5EF4-FFF2-40B4-BE49-F238E27FC236}">
                      <a16:creationId xmlns:a16="http://schemas.microsoft.com/office/drawing/2014/main" id="{E8BC5514-B5BC-4AAB-B3E5-89FE21DD498D}"/>
                    </a:ext>
                  </a:extLst>
                </p:cNvPr>
                <p:cNvSpPr/>
                <p:nvPr/>
              </p:nvSpPr>
              <p:spPr>
                <a:xfrm>
                  <a:off x="1350495" y="1038639"/>
                  <a:ext cx="146851" cy="111043"/>
                </a:xfrm>
                <a:prstGeom prst="roundRect">
                  <a:avLst>
                    <a:gd name="adj" fmla="val 50000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  <p:sp>
              <p:nvSpPr>
                <p:cNvPr id="554" name="角丸四角形 434">
                  <a:extLst>
                    <a:ext uri="{FF2B5EF4-FFF2-40B4-BE49-F238E27FC236}">
                      <a16:creationId xmlns:a16="http://schemas.microsoft.com/office/drawing/2014/main" id="{E1C63A0E-CE07-4A11-8D7A-99F0EB8FD465}"/>
                    </a:ext>
                  </a:extLst>
                </p:cNvPr>
                <p:cNvSpPr/>
                <p:nvPr/>
              </p:nvSpPr>
              <p:spPr>
                <a:xfrm>
                  <a:off x="1496809" y="1038639"/>
                  <a:ext cx="718076" cy="111044"/>
                </a:xfrm>
                <a:prstGeom prst="roundRect">
                  <a:avLst>
                    <a:gd name="adj" fmla="val 44098"/>
                  </a:avLst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700"/>
                </a:p>
              </p:txBody>
            </p:sp>
          </p:grpSp>
        </p:grpSp>
      </p:grpSp>
      <p:grpSp>
        <p:nvGrpSpPr>
          <p:cNvPr id="555" name="グループ化 554">
            <a:extLst>
              <a:ext uri="{FF2B5EF4-FFF2-40B4-BE49-F238E27FC236}">
                <a16:creationId xmlns:a16="http://schemas.microsoft.com/office/drawing/2014/main" id="{631EB3C8-5BD2-4FDD-B1B4-AEFA899344A9}"/>
              </a:ext>
            </a:extLst>
          </p:cNvPr>
          <p:cNvGrpSpPr/>
          <p:nvPr/>
        </p:nvGrpSpPr>
        <p:grpSpPr>
          <a:xfrm>
            <a:off x="11153198" y="1130263"/>
            <a:ext cx="322949" cy="307313"/>
            <a:chOff x="9302806" y="1494238"/>
            <a:chExt cx="614309" cy="672851"/>
          </a:xfrm>
        </p:grpSpPr>
        <p:sp>
          <p:nvSpPr>
            <p:cNvPr id="556" name="楕円 555">
              <a:extLst>
                <a:ext uri="{FF2B5EF4-FFF2-40B4-BE49-F238E27FC236}">
                  <a16:creationId xmlns:a16="http://schemas.microsoft.com/office/drawing/2014/main" id="{A7CD46B0-2D3E-4147-8B21-FE517FE6AEE0}"/>
                </a:ext>
              </a:extLst>
            </p:cNvPr>
            <p:cNvSpPr/>
            <p:nvPr/>
          </p:nvSpPr>
          <p:spPr>
            <a:xfrm>
              <a:off x="9302806" y="1494238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rgbClr val="FFCCFF"/>
                </a:gs>
                <a:gs pos="35000">
                  <a:srgbClr val="FFFFFF"/>
                </a:gs>
                <a:gs pos="100000">
                  <a:srgbClr val="FFCC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7" name="楕円 556">
              <a:extLst>
                <a:ext uri="{FF2B5EF4-FFF2-40B4-BE49-F238E27FC236}">
                  <a16:creationId xmlns:a16="http://schemas.microsoft.com/office/drawing/2014/main" id="{AF08CA33-A149-4E8A-B063-631C4A45621E}"/>
                </a:ext>
              </a:extLst>
            </p:cNvPr>
            <p:cNvSpPr/>
            <p:nvPr/>
          </p:nvSpPr>
          <p:spPr>
            <a:xfrm>
              <a:off x="9433501" y="1702620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3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58" name="グループ化 557">
              <a:extLst>
                <a:ext uri="{FF2B5EF4-FFF2-40B4-BE49-F238E27FC236}">
                  <a16:creationId xmlns:a16="http://schemas.microsoft.com/office/drawing/2014/main" id="{0A5DFA80-A338-496D-BA29-A10793A0FFC0}"/>
                </a:ext>
              </a:extLst>
            </p:cNvPr>
            <p:cNvGrpSpPr/>
            <p:nvPr/>
          </p:nvGrpSpPr>
          <p:grpSpPr>
            <a:xfrm rot="5400000">
              <a:off x="9433752" y="1843683"/>
              <a:ext cx="259969" cy="154053"/>
              <a:chOff x="1074320" y="899976"/>
              <a:chExt cx="1140560" cy="249706"/>
            </a:xfrm>
          </p:grpSpPr>
          <p:sp>
            <p:nvSpPr>
              <p:cNvPr id="559" name="角丸四角形 429">
                <a:extLst>
                  <a:ext uri="{FF2B5EF4-FFF2-40B4-BE49-F238E27FC236}">
                    <a16:creationId xmlns:a16="http://schemas.microsoft.com/office/drawing/2014/main" id="{4A5AC45C-535F-4AB4-9C1F-4760AEBF77E4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60" name="角丸四角形 430">
                <a:extLst>
                  <a:ext uri="{FF2B5EF4-FFF2-40B4-BE49-F238E27FC236}">
                    <a16:creationId xmlns:a16="http://schemas.microsoft.com/office/drawing/2014/main" id="{FBAC37CE-3F78-4712-8839-ED645A266C9F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61" name="角丸四角形 431">
                <a:extLst>
                  <a:ext uri="{FF2B5EF4-FFF2-40B4-BE49-F238E27FC236}">
                    <a16:creationId xmlns:a16="http://schemas.microsoft.com/office/drawing/2014/main" id="{B46E2DB3-7937-44E2-9354-7FD41A69D294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62" name="角丸四角形 432">
                <a:extLst>
                  <a:ext uri="{FF2B5EF4-FFF2-40B4-BE49-F238E27FC236}">
                    <a16:creationId xmlns:a16="http://schemas.microsoft.com/office/drawing/2014/main" id="{E9315FD1-5F9C-400F-84D2-7AB9D79EA1AD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63" name="角丸四角形 433">
                <a:extLst>
                  <a:ext uri="{FF2B5EF4-FFF2-40B4-BE49-F238E27FC236}">
                    <a16:creationId xmlns:a16="http://schemas.microsoft.com/office/drawing/2014/main" id="{46C27FD6-CDA0-4AB2-BC1D-649FBE605B8A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64" name="角丸四角形 434">
                <a:extLst>
                  <a:ext uri="{FF2B5EF4-FFF2-40B4-BE49-F238E27FC236}">
                    <a16:creationId xmlns:a16="http://schemas.microsoft.com/office/drawing/2014/main" id="{ACCED565-1277-49E5-A95C-F76562471A67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grpSp>
        <p:nvGrpSpPr>
          <p:cNvPr id="565" name="グループ化 564">
            <a:extLst>
              <a:ext uri="{FF2B5EF4-FFF2-40B4-BE49-F238E27FC236}">
                <a16:creationId xmlns:a16="http://schemas.microsoft.com/office/drawing/2014/main" id="{3F787935-F073-4E45-AA50-18339F0BDC7E}"/>
              </a:ext>
            </a:extLst>
          </p:cNvPr>
          <p:cNvGrpSpPr/>
          <p:nvPr/>
        </p:nvGrpSpPr>
        <p:grpSpPr>
          <a:xfrm>
            <a:off x="11525545" y="1125126"/>
            <a:ext cx="322949" cy="307313"/>
            <a:chOff x="9302806" y="1494238"/>
            <a:chExt cx="614309" cy="672851"/>
          </a:xfrm>
        </p:grpSpPr>
        <p:sp>
          <p:nvSpPr>
            <p:cNvPr id="566" name="楕円 565">
              <a:extLst>
                <a:ext uri="{FF2B5EF4-FFF2-40B4-BE49-F238E27FC236}">
                  <a16:creationId xmlns:a16="http://schemas.microsoft.com/office/drawing/2014/main" id="{46AC734A-D233-4F22-A27D-89BA04EC4E76}"/>
                </a:ext>
              </a:extLst>
            </p:cNvPr>
            <p:cNvSpPr/>
            <p:nvPr/>
          </p:nvSpPr>
          <p:spPr>
            <a:xfrm>
              <a:off x="9302806" y="1494238"/>
              <a:ext cx="614309" cy="672851"/>
            </a:xfrm>
            <a:prstGeom prst="ellipse">
              <a:avLst/>
            </a:prstGeom>
            <a:gradFill flip="none" rotWithShape="1">
              <a:gsLst>
                <a:gs pos="0">
                  <a:srgbClr val="FFCCFF"/>
                </a:gs>
                <a:gs pos="35000">
                  <a:srgbClr val="FFFFFF"/>
                </a:gs>
                <a:gs pos="100000">
                  <a:srgbClr val="FFCC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7" name="楕円 566">
              <a:extLst>
                <a:ext uri="{FF2B5EF4-FFF2-40B4-BE49-F238E27FC236}">
                  <a16:creationId xmlns:a16="http://schemas.microsoft.com/office/drawing/2014/main" id="{3A79D3A4-22E9-4F46-B90E-3A0FFDC00038}"/>
                </a:ext>
              </a:extLst>
            </p:cNvPr>
            <p:cNvSpPr/>
            <p:nvPr/>
          </p:nvSpPr>
          <p:spPr>
            <a:xfrm>
              <a:off x="9433501" y="1702620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3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68" name="グループ化 567">
              <a:extLst>
                <a:ext uri="{FF2B5EF4-FFF2-40B4-BE49-F238E27FC236}">
                  <a16:creationId xmlns:a16="http://schemas.microsoft.com/office/drawing/2014/main" id="{FCA6C870-82B5-4716-BF99-312E56B3B024}"/>
                </a:ext>
              </a:extLst>
            </p:cNvPr>
            <p:cNvGrpSpPr/>
            <p:nvPr/>
          </p:nvGrpSpPr>
          <p:grpSpPr>
            <a:xfrm rot="5400000">
              <a:off x="9433752" y="1843683"/>
              <a:ext cx="259969" cy="154053"/>
              <a:chOff x="1074320" y="899976"/>
              <a:chExt cx="1140560" cy="249706"/>
            </a:xfrm>
          </p:grpSpPr>
          <p:sp>
            <p:nvSpPr>
              <p:cNvPr id="569" name="角丸四角形 429">
                <a:extLst>
                  <a:ext uri="{FF2B5EF4-FFF2-40B4-BE49-F238E27FC236}">
                    <a16:creationId xmlns:a16="http://schemas.microsoft.com/office/drawing/2014/main" id="{8C0A956B-BA85-4647-8CBC-DED157B8367A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70" name="角丸四角形 430">
                <a:extLst>
                  <a:ext uri="{FF2B5EF4-FFF2-40B4-BE49-F238E27FC236}">
                    <a16:creationId xmlns:a16="http://schemas.microsoft.com/office/drawing/2014/main" id="{7AFDB253-B6F2-4BBD-A4C4-52B0739E0934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71" name="角丸四角形 431">
                <a:extLst>
                  <a:ext uri="{FF2B5EF4-FFF2-40B4-BE49-F238E27FC236}">
                    <a16:creationId xmlns:a16="http://schemas.microsoft.com/office/drawing/2014/main" id="{06439890-73BE-4CAB-80CF-834EA7BC3892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72" name="角丸四角形 432">
                <a:extLst>
                  <a:ext uri="{FF2B5EF4-FFF2-40B4-BE49-F238E27FC236}">
                    <a16:creationId xmlns:a16="http://schemas.microsoft.com/office/drawing/2014/main" id="{9950AC11-A174-41FD-BC02-D20963EA71DA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73" name="角丸四角形 433">
                <a:extLst>
                  <a:ext uri="{FF2B5EF4-FFF2-40B4-BE49-F238E27FC236}">
                    <a16:creationId xmlns:a16="http://schemas.microsoft.com/office/drawing/2014/main" id="{081576F9-A5F2-4725-960B-6216FE0B7A68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74" name="角丸四角形 434">
                <a:extLst>
                  <a:ext uri="{FF2B5EF4-FFF2-40B4-BE49-F238E27FC236}">
                    <a16:creationId xmlns:a16="http://schemas.microsoft.com/office/drawing/2014/main" id="{DC907030-4874-4955-9903-BDCDBE5F7FA8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575" name="楕円 574">
            <a:extLst>
              <a:ext uri="{FF2B5EF4-FFF2-40B4-BE49-F238E27FC236}">
                <a16:creationId xmlns:a16="http://schemas.microsoft.com/office/drawing/2014/main" id="{30095909-C828-4A8F-8F42-792056CE901A}"/>
              </a:ext>
            </a:extLst>
          </p:cNvPr>
          <p:cNvSpPr/>
          <p:nvPr/>
        </p:nvSpPr>
        <p:spPr>
          <a:xfrm>
            <a:off x="11186490" y="1809491"/>
            <a:ext cx="318014" cy="318322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76" name="グループ化 575">
            <a:extLst>
              <a:ext uri="{FF2B5EF4-FFF2-40B4-BE49-F238E27FC236}">
                <a16:creationId xmlns:a16="http://schemas.microsoft.com/office/drawing/2014/main" id="{BD8632E4-8263-4782-979D-8CD17944648D}"/>
              </a:ext>
            </a:extLst>
          </p:cNvPr>
          <p:cNvGrpSpPr/>
          <p:nvPr/>
        </p:nvGrpSpPr>
        <p:grpSpPr>
          <a:xfrm>
            <a:off x="11251878" y="1882846"/>
            <a:ext cx="184767" cy="192809"/>
            <a:chOff x="1803795" y="906901"/>
            <a:chExt cx="356914" cy="407549"/>
          </a:xfrm>
        </p:grpSpPr>
        <p:sp>
          <p:nvSpPr>
            <p:cNvPr id="577" name="楕円 576">
              <a:extLst>
                <a:ext uri="{FF2B5EF4-FFF2-40B4-BE49-F238E27FC236}">
                  <a16:creationId xmlns:a16="http://schemas.microsoft.com/office/drawing/2014/main" id="{74D2A9B5-E3F6-4BE6-A776-58EC15295B87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78" name="グループ化 577">
              <a:extLst>
                <a:ext uri="{FF2B5EF4-FFF2-40B4-BE49-F238E27FC236}">
                  <a16:creationId xmlns:a16="http://schemas.microsoft.com/office/drawing/2014/main" id="{FEE8993B-9DA7-4764-B460-FD605A662089}"/>
                </a:ext>
              </a:extLst>
            </p:cNvPr>
            <p:cNvGrpSpPr/>
            <p:nvPr/>
          </p:nvGrpSpPr>
          <p:grpSpPr>
            <a:xfrm rot="5400000">
              <a:off x="1889590" y="1047964"/>
              <a:ext cx="259969" cy="154053"/>
              <a:chOff x="1074320" y="761314"/>
              <a:chExt cx="1140560" cy="249705"/>
            </a:xfrm>
          </p:grpSpPr>
          <p:sp>
            <p:nvSpPr>
              <p:cNvPr id="579" name="角丸四角形 426">
                <a:extLst>
                  <a:ext uri="{FF2B5EF4-FFF2-40B4-BE49-F238E27FC236}">
                    <a16:creationId xmlns:a16="http://schemas.microsoft.com/office/drawing/2014/main" id="{D85B13C4-94A5-4716-AD8B-D1A583665D9A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80" name="角丸四角形 427">
                <a:extLst>
                  <a:ext uri="{FF2B5EF4-FFF2-40B4-BE49-F238E27FC236}">
                    <a16:creationId xmlns:a16="http://schemas.microsoft.com/office/drawing/2014/main" id="{1C6B4668-02D0-4DFE-B0F7-96994454D255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81" name="角丸四角形 428">
                <a:extLst>
                  <a:ext uri="{FF2B5EF4-FFF2-40B4-BE49-F238E27FC236}">
                    <a16:creationId xmlns:a16="http://schemas.microsoft.com/office/drawing/2014/main" id="{1176601A-CDCD-480C-9BB2-F50366D7FEBF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82" name="角丸四角形 429">
                <a:extLst>
                  <a:ext uri="{FF2B5EF4-FFF2-40B4-BE49-F238E27FC236}">
                    <a16:creationId xmlns:a16="http://schemas.microsoft.com/office/drawing/2014/main" id="{C577D6D3-F051-4683-8600-20481A8FCCB5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83" name="角丸四角形 430">
                <a:extLst>
                  <a:ext uri="{FF2B5EF4-FFF2-40B4-BE49-F238E27FC236}">
                    <a16:creationId xmlns:a16="http://schemas.microsoft.com/office/drawing/2014/main" id="{D37F0B10-3149-44A9-975F-BA3BCAF77E1B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84" name="角丸四角形 431">
                <a:extLst>
                  <a:ext uri="{FF2B5EF4-FFF2-40B4-BE49-F238E27FC236}">
                    <a16:creationId xmlns:a16="http://schemas.microsoft.com/office/drawing/2014/main" id="{811F849B-D869-44E5-BF53-28950AC85A63}"/>
                  </a:ext>
                </a:extLst>
              </p:cNvPr>
              <p:cNvSpPr/>
              <p:nvPr/>
            </p:nvSpPr>
            <p:spPr>
              <a:xfrm>
                <a:off x="1496808" y="899976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585" name="楕円 584">
            <a:extLst>
              <a:ext uri="{FF2B5EF4-FFF2-40B4-BE49-F238E27FC236}">
                <a16:creationId xmlns:a16="http://schemas.microsoft.com/office/drawing/2014/main" id="{AC148A71-93AD-446B-A1E2-6149B05E5C0D}"/>
              </a:ext>
            </a:extLst>
          </p:cNvPr>
          <p:cNvSpPr/>
          <p:nvPr/>
        </p:nvSpPr>
        <p:spPr>
          <a:xfrm>
            <a:off x="11537974" y="1805184"/>
            <a:ext cx="318014" cy="318322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86" name="グループ化 585">
            <a:extLst>
              <a:ext uri="{FF2B5EF4-FFF2-40B4-BE49-F238E27FC236}">
                <a16:creationId xmlns:a16="http://schemas.microsoft.com/office/drawing/2014/main" id="{6651547C-59B4-49CA-8670-023180A68D57}"/>
              </a:ext>
            </a:extLst>
          </p:cNvPr>
          <p:cNvGrpSpPr/>
          <p:nvPr/>
        </p:nvGrpSpPr>
        <p:grpSpPr>
          <a:xfrm>
            <a:off x="11603362" y="1888065"/>
            <a:ext cx="184767" cy="192809"/>
            <a:chOff x="1803795" y="906901"/>
            <a:chExt cx="356914" cy="407549"/>
          </a:xfrm>
        </p:grpSpPr>
        <p:sp>
          <p:nvSpPr>
            <p:cNvPr id="587" name="楕円 586">
              <a:extLst>
                <a:ext uri="{FF2B5EF4-FFF2-40B4-BE49-F238E27FC236}">
                  <a16:creationId xmlns:a16="http://schemas.microsoft.com/office/drawing/2014/main" id="{C5EBFB67-7E95-49B0-AD01-5892FC0BABED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5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88" name="グループ化 587">
              <a:extLst>
                <a:ext uri="{FF2B5EF4-FFF2-40B4-BE49-F238E27FC236}">
                  <a16:creationId xmlns:a16="http://schemas.microsoft.com/office/drawing/2014/main" id="{430EC024-7D79-4F49-9BF9-FCBDFABBD559}"/>
                </a:ext>
              </a:extLst>
            </p:cNvPr>
            <p:cNvGrpSpPr/>
            <p:nvPr/>
          </p:nvGrpSpPr>
          <p:grpSpPr>
            <a:xfrm rot="5400000">
              <a:off x="1889589" y="1047964"/>
              <a:ext cx="259971" cy="154055"/>
              <a:chOff x="1074320" y="761314"/>
              <a:chExt cx="1140569" cy="249708"/>
            </a:xfrm>
          </p:grpSpPr>
          <p:sp>
            <p:nvSpPr>
              <p:cNvPr id="589" name="角丸四角形 426">
                <a:extLst>
                  <a:ext uri="{FF2B5EF4-FFF2-40B4-BE49-F238E27FC236}">
                    <a16:creationId xmlns:a16="http://schemas.microsoft.com/office/drawing/2014/main" id="{271A9AE5-7C7C-4258-9485-6E3F95DE2843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90" name="角丸四角形 427">
                <a:extLst>
                  <a:ext uri="{FF2B5EF4-FFF2-40B4-BE49-F238E27FC236}">
                    <a16:creationId xmlns:a16="http://schemas.microsoft.com/office/drawing/2014/main" id="{E31C3ED3-9664-4093-AED4-220341A7842C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91" name="角丸四角形 428">
                <a:extLst>
                  <a:ext uri="{FF2B5EF4-FFF2-40B4-BE49-F238E27FC236}">
                    <a16:creationId xmlns:a16="http://schemas.microsoft.com/office/drawing/2014/main" id="{277D8D7F-7E7C-4248-9342-6CB68E1435BA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92" name="角丸四角形 429">
                <a:extLst>
                  <a:ext uri="{FF2B5EF4-FFF2-40B4-BE49-F238E27FC236}">
                    <a16:creationId xmlns:a16="http://schemas.microsoft.com/office/drawing/2014/main" id="{D2338168-E9BA-48D4-9D54-89368BA45EB5}"/>
                  </a:ext>
                </a:extLst>
              </p:cNvPr>
              <p:cNvSpPr/>
              <p:nvPr/>
            </p:nvSpPr>
            <p:spPr>
              <a:xfrm>
                <a:off x="1074320" y="899976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93" name="角丸四角形 430">
                <a:extLst>
                  <a:ext uri="{FF2B5EF4-FFF2-40B4-BE49-F238E27FC236}">
                    <a16:creationId xmlns:a16="http://schemas.microsoft.com/office/drawing/2014/main" id="{FBE030DB-83D3-4B22-89D8-C61EB65A869D}"/>
                  </a:ext>
                </a:extLst>
              </p:cNvPr>
              <p:cNvSpPr/>
              <p:nvPr/>
            </p:nvSpPr>
            <p:spPr>
              <a:xfrm>
                <a:off x="1350500" y="899976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594" name="角丸四角形 431">
                <a:extLst>
                  <a:ext uri="{FF2B5EF4-FFF2-40B4-BE49-F238E27FC236}">
                    <a16:creationId xmlns:a16="http://schemas.microsoft.com/office/drawing/2014/main" id="{1786626A-7D1D-4DAF-8542-B852325363F7}"/>
                  </a:ext>
                </a:extLst>
              </p:cNvPr>
              <p:cNvSpPr/>
              <p:nvPr/>
            </p:nvSpPr>
            <p:spPr>
              <a:xfrm>
                <a:off x="1496816" y="899978"/>
                <a:ext cx="718073" cy="111044"/>
              </a:xfrm>
              <a:prstGeom prst="roundRect">
                <a:avLst>
                  <a:gd name="adj" fmla="val 44098"/>
                </a:avLst>
              </a:prstGeom>
              <a:solidFill>
                <a:srgbClr val="FF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605" name="楕円 604">
            <a:extLst>
              <a:ext uri="{FF2B5EF4-FFF2-40B4-BE49-F238E27FC236}">
                <a16:creationId xmlns:a16="http://schemas.microsoft.com/office/drawing/2014/main" id="{A48E56AF-A042-4FF1-8A30-035C491C4158}"/>
              </a:ext>
            </a:extLst>
          </p:cNvPr>
          <p:cNvSpPr/>
          <p:nvPr/>
        </p:nvSpPr>
        <p:spPr>
          <a:xfrm>
            <a:off x="11195128" y="2533993"/>
            <a:ext cx="281017" cy="297036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06" name="グループ化 605">
            <a:extLst>
              <a:ext uri="{FF2B5EF4-FFF2-40B4-BE49-F238E27FC236}">
                <a16:creationId xmlns:a16="http://schemas.microsoft.com/office/drawing/2014/main" id="{DB62F61B-A66F-4356-B3DE-13BD7997A48D}"/>
              </a:ext>
            </a:extLst>
          </p:cNvPr>
          <p:cNvGrpSpPr/>
          <p:nvPr/>
        </p:nvGrpSpPr>
        <p:grpSpPr>
          <a:xfrm>
            <a:off x="11251518" y="2594925"/>
            <a:ext cx="158022" cy="189681"/>
            <a:chOff x="1803795" y="906901"/>
            <a:chExt cx="356914" cy="407549"/>
          </a:xfrm>
        </p:grpSpPr>
        <p:sp>
          <p:nvSpPr>
            <p:cNvPr id="607" name="楕円 606">
              <a:extLst>
                <a:ext uri="{FF2B5EF4-FFF2-40B4-BE49-F238E27FC236}">
                  <a16:creationId xmlns:a16="http://schemas.microsoft.com/office/drawing/2014/main" id="{36EFEF1A-756A-4849-9D25-A4B955CF9C1D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47760">
                  <a:srgbClr val="FFE2FF"/>
                </a:gs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1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08" name="グループ化 607">
              <a:extLst>
                <a:ext uri="{FF2B5EF4-FFF2-40B4-BE49-F238E27FC236}">
                  <a16:creationId xmlns:a16="http://schemas.microsoft.com/office/drawing/2014/main" id="{E5124892-39FC-4BB7-BE5E-F3B8068B71BE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609" name="角丸四角形 426">
                <a:extLst>
                  <a:ext uri="{FF2B5EF4-FFF2-40B4-BE49-F238E27FC236}">
                    <a16:creationId xmlns:a16="http://schemas.microsoft.com/office/drawing/2014/main" id="{42CC8299-FFF7-4BA8-81A7-30F813A65F7C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10" name="角丸四角形 427">
                <a:extLst>
                  <a:ext uri="{FF2B5EF4-FFF2-40B4-BE49-F238E27FC236}">
                    <a16:creationId xmlns:a16="http://schemas.microsoft.com/office/drawing/2014/main" id="{DB542915-2981-43AC-B9FF-4E9EBDF588C1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11" name="角丸四角形 428">
                <a:extLst>
                  <a:ext uri="{FF2B5EF4-FFF2-40B4-BE49-F238E27FC236}">
                    <a16:creationId xmlns:a16="http://schemas.microsoft.com/office/drawing/2014/main" id="{8132DD57-3F24-4231-A25D-91F46ED0BB10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12" name="角丸四角形 432">
                <a:extLst>
                  <a:ext uri="{FF2B5EF4-FFF2-40B4-BE49-F238E27FC236}">
                    <a16:creationId xmlns:a16="http://schemas.microsoft.com/office/drawing/2014/main" id="{E6143BE1-0E79-4395-B558-89F17A667378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13" name="角丸四角形 433">
                <a:extLst>
                  <a:ext uri="{FF2B5EF4-FFF2-40B4-BE49-F238E27FC236}">
                    <a16:creationId xmlns:a16="http://schemas.microsoft.com/office/drawing/2014/main" id="{F88761EC-62DE-44B4-94AC-892A5CAD0A0F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14" name="角丸四角形 434">
                <a:extLst>
                  <a:ext uri="{FF2B5EF4-FFF2-40B4-BE49-F238E27FC236}">
                    <a16:creationId xmlns:a16="http://schemas.microsoft.com/office/drawing/2014/main" id="{E54C8085-F4FA-470C-B31C-BDB348CEB6B4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  <p:sp>
        <p:nvSpPr>
          <p:cNvPr id="615" name="楕円 614">
            <a:extLst>
              <a:ext uri="{FF2B5EF4-FFF2-40B4-BE49-F238E27FC236}">
                <a16:creationId xmlns:a16="http://schemas.microsoft.com/office/drawing/2014/main" id="{ED1618AC-645D-4482-9EAD-3F681CAC4056}"/>
              </a:ext>
            </a:extLst>
          </p:cNvPr>
          <p:cNvSpPr/>
          <p:nvPr/>
        </p:nvSpPr>
        <p:spPr>
          <a:xfrm>
            <a:off x="11504701" y="2562559"/>
            <a:ext cx="281017" cy="297036"/>
          </a:xfrm>
          <a:prstGeom prst="ellipse">
            <a:avLst/>
          </a:prstGeom>
          <a:gradFill flip="none" rotWithShape="1">
            <a:gsLst>
              <a:gs pos="0">
                <a:srgbClr val="FFCCFF"/>
              </a:gs>
              <a:gs pos="35000">
                <a:srgbClr val="FFFFFF"/>
              </a:gs>
              <a:gs pos="100000">
                <a:srgbClr val="FFCCFF"/>
              </a:gs>
            </a:gsLst>
            <a:path path="circle">
              <a:fillToRect l="100000" t="100000"/>
            </a:path>
            <a:tileRect r="-100000" b="-100000"/>
          </a:gra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16" name="グループ化 615">
            <a:extLst>
              <a:ext uri="{FF2B5EF4-FFF2-40B4-BE49-F238E27FC236}">
                <a16:creationId xmlns:a16="http://schemas.microsoft.com/office/drawing/2014/main" id="{3F1E5FFA-A2E7-4E01-8763-3799DF6DBE11}"/>
              </a:ext>
            </a:extLst>
          </p:cNvPr>
          <p:cNvGrpSpPr/>
          <p:nvPr/>
        </p:nvGrpSpPr>
        <p:grpSpPr>
          <a:xfrm>
            <a:off x="11561091" y="2623491"/>
            <a:ext cx="158022" cy="189681"/>
            <a:chOff x="1803795" y="906901"/>
            <a:chExt cx="356914" cy="407549"/>
          </a:xfrm>
        </p:grpSpPr>
        <p:sp>
          <p:nvSpPr>
            <p:cNvPr id="617" name="楕円 616">
              <a:extLst>
                <a:ext uri="{FF2B5EF4-FFF2-40B4-BE49-F238E27FC236}">
                  <a16:creationId xmlns:a16="http://schemas.microsoft.com/office/drawing/2014/main" id="{8C82773B-6393-4221-A5A1-3A474136DB2F}"/>
                </a:ext>
              </a:extLst>
            </p:cNvPr>
            <p:cNvSpPr/>
            <p:nvPr/>
          </p:nvSpPr>
          <p:spPr>
            <a:xfrm>
              <a:off x="1803795" y="906901"/>
              <a:ext cx="356914" cy="407549"/>
            </a:xfrm>
            <a:prstGeom prst="ellipse">
              <a:avLst/>
            </a:prstGeom>
            <a:gradFill flip="none" rotWithShape="1">
              <a:gsLst>
                <a:gs pos="47760">
                  <a:srgbClr val="FFE2FF"/>
                </a:gs>
                <a:gs pos="100000">
                  <a:srgbClr val="CC00CC"/>
                </a:gs>
                <a:gs pos="0">
                  <a:srgbClr val="FFCCFF">
                    <a:lumMod val="0"/>
                    <a:lumOff val="100000"/>
                  </a:srgbClr>
                </a:gs>
                <a:gs pos="10000">
                  <a:srgbClr val="FFCCFF">
                    <a:shade val="100000"/>
                    <a:satMod val="115000"/>
                    <a:lumMod val="67000"/>
                    <a:lumOff val="33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18" name="グループ化 617">
              <a:extLst>
                <a:ext uri="{FF2B5EF4-FFF2-40B4-BE49-F238E27FC236}">
                  <a16:creationId xmlns:a16="http://schemas.microsoft.com/office/drawing/2014/main" id="{322DE87D-98E3-4CE5-ADE7-2E97493EDC84}"/>
                </a:ext>
              </a:extLst>
            </p:cNvPr>
            <p:cNvGrpSpPr/>
            <p:nvPr/>
          </p:nvGrpSpPr>
          <p:grpSpPr>
            <a:xfrm rot="5400000">
              <a:off x="1846818" y="1005191"/>
              <a:ext cx="259969" cy="239599"/>
              <a:chOff x="1074320" y="761314"/>
              <a:chExt cx="1140560" cy="388368"/>
            </a:xfrm>
          </p:grpSpPr>
          <p:sp>
            <p:nvSpPr>
              <p:cNvPr id="619" name="角丸四角形 426">
                <a:extLst>
                  <a:ext uri="{FF2B5EF4-FFF2-40B4-BE49-F238E27FC236}">
                    <a16:creationId xmlns:a16="http://schemas.microsoft.com/office/drawing/2014/main" id="{7D0AA104-2220-4BF6-87FD-98704C34C756}"/>
                  </a:ext>
                </a:extLst>
              </p:cNvPr>
              <p:cNvSpPr/>
              <p:nvPr/>
            </p:nvSpPr>
            <p:spPr>
              <a:xfrm>
                <a:off x="1074320" y="761314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20" name="角丸四角形 427">
                <a:extLst>
                  <a:ext uri="{FF2B5EF4-FFF2-40B4-BE49-F238E27FC236}">
                    <a16:creationId xmlns:a16="http://schemas.microsoft.com/office/drawing/2014/main" id="{2AE55DB3-9FA7-4CE5-BEBB-57A6D73056C2}"/>
                  </a:ext>
                </a:extLst>
              </p:cNvPr>
              <p:cNvSpPr/>
              <p:nvPr/>
            </p:nvSpPr>
            <p:spPr>
              <a:xfrm>
                <a:off x="1350500" y="761314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21" name="角丸四角形 428">
                <a:extLst>
                  <a:ext uri="{FF2B5EF4-FFF2-40B4-BE49-F238E27FC236}">
                    <a16:creationId xmlns:a16="http://schemas.microsoft.com/office/drawing/2014/main" id="{B28229B1-B617-4BCF-A163-6E162FC1AC96}"/>
                  </a:ext>
                </a:extLst>
              </p:cNvPr>
              <p:cNvSpPr/>
              <p:nvPr/>
            </p:nvSpPr>
            <p:spPr>
              <a:xfrm>
                <a:off x="1496808" y="761314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6699FF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22" name="角丸四角形 432">
                <a:extLst>
                  <a:ext uri="{FF2B5EF4-FFF2-40B4-BE49-F238E27FC236}">
                    <a16:creationId xmlns:a16="http://schemas.microsoft.com/office/drawing/2014/main" id="{A0EDA1C5-120E-42B4-8788-16213C47ABCE}"/>
                  </a:ext>
                </a:extLst>
              </p:cNvPr>
              <p:cNvSpPr/>
              <p:nvPr/>
            </p:nvSpPr>
            <p:spPr>
              <a:xfrm>
                <a:off x="1074320" y="1038639"/>
                <a:ext cx="269763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23" name="角丸四角形 433">
                <a:extLst>
                  <a:ext uri="{FF2B5EF4-FFF2-40B4-BE49-F238E27FC236}">
                    <a16:creationId xmlns:a16="http://schemas.microsoft.com/office/drawing/2014/main" id="{40660A9B-C76E-421F-ADFE-EE838402B6C4}"/>
                  </a:ext>
                </a:extLst>
              </p:cNvPr>
              <p:cNvSpPr/>
              <p:nvPr/>
            </p:nvSpPr>
            <p:spPr>
              <a:xfrm>
                <a:off x="1350500" y="1038639"/>
                <a:ext cx="146851" cy="111043"/>
              </a:xfrm>
              <a:prstGeom prst="roundRect">
                <a:avLst>
                  <a:gd name="adj" fmla="val 50000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  <p:sp>
            <p:nvSpPr>
              <p:cNvPr id="624" name="角丸四角形 434">
                <a:extLst>
                  <a:ext uri="{FF2B5EF4-FFF2-40B4-BE49-F238E27FC236}">
                    <a16:creationId xmlns:a16="http://schemas.microsoft.com/office/drawing/2014/main" id="{B7731629-7EDB-4F05-9709-F2811950682F}"/>
                  </a:ext>
                </a:extLst>
              </p:cNvPr>
              <p:cNvSpPr/>
              <p:nvPr/>
            </p:nvSpPr>
            <p:spPr>
              <a:xfrm>
                <a:off x="1496808" y="1038639"/>
                <a:ext cx="718072" cy="111043"/>
              </a:xfrm>
              <a:prstGeom prst="roundRect">
                <a:avLst>
                  <a:gd name="adj" fmla="val 44098"/>
                </a:avLst>
              </a:prstGeom>
              <a:solidFill>
                <a:srgbClr val="FF9933"/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7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59583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98</TotalTime>
  <Words>96</Words>
  <Application>Microsoft Office PowerPoint</Application>
  <PresentationFormat>ワイド画面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P</dc:creator>
  <cp:lastModifiedBy>幸子</cp:lastModifiedBy>
  <cp:revision>598</cp:revision>
  <cp:lastPrinted>2018-01-17T05:51:52Z</cp:lastPrinted>
  <dcterms:created xsi:type="dcterms:W3CDTF">2017-11-01T02:19:15Z</dcterms:created>
  <dcterms:modified xsi:type="dcterms:W3CDTF">2022-03-26T04:44:30Z</dcterms:modified>
</cp:coreProperties>
</file>